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9FDBA-AF0F-4F19-82A0-1DF63E7070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E5ECE1-D1B7-4186-8094-D049774FEF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5399AE-AFE4-4C4F-A00F-20330A4F0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922BFC-4EAD-4BD5-830E-4D337FA05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D042F-C831-4BA5-B3DD-24DCC3FCE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92426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482D9-9E61-47B2-A02B-820D4A246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BBBAFC-4F4A-4DCE-B156-B48EA22C1B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7FB6B-4694-412A-8174-9A8DCDEBA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45D47-F64E-4F42-8C53-15980E791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5A7391-76CA-4D7B-A412-B2C054335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0118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4852E2-33C3-425D-8A4D-C995A796F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FF1A9-814D-4533-955A-674507336D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DE3B54-68B3-403B-9CC0-74D32B94B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7BD59-F59F-4330-9807-BDEDBCAAE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9A126-54B5-48FC-BEF3-01ECABEA8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0722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6EA14-35A4-4E81-AD13-DBD6ABA09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280749-D930-4A7B-AB69-49CF383BD0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19746B-C34F-44C7-A16F-65A493532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09CD9-E300-4BC0-82CC-653ED0B1E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DDBD56-5ACC-46BE-A89E-D9E2C2FCE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932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CD9DBB-7B08-4A7A-8427-A487F07B0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A8C3E0-BB42-47B4-8A60-3D12469E9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589FD3-3CEF-42B3-AF81-70C9CF5B2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EDFBCD-7CB8-47A1-BE40-DDDBFDF84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B7F5BD-4DB3-4146-8421-9F79FCD80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62855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118DE-D9C6-45CC-86C9-705D76BC0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601DAC-4535-4A6B-AFCC-460E653FE6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FCD6E2-BF4D-4538-8053-BC901A95E6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7B23E8-F3CE-4F67-819F-19BEEE63E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FC5BBB-F329-4C21-95F3-883C7A0F6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00A06A-3081-41BE-8C00-F00DC8B4D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5940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37234C-C434-43A9-A602-60AD56986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B0EEAC-1239-4963-9091-3C38A6FDEF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25E398-42D0-4974-BF10-28B1B2D606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CE1D775-14F4-465A-8F08-674263313F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E39E28-D246-48A6-A296-571A8A9E91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C0C801-B7C4-42B3-A106-C69134F2F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1830FA-9250-4ACE-B144-74BEFCB76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63C8F1-924B-46A3-829A-C309AE4DC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5744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9424D-A415-4994-9075-16259A0BA8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37DE52-2DC1-4E93-B199-5AF530BA8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64E0A3-1C1B-41CA-8FB0-C7EC90A73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EF40AD-0102-4464-A9C0-6E8C18272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8436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CB6E40-A193-4775-9652-FC9FD10C6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D50B189-2C52-41B9-9778-DE790F4C1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0D8BBC-8C8D-416A-82CB-F649B985A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2464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56ADCA-24A0-4C34-8B54-786C8EDF3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B0AE1D-E2A0-4406-868F-4E42553095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2DACF6-EBF7-4F50-A206-AA3B88D7FD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129393-D433-426C-8163-1E81A6778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D25881-A9C3-4715-A2D1-5AF9BDBA4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05D59D-D79A-42A5-8A33-A1A9CB7D7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7880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DA323-EC3E-46E4-BF23-84421B295D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49C269-D1C8-474E-8CC6-21E283E678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996963-466B-4A51-A509-ED7F6B1FE4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21785A-0F43-4FA4-A0B9-EF467C8B8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BDFB06-4F3D-410E-BED5-090A6AFA9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E7AC1F-0AF9-4026-82C9-BAC1AB77D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47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81D2F4-F809-4426-B113-00CDD8A508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2E539F-358B-49A5-9398-1A60A53DDE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AE5EB-59C4-4183-A96C-8CAFD6F108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F41F9-3DF4-4728-89DD-9F8C8874AFCA}" type="datetimeFigureOut">
              <a:rPr lang="en-CA" smtClean="0"/>
              <a:t>2021-10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3335BC-716E-4432-894E-F95444B4FC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A684F4-922E-4AA4-B7EF-6756BC7BE6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728B1-1EA1-4A1E-AB67-B894EC8D64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69290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reeform 6">
            <a:extLst>
              <a:ext uri="{FF2B5EF4-FFF2-40B4-BE49-F238E27FC236}">
                <a16:creationId xmlns:a16="http://schemas.microsoft.com/office/drawing/2014/main" id="{53D99407-5ACF-4FDD-AF7F-217F1735F1A7}"/>
              </a:ext>
            </a:extLst>
          </p:cNvPr>
          <p:cNvSpPr>
            <a:spLocks/>
          </p:cNvSpPr>
          <p:nvPr/>
        </p:nvSpPr>
        <p:spPr bwMode="auto">
          <a:xfrm>
            <a:off x="1727804" y="2336801"/>
            <a:ext cx="3501043" cy="752475"/>
          </a:xfrm>
          <a:custGeom>
            <a:avLst/>
            <a:gdLst>
              <a:gd name="T0" fmla="*/ 0 w 251"/>
              <a:gd name="T1" fmla="*/ 36 h 64"/>
              <a:gd name="T2" fmla="*/ 28 w 251"/>
              <a:gd name="T3" fmla="*/ 0 h 64"/>
              <a:gd name="T4" fmla="*/ 56 w 251"/>
              <a:gd name="T5" fmla="*/ 23 h 64"/>
              <a:gd name="T6" fmla="*/ 84 w 251"/>
              <a:gd name="T7" fmla="*/ 23 h 64"/>
              <a:gd name="T8" fmla="*/ 112 w 251"/>
              <a:gd name="T9" fmla="*/ 62 h 64"/>
              <a:gd name="T10" fmla="*/ 140 w 251"/>
              <a:gd name="T11" fmla="*/ 46 h 64"/>
              <a:gd name="T12" fmla="*/ 168 w 251"/>
              <a:gd name="T13" fmla="*/ 64 h 64"/>
              <a:gd name="T14" fmla="*/ 196 w 251"/>
              <a:gd name="T15" fmla="*/ 17 h 64"/>
              <a:gd name="T16" fmla="*/ 224 w 251"/>
              <a:gd name="T17" fmla="*/ 19 h 64"/>
              <a:gd name="T18" fmla="*/ 251 w 251"/>
              <a:gd name="T19" fmla="*/ 42 h 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1" h="64">
                <a:moveTo>
                  <a:pt x="0" y="36"/>
                </a:moveTo>
                <a:lnTo>
                  <a:pt x="28" y="0"/>
                </a:lnTo>
                <a:lnTo>
                  <a:pt x="56" y="23"/>
                </a:lnTo>
                <a:lnTo>
                  <a:pt x="84" y="23"/>
                </a:lnTo>
                <a:lnTo>
                  <a:pt x="112" y="62"/>
                </a:lnTo>
                <a:lnTo>
                  <a:pt x="140" y="46"/>
                </a:lnTo>
                <a:lnTo>
                  <a:pt x="168" y="64"/>
                </a:lnTo>
                <a:lnTo>
                  <a:pt x="196" y="17"/>
                </a:lnTo>
                <a:lnTo>
                  <a:pt x="224" y="19"/>
                </a:lnTo>
                <a:lnTo>
                  <a:pt x="251" y="42"/>
                </a:lnTo>
              </a:path>
            </a:pathLst>
          </a:custGeom>
          <a:noFill/>
          <a:ln w="396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" name="Line 7">
            <a:extLst>
              <a:ext uri="{FF2B5EF4-FFF2-40B4-BE49-F238E27FC236}">
                <a16:creationId xmlns:a16="http://schemas.microsoft.com/office/drawing/2014/main" id="{6A8A54A5-F0C2-4EA8-B60A-656E8AC4818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37334" y="1092201"/>
            <a:ext cx="0" cy="443865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" name="Line 8">
            <a:extLst>
              <a:ext uri="{FF2B5EF4-FFF2-40B4-BE49-F238E27FC236}">
                <a16:creationId xmlns:a16="http://schemas.microsoft.com/office/drawing/2014/main" id="{CC94B2E7-8FAF-4ED1-B58B-CE191813CD3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2120" y="5530851"/>
            <a:ext cx="125214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" name="Line 9">
            <a:extLst>
              <a:ext uri="{FF2B5EF4-FFF2-40B4-BE49-F238E27FC236}">
                <a16:creationId xmlns:a16="http://schemas.microsoft.com/office/drawing/2014/main" id="{B4C72CD4-26D9-4FA3-A415-1876CB8FD60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2120" y="4649788"/>
            <a:ext cx="125214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2" name="Line 10">
            <a:extLst>
              <a:ext uri="{FF2B5EF4-FFF2-40B4-BE49-F238E27FC236}">
                <a16:creationId xmlns:a16="http://schemas.microsoft.com/office/drawing/2014/main" id="{FC2C3F9E-2B74-4E17-BF0F-D9F1BA4274A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2120" y="3757613"/>
            <a:ext cx="125214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3" name="Line 11">
            <a:extLst>
              <a:ext uri="{FF2B5EF4-FFF2-40B4-BE49-F238E27FC236}">
                <a16:creationId xmlns:a16="http://schemas.microsoft.com/office/drawing/2014/main" id="{060A9AF4-D07C-4139-8AF1-F7BF6D3B0FE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2120" y="2876551"/>
            <a:ext cx="125214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4" name="Line 12">
            <a:extLst>
              <a:ext uri="{FF2B5EF4-FFF2-40B4-BE49-F238E27FC236}">
                <a16:creationId xmlns:a16="http://schemas.microsoft.com/office/drawing/2014/main" id="{B41A7A27-B008-464A-A809-15CBB4221B0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2120" y="1984376"/>
            <a:ext cx="125214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5" name="Line 13">
            <a:extLst>
              <a:ext uri="{FF2B5EF4-FFF2-40B4-BE49-F238E27FC236}">
                <a16:creationId xmlns:a16="http://schemas.microsoft.com/office/drawing/2014/main" id="{0866219B-45AC-40B7-B53F-9164585A360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2120" y="1092201"/>
            <a:ext cx="125214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6" name="Rectangle 14">
            <a:extLst>
              <a:ext uri="{FF2B5EF4-FFF2-40B4-BE49-F238E27FC236}">
                <a16:creationId xmlns:a16="http://schemas.microsoft.com/office/drawing/2014/main" id="{9A56571F-2D31-4E1E-8084-D256C5622C2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76749" y="5395781"/>
            <a:ext cx="212725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5">
            <a:extLst>
              <a:ext uri="{FF2B5EF4-FFF2-40B4-BE49-F238E27FC236}">
                <a16:creationId xmlns:a16="http://schemas.microsoft.com/office/drawing/2014/main" id="{A7783260-AA93-4EE1-B87D-5F001E4BC8A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14836" y="4514719"/>
            <a:ext cx="336550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6">
            <a:extLst>
              <a:ext uri="{FF2B5EF4-FFF2-40B4-BE49-F238E27FC236}">
                <a16:creationId xmlns:a16="http://schemas.microsoft.com/office/drawing/2014/main" id="{1461E6FE-5AE5-4FAB-AB4D-F2BCA16F89C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14836" y="3622544"/>
            <a:ext cx="336550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7">
            <a:extLst>
              <a:ext uri="{FF2B5EF4-FFF2-40B4-BE49-F238E27FC236}">
                <a16:creationId xmlns:a16="http://schemas.microsoft.com/office/drawing/2014/main" id="{F1C362D2-E741-43A8-AE70-1C1F7FCAA41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14836" y="2741481"/>
            <a:ext cx="336550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18">
            <a:extLst>
              <a:ext uri="{FF2B5EF4-FFF2-40B4-BE49-F238E27FC236}">
                <a16:creationId xmlns:a16="http://schemas.microsoft.com/office/drawing/2014/main" id="{40A88C7B-8CA7-4012-8905-C71A8B97DC6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14836" y="1849306"/>
            <a:ext cx="336550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19">
            <a:extLst>
              <a:ext uri="{FF2B5EF4-FFF2-40B4-BE49-F238E27FC236}">
                <a16:creationId xmlns:a16="http://schemas.microsoft.com/office/drawing/2014/main" id="{510F775B-88E7-4247-9013-F7F89D07976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54511" y="955544"/>
            <a:ext cx="457200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0">
            <a:extLst>
              <a:ext uri="{FF2B5EF4-FFF2-40B4-BE49-F238E27FC236}">
                <a16:creationId xmlns:a16="http://schemas.microsoft.com/office/drawing/2014/main" id="{58BDB9B0-448D-4442-8B9B-88ACDC4EC7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7334" y="915988"/>
            <a:ext cx="10516310" cy="480377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3" name="Rectangle 21">
            <a:extLst>
              <a:ext uri="{FF2B5EF4-FFF2-40B4-BE49-F238E27FC236}">
                <a16:creationId xmlns:a16="http://schemas.microsoft.com/office/drawing/2014/main" id="{C1BB840D-0E1B-4BF4-A3CB-09A3232E28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2444" y="341313"/>
            <a:ext cx="3067738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cility Birth over Tim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22">
            <a:extLst>
              <a:ext uri="{FF2B5EF4-FFF2-40B4-BE49-F238E27FC236}">
                <a16:creationId xmlns:a16="http://schemas.microsoft.com/office/drawing/2014/main" id="{C33D241B-D793-41F0-A014-6D5E3267C2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0526" y="6423026"/>
            <a:ext cx="151575" cy="258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23">
            <a:extLst>
              <a:ext uri="{FF2B5EF4-FFF2-40B4-BE49-F238E27FC236}">
                <a16:creationId xmlns:a16="http://schemas.microsoft.com/office/drawing/2014/main" id="{A7CC74B2-99B8-46F6-B7E9-2DA08D11D0F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45912" y="3176456"/>
            <a:ext cx="1597025" cy="268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cility Birth(%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Freeform 24">
            <a:extLst>
              <a:ext uri="{FF2B5EF4-FFF2-40B4-BE49-F238E27FC236}">
                <a16:creationId xmlns:a16="http://schemas.microsoft.com/office/drawing/2014/main" id="{2C88F5B9-A095-4C9C-9341-36DD2881579A}"/>
              </a:ext>
            </a:extLst>
          </p:cNvPr>
          <p:cNvSpPr>
            <a:spLocks noEditPoints="1"/>
          </p:cNvSpPr>
          <p:nvPr/>
        </p:nvSpPr>
        <p:spPr bwMode="auto">
          <a:xfrm>
            <a:off x="7614499" y="1762126"/>
            <a:ext cx="3848676" cy="481013"/>
          </a:xfrm>
          <a:custGeom>
            <a:avLst/>
            <a:gdLst>
              <a:gd name="T0" fmla="*/ 0 w 276"/>
              <a:gd name="T1" fmla="*/ 34 h 41"/>
              <a:gd name="T2" fmla="*/ 9 w 276"/>
              <a:gd name="T3" fmla="*/ 29 h 41"/>
              <a:gd name="T4" fmla="*/ 12 w 276"/>
              <a:gd name="T5" fmla="*/ 28 h 41"/>
              <a:gd name="T6" fmla="*/ 21 w 276"/>
              <a:gd name="T7" fmla="*/ 24 h 41"/>
              <a:gd name="T8" fmla="*/ 24 w 276"/>
              <a:gd name="T9" fmla="*/ 22 h 41"/>
              <a:gd name="T10" fmla="*/ 33 w 276"/>
              <a:gd name="T11" fmla="*/ 21 h 41"/>
              <a:gd name="T12" fmla="*/ 36 w 276"/>
              <a:gd name="T13" fmla="*/ 20 h 41"/>
              <a:gd name="T14" fmla="*/ 45 w 276"/>
              <a:gd name="T15" fmla="*/ 18 h 41"/>
              <a:gd name="T16" fmla="*/ 48 w 276"/>
              <a:gd name="T17" fmla="*/ 18 h 41"/>
              <a:gd name="T18" fmla="*/ 57 w 276"/>
              <a:gd name="T19" fmla="*/ 18 h 41"/>
              <a:gd name="T20" fmla="*/ 60 w 276"/>
              <a:gd name="T21" fmla="*/ 19 h 41"/>
              <a:gd name="T22" fmla="*/ 69 w 276"/>
              <a:gd name="T23" fmla="*/ 22 h 41"/>
              <a:gd name="T24" fmla="*/ 72 w 276"/>
              <a:gd name="T25" fmla="*/ 23 h 41"/>
              <a:gd name="T26" fmla="*/ 81 w 276"/>
              <a:gd name="T27" fmla="*/ 26 h 41"/>
              <a:gd name="T28" fmla="*/ 84 w 276"/>
              <a:gd name="T29" fmla="*/ 25 h 41"/>
              <a:gd name="T30" fmla="*/ 93 w 276"/>
              <a:gd name="T31" fmla="*/ 23 h 41"/>
              <a:gd name="T32" fmla="*/ 96 w 276"/>
              <a:gd name="T33" fmla="*/ 22 h 41"/>
              <a:gd name="T34" fmla="*/ 105 w 276"/>
              <a:gd name="T35" fmla="*/ 19 h 41"/>
              <a:gd name="T36" fmla="*/ 108 w 276"/>
              <a:gd name="T37" fmla="*/ 18 h 41"/>
              <a:gd name="T38" fmla="*/ 117 w 276"/>
              <a:gd name="T39" fmla="*/ 18 h 41"/>
              <a:gd name="T40" fmla="*/ 120 w 276"/>
              <a:gd name="T41" fmla="*/ 18 h 41"/>
              <a:gd name="T42" fmla="*/ 129 w 276"/>
              <a:gd name="T43" fmla="*/ 17 h 41"/>
              <a:gd name="T44" fmla="*/ 132 w 276"/>
              <a:gd name="T45" fmla="*/ 17 h 41"/>
              <a:gd name="T46" fmla="*/ 141 w 276"/>
              <a:gd name="T47" fmla="*/ 17 h 41"/>
              <a:gd name="T48" fmla="*/ 144 w 276"/>
              <a:gd name="T49" fmla="*/ 16 h 41"/>
              <a:gd name="T50" fmla="*/ 153 w 276"/>
              <a:gd name="T51" fmla="*/ 15 h 41"/>
              <a:gd name="T52" fmla="*/ 156 w 276"/>
              <a:gd name="T53" fmla="*/ 15 h 41"/>
              <a:gd name="T54" fmla="*/ 165 w 276"/>
              <a:gd name="T55" fmla="*/ 14 h 41"/>
              <a:gd name="T56" fmla="*/ 168 w 276"/>
              <a:gd name="T57" fmla="*/ 12 h 41"/>
              <a:gd name="T58" fmla="*/ 177 w 276"/>
              <a:gd name="T59" fmla="*/ 7 h 41"/>
              <a:gd name="T60" fmla="*/ 180 w 276"/>
              <a:gd name="T61" fmla="*/ 6 h 41"/>
              <a:gd name="T62" fmla="*/ 188 w 276"/>
              <a:gd name="T63" fmla="*/ 1 h 41"/>
              <a:gd name="T64" fmla="*/ 191 w 276"/>
              <a:gd name="T65" fmla="*/ 0 h 41"/>
              <a:gd name="T66" fmla="*/ 198 w 276"/>
              <a:gd name="T67" fmla="*/ 5 h 41"/>
              <a:gd name="T68" fmla="*/ 201 w 276"/>
              <a:gd name="T69" fmla="*/ 8 h 41"/>
              <a:gd name="T70" fmla="*/ 208 w 276"/>
              <a:gd name="T71" fmla="*/ 15 h 41"/>
              <a:gd name="T72" fmla="*/ 211 w 276"/>
              <a:gd name="T73" fmla="*/ 18 h 41"/>
              <a:gd name="T74" fmla="*/ 218 w 276"/>
              <a:gd name="T75" fmla="*/ 25 h 41"/>
              <a:gd name="T76" fmla="*/ 220 w 276"/>
              <a:gd name="T77" fmla="*/ 27 h 41"/>
              <a:gd name="T78" fmla="*/ 220 w 276"/>
              <a:gd name="T79" fmla="*/ 27 h 41"/>
              <a:gd name="T80" fmla="*/ 229 w 276"/>
              <a:gd name="T81" fmla="*/ 29 h 41"/>
              <a:gd name="T82" fmla="*/ 232 w 276"/>
              <a:gd name="T83" fmla="*/ 30 h 41"/>
              <a:gd name="T84" fmla="*/ 241 w 276"/>
              <a:gd name="T85" fmla="*/ 31 h 41"/>
              <a:gd name="T86" fmla="*/ 244 w 276"/>
              <a:gd name="T87" fmla="*/ 32 h 41"/>
              <a:gd name="T88" fmla="*/ 253 w 276"/>
              <a:gd name="T89" fmla="*/ 34 h 41"/>
              <a:gd name="T90" fmla="*/ 256 w 276"/>
              <a:gd name="T91" fmla="*/ 35 h 41"/>
              <a:gd name="T92" fmla="*/ 265 w 276"/>
              <a:gd name="T93" fmla="*/ 38 h 41"/>
              <a:gd name="T94" fmla="*/ 268 w 276"/>
              <a:gd name="T95" fmla="*/ 39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276" h="41">
                <a:moveTo>
                  <a:pt x="9" y="29"/>
                </a:moveTo>
                <a:lnTo>
                  <a:pt x="12" y="28"/>
                </a:lnTo>
                <a:moveTo>
                  <a:pt x="21" y="24"/>
                </a:moveTo>
                <a:lnTo>
                  <a:pt x="24" y="22"/>
                </a:lnTo>
                <a:moveTo>
                  <a:pt x="33" y="21"/>
                </a:moveTo>
                <a:lnTo>
                  <a:pt x="36" y="20"/>
                </a:lnTo>
                <a:moveTo>
                  <a:pt x="45" y="18"/>
                </a:moveTo>
                <a:lnTo>
                  <a:pt x="48" y="18"/>
                </a:lnTo>
                <a:moveTo>
                  <a:pt x="57" y="18"/>
                </a:moveTo>
                <a:lnTo>
                  <a:pt x="60" y="19"/>
                </a:lnTo>
                <a:moveTo>
                  <a:pt x="69" y="22"/>
                </a:moveTo>
                <a:lnTo>
                  <a:pt x="72" y="23"/>
                </a:lnTo>
                <a:moveTo>
                  <a:pt x="81" y="26"/>
                </a:moveTo>
                <a:lnTo>
                  <a:pt x="84" y="25"/>
                </a:lnTo>
                <a:moveTo>
                  <a:pt x="93" y="23"/>
                </a:moveTo>
                <a:lnTo>
                  <a:pt x="96" y="22"/>
                </a:lnTo>
                <a:moveTo>
                  <a:pt x="105" y="19"/>
                </a:moveTo>
                <a:lnTo>
                  <a:pt x="108" y="18"/>
                </a:lnTo>
                <a:moveTo>
                  <a:pt x="117" y="18"/>
                </a:moveTo>
                <a:lnTo>
                  <a:pt x="120" y="18"/>
                </a:lnTo>
                <a:moveTo>
                  <a:pt x="129" y="17"/>
                </a:moveTo>
                <a:lnTo>
                  <a:pt x="132" y="17"/>
                </a:lnTo>
                <a:moveTo>
                  <a:pt x="141" y="17"/>
                </a:moveTo>
                <a:lnTo>
                  <a:pt x="144" y="16"/>
                </a:lnTo>
                <a:moveTo>
                  <a:pt x="153" y="15"/>
                </a:moveTo>
                <a:lnTo>
                  <a:pt x="156" y="15"/>
                </a:lnTo>
                <a:moveTo>
                  <a:pt x="165" y="14"/>
                </a:moveTo>
                <a:lnTo>
                  <a:pt x="168" y="12"/>
                </a:lnTo>
                <a:moveTo>
                  <a:pt x="177" y="7"/>
                </a:moveTo>
                <a:lnTo>
                  <a:pt x="180" y="6"/>
                </a:lnTo>
                <a:moveTo>
                  <a:pt x="188" y="1"/>
                </a:moveTo>
                <a:lnTo>
                  <a:pt x="191" y="0"/>
                </a:lnTo>
                <a:moveTo>
                  <a:pt x="198" y="5"/>
                </a:moveTo>
                <a:lnTo>
                  <a:pt x="201" y="8"/>
                </a:lnTo>
                <a:moveTo>
                  <a:pt x="208" y="15"/>
                </a:moveTo>
                <a:lnTo>
                  <a:pt x="211" y="18"/>
                </a:lnTo>
                <a:moveTo>
                  <a:pt x="218" y="25"/>
                </a:moveTo>
                <a:lnTo>
                  <a:pt x="220" y="27"/>
                </a:lnTo>
                <a:lnTo>
                  <a:pt x="220" y="27"/>
                </a:lnTo>
                <a:moveTo>
                  <a:pt x="229" y="29"/>
                </a:moveTo>
                <a:lnTo>
                  <a:pt x="232" y="30"/>
                </a:lnTo>
                <a:moveTo>
                  <a:pt x="241" y="31"/>
                </a:moveTo>
                <a:lnTo>
                  <a:pt x="244" y="32"/>
                </a:lnTo>
                <a:moveTo>
                  <a:pt x="253" y="34"/>
                </a:moveTo>
                <a:lnTo>
                  <a:pt x="256" y="35"/>
                </a:lnTo>
                <a:moveTo>
                  <a:pt x="265" y="38"/>
                </a:moveTo>
                <a:lnTo>
                  <a:pt x="268" y="39"/>
                </a:lnTo>
              </a:path>
            </a:pathLst>
          </a:custGeom>
          <a:noFill/>
          <a:ln w="396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7" name="Rectangle 25">
            <a:extLst>
              <a:ext uri="{FF2B5EF4-FFF2-40B4-BE49-F238E27FC236}">
                <a16:creationId xmlns:a16="http://schemas.microsoft.com/office/drawing/2014/main" id="{2E4C0345-1AEE-49CB-B71E-B33ADC042D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5666" y="2795588"/>
            <a:ext cx="41189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8" name="Rectangle 26">
            <a:extLst>
              <a:ext uri="{FF2B5EF4-FFF2-40B4-BE49-F238E27FC236}">
                <a16:creationId xmlns:a16="http://schemas.microsoft.com/office/drawing/2014/main" id="{A61B9C1C-126F-4B55-B7ED-E4CE108E8B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5666" y="2865438"/>
            <a:ext cx="41189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9" name="Rectangle 27">
            <a:extLst>
              <a:ext uri="{FF2B5EF4-FFF2-40B4-BE49-F238E27FC236}">
                <a16:creationId xmlns:a16="http://schemas.microsoft.com/office/drawing/2014/main" id="{37DC8963-6DDC-4F90-949C-985C7CBAA0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00838" y="2806701"/>
            <a:ext cx="7084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0" name="Rectangle 28">
            <a:extLst>
              <a:ext uri="{FF2B5EF4-FFF2-40B4-BE49-F238E27FC236}">
                <a16:creationId xmlns:a16="http://schemas.microsoft.com/office/drawing/2014/main" id="{06B9EA22-5DD8-4B87-9F26-6913EAA0C3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00838" y="2854326"/>
            <a:ext cx="7084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1" name="Rectangle 29">
            <a:extLst>
              <a:ext uri="{FF2B5EF4-FFF2-40B4-BE49-F238E27FC236}">
                <a16:creationId xmlns:a16="http://schemas.microsoft.com/office/drawing/2014/main" id="{D941716C-37AC-44D2-9701-8D888E95AA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7658" y="2817813"/>
            <a:ext cx="97205" cy="1270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2" name="Rectangle 30">
            <a:extLst>
              <a:ext uri="{FF2B5EF4-FFF2-40B4-BE49-F238E27FC236}">
                <a16:creationId xmlns:a16="http://schemas.microsoft.com/office/drawing/2014/main" id="{7DF6CE78-9B92-4000-885E-16366CA4BE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7658" y="2841626"/>
            <a:ext cx="97205" cy="1270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3" name="Rectangle 31">
            <a:extLst>
              <a:ext uri="{FF2B5EF4-FFF2-40B4-BE49-F238E27FC236}">
                <a16:creationId xmlns:a16="http://schemas.microsoft.com/office/drawing/2014/main" id="{FD3E35D9-2BC5-417D-8B00-3CA8234612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7658" y="2830513"/>
            <a:ext cx="9720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4" name="Rectangle 32">
            <a:extLst>
              <a:ext uri="{FF2B5EF4-FFF2-40B4-BE49-F238E27FC236}">
                <a16:creationId xmlns:a16="http://schemas.microsoft.com/office/drawing/2014/main" id="{A1634386-70EC-4A58-A2EB-A0479D20C1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7658" y="2830513"/>
            <a:ext cx="9720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5" name="Rectangle 33">
            <a:extLst>
              <a:ext uri="{FF2B5EF4-FFF2-40B4-BE49-F238E27FC236}">
                <a16:creationId xmlns:a16="http://schemas.microsoft.com/office/drawing/2014/main" id="{5C43CE68-7CCF-47CB-B300-0638719A4F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8482" y="2136776"/>
            <a:ext cx="41189" cy="1270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6" name="Rectangle 34">
            <a:extLst>
              <a:ext uri="{FF2B5EF4-FFF2-40B4-BE49-F238E27FC236}">
                <a16:creationId xmlns:a16="http://schemas.microsoft.com/office/drawing/2014/main" id="{05858082-1ED9-4E85-B5FA-D3EDC58CEA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8482" y="2208213"/>
            <a:ext cx="41189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7" name="Rectangle 35">
            <a:extLst>
              <a:ext uri="{FF2B5EF4-FFF2-40B4-BE49-F238E27FC236}">
                <a16:creationId xmlns:a16="http://schemas.microsoft.com/office/drawing/2014/main" id="{1642E347-AC2E-4002-AA5E-D26ECFD6D2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5302" y="2149476"/>
            <a:ext cx="69197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8" name="Rectangle 36">
            <a:extLst>
              <a:ext uri="{FF2B5EF4-FFF2-40B4-BE49-F238E27FC236}">
                <a16:creationId xmlns:a16="http://schemas.microsoft.com/office/drawing/2014/main" id="{194C389E-B999-4CB1-A6F1-C09430F980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5302" y="2195513"/>
            <a:ext cx="69197" cy="1270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9" name="Rectangle 37">
            <a:extLst>
              <a:ext uri="{FF2B5EF4-FFF2-40B4-BE49-F238E27FC236}">
                <a16:creationId xmlns:a16="http://schemas.microsoft.com/office/drawing/2014/main" id="{1860A1FE-82A6-42C5-A340-57941DAED3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0474" y="2160588"/>
            <a:ext cx="97205" cy="1270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0" name="Rectangle 38">
            <a:extLst>
              <a:ext uri="{FF2B5EF4-FFF2-40B4-BE49-F238E27FC236}">
                <a16:creationId xmlns:a16="http://schemas.microsoft.com/office/drawing/2014/main" id="{79C277FB-50D6-4B56-B102-F9FDFBF9DF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0474" y="2184401"/>
            <a:ext cx="9720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1" name="Rectangle 39">
            <a:extLst>
              <a:ext uri="{FF2B5EF4-FFF2-40B4-BE49-F238E27FC236}">
                <a16:creationId xmlns:a16="http://schemas.microsoft.com/office/drawing/2014/main" id="{7E14E37A-1C12-41D4-B8B9-7A5A291FEE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0474" y="2173288"/>
            <a:ext cx="9720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2" name="Rectangle 40">
            <a:extLst>
              <a:ext uri="{FF2B5EF4-FFF2-40B4-BE49-F238E27FC236}">
                <a16:creationId xmlns:a16="http://schemas.microsoft.com/office/drawing/2014/main" id="{9108D1E2-A74A-4414-860C-CA5A389470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0474" y="2173288"/>
            <a:ext cx="97205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3" name="Freeform 41">
            <a:extLst>
              <a:ext uri="{FF2B5EF4-FFF2-40B4-BE49-F238E27FC236}">
                <a16:creationId xmlns:a16="http://schemas.microsoft.com/office/drawing/2014/main" id="{26CCC04B-4B8A-4155-84E9-27E5CDB35251}"/>
              </a:ext>
            </a:extLst>
          </p:cNvPr>
          <p:cNvSpPr>
            <a:spLocks/>
          </p:cNvSpPr>
          <p:nvPr/>
        </p:nvSpPr>
        <p:spPr bwMode="auto">
          <a:xfrm>
            <a:off x="1727804" y="1092201"/>
            <a:ext cx="5453390" cy="2536825"/>
          </a:xfrm>
          <a:custGeom>
            <a:avLst/>
            <a:gdLst>
              <a:gd name="T0" fmla="*/ 0 w 391"/>
              <a:gd name="T1" fmla="*/ 216 h 216"/>
              <a:gd name="T2" fmla="*/ 28 w 391"/>
              <a:gd name="T3" fmla="*/ 103 h 216"/>
              <a:gd name="T4" fmla="*/ 56 w 391"/>
              <a:gd name="T5" fmla="*/ 38 h 216"/>
              <a:gd name="T6" fmla="*/ 84 w 391"/>
              <a:gd name="T7" fmla="*/ 27 h 216"/>
              <a:gd name="T8" fmla="*/ 112 w 391"/>
              <a:gd name="T9" fmla="*/ 216 h 216"/>
              <a:gd name="T10" fmla="*/ 140 w 391"/>
              <a:gd name="T11" fmla="*/ 69 h 216"/>
              <a:gd name="T12" fmla="*/ 168 w 391"/>
              <a:gd name="T13" fmla="*/ 27 h 216"/>
              <a:gd name="T14" fmla="*/ 196 w 391"/>
              <a:gd name="T15" fmla="*/ 95 h 216"/>
              <a:gd name="T16" fmla="*/ 224 w 391"/>
              <a:gd name="T17" fmla="*/ 63 h 216"/>
              <a:gd name="T18" fmla="*/ 251 w 391"/>
              <a:gd name="T19" fmla="*/ 0 h 216"/>
              <a:gd name="T20" fmla="*/ 279 w 391"/>
              <a:gd name="T21" fmla="*/ 79 h 216"/>
              <a:gd name="T22" fmla="*/ 307 w 391"/>
              <a:gd name="T23" fmla="*/ 126 h 216"/>
              <a:gd name="T24" fmla="*/ 335 w 391"/>
              <a:gd name="T25" fmla="*/ 71 h 216"/>
              <a:gd name="T26" fmla="*/ 363 w 391"/>
              <a:gd name="T27" fmla="*/ 58 h 216"/>
              <a:gd name="T28" fmla="*/ 391 w 391"/>
              <a:gd name="T29" fmla="*/ 69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91" h="216">
                <a:moveTo>
                  <a:pt x="0" y="216"/>
                </a:moveTo>
                <a:lnTo>
                  <a:pt x="28" y="103"/>
                </a:lnTo>
                <a:lnTo>
                  <a:pt x="56" y="38"/>
                </a:lnTo>
                <a:lnTo>
                  <a:pt x="84" y="27"/>
                </a:lnTo>
                <a:lnTo>
                  <a:pt x="112" y="216"/>
                </a:lnTo>
                <a:lnTo>
                  <a:pt x="140" y="69"/>
                </a:lnTo>
                <a:lnTo>
                  <a:pt x="168" y="27"/>
                </a:lnTo>
                <a:lnTo>
                  <a:pt x="196" y="95"/>
                </a:lnTo>
                <a:lnTo>
                  <a:pt x="224" y="63"/>
                </a:lnTo>
                <a:lnTo>
                  <a:pt x="251" y="0"/>
                </a:lnTo>
                <a:lnTo>
                  <a:pt x="279" y="79"/>
                </a:lnTo>
                <a:lnTo>
                  <a:pt x="307" y="126"/>
                </a:lnTo>
                <a:lnTo>
                  <a:pt x="335" y="71"/>
                </a:lnTo>
                <a:lnTo>
                  <a:pt x="363" y="58"/>
                </a:lnTo>
                <a:lnTo>
                  <a:pt x="391" y="69"/>
                </a:lnTo>
              </a:path>
            </a:pathLst>
          </a:custGeom>
          <a:noFill/>
          <a:ln w="396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4" name="Freeform 42">
            <a:extLst>
              <a:ext uri="{FF2B5EF4-FFF2-40B4-BE49-F238E27FC236}">
                <a16:creationId xmlns:a16="http://schemas.microsoft.com/office/drawing/2014/main" id="{93DE8479-36BE-4776-AFD2-00666F328E3D}"/>
              </a:ext>
            </a:extLst>
          </p:cNvPr>
          <p:cNvSpPr>
            <a:spLocks noEditPoints="1"/>
          </p:cNvSpPr>
          <p:nvPr/>
        </p:nvSpPr>
        <p:spPr bwMode="auto">
          <a:xfrm>
            <a:off x="9566845" y="1725613"/>
            <a:ext cx="1896330" cy="411163"/>
          </a:xfrm>
          <a:custGeom>
            <a:avLst/>
            <a:gdLst>
              <a:gd name="T0" fmla="*/ 0 w 136"/>
              <a:gd name="T1" fmla="*/ 33 h 35"/>
              <a:gd name="T2" fmla="*/ 9 w 136"/>
              <a:gd name="T3" fmla="*/ 34 h 35"/>
              <a:gd name="T4" fmla="*/ 12 w 136"/>
              <a:gd name="T5" fmla="*/ 34 h 35"/>
              <a:gd name="T6" fmla="*/ 21 w 136"/>
              <a:gd name="T7" fmla="*/ 35 h 35"/>
              <a:gd name="T8" fmla="*/ 24 w 136"/>
              <a:gd name="T9" fmla="*/ 35 h 35"/>
              <a:gd name="T10" fmla="*/ 31 w 136"/>
              <a:gd name="T11" fmla="*/ 28 h 35"/>
              <a:gd name="T12" fmla="*/ 33 w 136"/>
              <a:gd name="T13" fmla="*/ 25 h 35"/>
              <a:gd name="T14" fmla="*/ 39 w 136"/>
              <a:gd name="T15" fmla="*/ 17 h 35"/>
              <a:gd name="T16" fmla="*/ 42 w 136"/>
              <a:gd name="T17" fmla="*/ 14 h 35"/>
              <a:gd name="T18" fmla="*/ 48 w 136"/>
              <a:gd name="T19" fmla="*/ 6 h 35"/>
              <a:gd name="T20" fmla="*/ 50 w 136"/>
              <a:gd name="T21" fmla="*/ 3 h 35"/>
              <a:gd name="T22" fmla="*/ 57 w 136"/>
              <a:gd name="T23" fmla="*/ 6 h 35"/>
              <a:gd name="T24" fmla="*/ 59 w 136"/>
              <a:gd name="T25" fmla="*/ 9 h 35"/>
              <a:gd name="T26" fmla="*/ 66 w 136"/>
              <a:gd name="T27" fmla="*/ 16 h 35"/>
              <a:gd name="T28" fmla="*/ 68 w 136"/>
              <a:gd name="T29" fmla="*/ 19 h 35"/>
              <a:gd name="T30" fmla="*/ 75 w 136"/>
              <a:gd name="T31" fmla="*/ 26 h 35"/>
              <a:gd name="T32" fmla="*/ 77 w 136"/>
              <a:gd name="T33" fmla="*/ 29 h 35"/>
              <a:gd name="T34" fmla="*/ 84 w 136"/>
              <a:gd name="T35" fmla="*/ 29 h 35"/>
              <a:gd name="T36" fmla="*/ 87 w 136"/>
              <a:gd name="T37" fmla="*/ 27 h 35"/>
              <a:gd name="T38" fmla="*/ 95 w 136"/>
              <a:gd name="T39" fmla="*/ 21 h 35"/>
              <a:gd name="T40" fmla="*/ 98 w 136"/>
              <a:gd name="T41" fmla="*/ 19 h 35"/>
              <a:gd name="T42" fmla="*/ 106 w 136"/>
              <a:gd name="T43" fmla="*/ 13 h 35"/>
              <a:gd name="T44" fmla="*/ 108 w 136"/>
              <a:gd name="T45" fmla="*/ 12 h 35"/>
              <a:gd name="T46" fmla="*/ 108 w 136"/>
              <a:gd name="T47" fmla="*/ 12 h 35"/>
              <a:gd name="T48" fmla="*/ 117 w 136"/>
              <a:gd name="T49" fmla="*/ 8 h 35"/>
              <a:gd name="T50" fmla="*/ 120 w 136"/>
              <a:gd name="T51" fmla="*/ 7 h 35"/>
              <a:gd name="T52" fmla="*/ 129 w 136"/>
              <a:gd name="T53" fmla="*/ 3 h 35"/>
              <a:gd name="T54" fmla="*/ 132 w 136"/>
              <a:gd name="T55" fmla="*/ 2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</a:cxnLst>
            <a:rect l="0" t="0" r="r" b="b"/>
            <a:pathLst>
              <a:path w="136" h="35">
                <a:moveTo>
                  <a:pt x="9" y="34"/>
                </a:moveTo>
                <a:lnTo>
                  <a:pt x="12" y="34"/>
                </a:lnTo>
                <a:moveTo>
                  <a:pt x="21" y="35"/>
                </a:moveTo>
                <a:lnTo>
                  <a:pt x="24" y="35"/>
                </a:lnTo>
                <a:moveTo>
                  <a:pt x="31" y="28"/>
                </a:moveTo>
                <a:lnTo>
                  <a:pt x="33" y="25"/>
                </a:lnTo>
                <a:moveTo>
                  <a:pt x="39" y="17"/>
                </a:moveTo>
                <a:lnTo>
                  <a:pt x="42" y="14"/>
                </a:lnTo>
                <a:moveTo>
                  <a:pt x="48" y="6"/>
                </a:moveTo>
                <a:lnTo>
                  <a:pt x="50" y="3"/>
                </a:lnTo>
                <a:moveTo>
                  <a:pt x="57" y="6"/>
                </a:moveTo>
                <a:lnTo>
                  <a:pt x="59" y="9"/>
                </a:lnTo>
                <a:moveTo>
                  <a:pt x="66" y="16"/>
                </a:moveTo>
                <a:lnTo>
                  <a:pt x="68" y="19"/>
                </a:lnTo>
                <a:moveTo>
                  <a:pt x="75" y="26"/>
                </a:moveTo>
                <a:lnTo>
                  <a:pt x="77" y="29"/>
                </a:lnTo>
                <a:moveTo>
                  <a:pt x="84" y="29"/>
                </a:moveTo>
                <a:lnTo>
                  <a:pt x="87" y="27"/>
                </a:lnTo>
                <a:moveTo>
                  <a:pt x="95" y="21"/>
                </a:moveTo>
                <a:lnTo>
                  <a:pt x="98" y="19"/>
                </a:lnTo>
                <a:moveTo>
                  <a:pt x="106" y="13"/>
                </a:moveTo>
                <a:lnTo>
                  <a:pt x="108" y="12"/>
                </a:lnTo>
                <a:lnTo>
                  <a:pt x="108" y="12"/>
                </a:lnTo>
                <a:moveTo>
                  <a:pt x="117" y="8"/>
                </a:moveTo>
                <a:lnTo>
                  <a:pt x="120" y="7"/>
                </a:lnTo>
                <a:moveTo>
                  <a:pt x="129" y="3"/>
                </a:moveTo>
                <a:lnTo>
                  <a:pt x="132" y="2"/>
                </a:lnTo>
              </a:path>
            </a:pathLst>
          </a:custGeom>
          <a:noFill/>
          <a:ln w="396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5" name="Rectangle 43">
            <a:extLst>
              <a:ext uri="{FF2B5EF4-FFF2-40B4-BE49-F238E27FC236}">
                <a16:creationId xmlns:a16="http://schemas.microsoft.com/office/drawing/2014/main" id="{7B3D0989-AC4B-45B1-883F-CFFA355155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8013" y="1866901"/>
            <a:ext cx="41189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6" name="Rectangle 44">
            <a:extLst>
              <a:ext uri="{FF2B5EF4-FFF2-40B4-BE49-F238E27FC236}">
                <a16:creationId xmlns:a16="http://schemas.microsoft.com/office/drawing/2014/main" id="{6A79D328-67F4-4DF1-B6B8-4B1721F3D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8013" y="1938338"/>
            <a:ext cx="41189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7" name="Rectangle 45">
            <a:extLst>
              <a:ext uri="{FF2B5EF4-FFF2-40B4-BE49-F238E27FC236}">
                <a16:creationId xmlns:a16="http://schemas.microsoft.com/office/drawing/2014/main" id="{4E163DF2-55EC-4172-9D34-F3A2E38B27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3185" y="1879601"/>
            <a:ext cx="70845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8" name="Rectangle 46">
            <a:extLst>
              <a:ext uri="{FF2B5EF4-FFF2-40B4-BE49-F238E27FC236}">
                <a16:creationId xmlns:a16="http://schemas.microsoft.com/office/drawing/2014/main" id="{50318536-ACAC-4827-A1E3-FD7727FC63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3185" y="1925638"/>
            <a:ext cx="70845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9" name="Rectangle 47">
            <a:extLst>
              <a:ext uri="{FF2B5EF4-FFF2-40B4-BE49-F238E27FC236}">
                <a16:creationId xmlns:a16="http://schemas.microsoft.com/office/drawing/2014/main" id="{E4FD6EA7-5FCE-4A5E-9D2E-03AFA6C853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0004" y="1890713"/>
            <a:ext cx="97205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0" name="Rectangle 48">
            <a:extLst>
              <a:ext uri="{FF2B5EF4-FFF2-40B4-BE49-F238E27FC236}">
                <a16:creationId xmlns:a16="http://schemas.microsoft.com/office/drawing/2014/main" id="{34A01000-A659-4A1A-A8C2-FD66AABA02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0004" y="1914526"/>
            <a:ext cx="97205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1" name="Rectangle 49">
            <a:extLst>
              <a:ext uri="{FF2B5EF4-FFF2-40B4-BE49-F238E27FC236}">
                <a16:creationId xmlns:a16="http://schemas.microsoft.com/office/drawing/2014/main" id="{4B6D4B47-6CCE-4E6A-88CA-40CB974DB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0004" y="1901826"/>
            <a:ext cx="97205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2" name="Rectangle 50">
            <a:extLst>
              <a:ext uri="{FF2B5EF4-FFF2-40B4-BE49-F238E27FC236}">
                <a16:creationId xmlns:a16="http://schemas.microsoft.com/office/drawing/2014/main" id="{8763CB7B-F7C0-4052-8205-0C6651EBC8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0004" y="1901826"/>
            <a:ext cx="97205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3" name="Rectangle 51">
            <a:extLst>
              <a:ext uri="{FF2B5EF4-FFF2-40B4-BE49-F238E27FC236}">
                <a16:creationId xmlns:a16="http://schemas.microsoft.com/office/drawing/2014/main" id="{4521C302-317F-4F20-9DD8-5D69136A1E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0828" y="2078038"/>
            <a:ext cx="42836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4" name="Rectangle 52">
            <a:extLst>
              <a:ext uri="{FF2B5EF4-FFF2-40B4-BE49-F238E27FC236}">
                <a16:creationId xmlns:a16="http://schemas.microsoft.com/office/drawing/2014/main" id="{00D61555-D24C-404D-9FE4-6C51023554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0828" y="2149476"/>
            <a:ext cx="42836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5" name="Rectangle 53">
            <a:extLst>
              <a:ext uri="{FF2B5EF4-FFF2-40B4-BE49-F238E27FC236}">
                <a16:creationId xmlns:a16="http://schemas.microsoft.com/office/drawing/2014/main" id="{2954EE22-7996-4F1D-B627-D89DD5DE3C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7648" y="2090738"/>
            <a:ext cx="69197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6" name="Rectangle 54">
            <a:extLst>
              <a:ext uri="{FF2B5EF4-FFF2-40B4-BE49-F238E27FC236}">
                <a16:creationId xmlns:a16="http://schemas.microsoft.com/office/drawing/2014/main" id="{BF7830D9-D524-4F07-A54E-611D1D5B29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7648" y="2136776"/>
            <a:ext cx="69197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7" name="Rectangle 55">
            <a:extLst>
              <a:ext uri="{FF2B5EF4-FFF2-40B4-BE49-F238E27FC236}">
                <a16:creationId xmlns:a16="http://schemas.microsoft.com/office/drawing/2014/main" id="{8B63FEC0-7990-4A04-A6BC-20228EAA55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820" y="2101851"/>
            <a:ext cx="97205" cy="1270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8" name="Rectangle 56">
            <a:extLst>
              <a:ext uri="{FF2B5EF4-FFF2-40B4-BE49-F238E27FC236}">
                <a16:creationId xmlns:a16="http://schemas.microsoft.com/office/drawing/2014/main" id="{1F49E23D-A10F-48F5-B523-AE9BDD3A64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820" y="2125663"/>
            <a:ext cx="97205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9" name="Rectangle 57">
            <a:extLst>
              <a:ext uri="{FF2B5EF4-FFF2-40B4-BE49-F238E27FC236}">
                <a16:creationId xmlns:a16="http://schemas.microsoft.com/office/drawing/2014/main" id="{1C885666-D7E2-4DF4-8709-A4516B825B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820" y="2114551"/>
            <a:ext cx="97205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0" name="Rectangle 58">
            <a:extLst>
              <a:ext uri="{FF2B5EF4-FFF2-40B4-BE49-F238E27FC236}">
                <a16:creationId xmlns:a16="http://schemas.microsoft.com/office/drawing/2014/main" id="{D8A57D75-6CEA-4CD0-A3BD-7624F65FAA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820" y="2114551"/>
            <a:ext cx="97205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1" name="Freeform 59">
            <a:extLst>
              <a:ext uri="{FF2B5EF4-FFF2-40B4-BE49-F238E27FC236}">
                <a16:creationId xmlns:a16="http://schemas.microsoft.com/office/drawing/2014/main" id="{E0E7FAC4-D35F-45D7-9A05-C5F952223693}"/>
              </a:ext>
            </a:extLst>
          </p:cNvPr>
          <p:cNvSpPr>
            <a:spLocks/>
          </p:cNvSpPr>
          <p:nvPr/>
        </p:nvSpPr>
        <p:spPr bwMode="auto">
          <a:xfrm>
            <a:off x="1727804" y="1901826"/>
            <a:ext cx="2344463" cy="739775"/>
          </a:xfrm>
          <a:custGeom>
            <a:avLst/>
            <a:gdLst>
              <a:gd name="T0" fmla="*/ 0 w 168"/>
              <a:gd name="T1" fmla="*/ 60 h 63"/>
              <a:gd name="T2" fmla="*/ 28 w 168"/>
              <a:gd name="T3" fmla="*/ 63 h 63"/>
              <a:gd name="T4" fmla="*/ 56 w 168"/>
              <a:gd name="T5" fmla="*/ 59 h 63"/>
              <a:gd name="T6" fmla="*/ 84 w 168"/>
              <a:gd name="T7" fmla="*/ 26 h 63"/>
              <a:gd name="T8" fmla="*/ 112 w 168"/>
              <a:gd name="T9" fmla="*/ 62 h 63"/>
              <a:gd name="T10" fmla="*/ 140 w 168"/>
              <a:gd name="T11" fmla="*/ 35 h 63"/>
              <a:gd name="T12" fmla="*/ 168 w 168"/>
              <a:gd name="T13" fmla="*/ 0 h 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8" h="63">
                <a:moveTo>
                  <a:pt x="0" y="60"/>
                </a:moveTo>
                <a:lnTo>
                  <a:pt x="28" y="63"/>
                </a:lnTo>
                <a:lnTo>
                  <a:pt x="56" y="59"/>
                </a:lnTo>
                <a:lnTo>
                  <a:pt x="84" y="26"/>
                </a:lnTo>
                <a:lnTo>
                  <a:pt x="112" y="62"/>
                </a:lnTo>
                <a:lnTo>
                  <a:pt x="140" y="35"/>
                </a:lnTo>
                <a:lnTo>
                  <a:pt x="168" y="0"/>
                </a:lnTo>
              </a:path>
            </a:pathLst>
          </a:custGeom>
          <a:noFill/>
          <a:ln w="396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2" name="Freeform 60">
            <a:extLst>
              <a:ext uri="{FF2B5EF4-FFF2-40B4-BE49-F238E27FC236}">
                <a16:creationId xmlns:a16="http://schemas.microsoft.com/office/drawing/2014/main" id="{8B94A045-2F09-4B1C-B485-D8C41B7B23FD}"/>
              </a:ext>
            </a:extLst>
          </p:cNvPr>
          <p:cNvSpPr>
            <a:spLocks noEditPoints="1"/>
          </p:cNvSpPr>
          <p:nvPr/>
        </p:nvSpPr>
        <p:spPr bwMode="auto">
          <a:xfrm>
            <a:off x="6443091" y="1431926"/>
            <a:ext cx="5020084" cy="365125"/>
          </a:xfrm>
          <a:custGeom>
            <a:avLst/>
            <a:gdLst>
              <a:gd name="T0" fmla="*/ 0 w 360"/>
              <a:gd name="T1" fmla="*/ 25 h 31"/>
              <a:gd name="T2" fmla="*/ 9 w 360"/>
              <a:gd name="T3" fmla="*/ 27 h 31"/>
              <a:gd name="T4" fmla="*/ 12 w 360"/>
              <a:gd name="T5" fmla="*/ 28 h 31"/>
              <a:gd name="T6" fmla="*/ 21 w 360"/>
              <a:gd name="T7" fmla="*/ 30 h 31"/>
              <a:gd name="T8" fmla="*/ 24 w 360"/>
              <a:gd name="T9" fmla="*/ 31 h 31"/>
              <a:gd name="T10" fmla="*/ 33 w 360"/>
              <a:gd name="T11" fmla="*/ 28 h 31"/>
              <a:gd name="T12" fmla="*/ 36 w 360"/>
              <a:gd name="T13" fmla="*/ 27 h 31"/>
              <a:gd name="T14" fmla="*/ 45 w 360"/>
              <a:gd name="T15" fmla="*/ 24 h 31"/>
              <a:gd name="T16" fmla="*/ 48 w 360"/>
              <a:gd name="T17" fmla="*/ 23 h 31"/>
              <a:gd name="T18" fmla="*/ 57 w 360"/>
              <a:gd name="T19" fmla="*/ 21 h 31"/>
              <a:gd name="T20" fmla="*/ 60 w 360"/>
              <a:gd name="T21" fmla="*/ 21 h 31"/>
              <a:gd name="T22" fmla="*/ 69 w 360"/>
              <a:gd name="T23" fmla="*/ 22 h 31"/>
              <a:gd name="T24" fmla="*/ 72 w 360"/>
              <a:gd name="T25" fmla="*/ 22 h 31"/>
              <a:gd name="T26" fmla="*/ 81 w 360"/>
              <a:gd name="T27" fmla="*/ 22 h 31"/>
              <a:gd name="T28" fmla="*/ 84 w 360"/>
              <a:gd name="T29" fmla="*/ 21 h 31"/>
              <a:gd name="T30" fmla="*/ 93 w 360"/>
              <a:gd name="T31" fmla="*/ 16 h 31"/>
              <a:gd name="T32" fmla="*/ 96 w 360"/>
              <a:gd name="T33" fmla="*/ 15 h 31"/>
              <a:gd name="T34" fmla="*/ 105 w 360"/>
              <a:gd name="T35" fmla="*/ 10 h 31"/>
              <a:gd name="T36" fmla="*/ 108 w 360"/>
              <a:gd name="T37" fmla="*/ 9 h 31"/>
              <a:gd name="T38" fmla="*/ 117 w 360"/>
              <a:gd name="T39" fmla="*/ 10 h 31"/>
              <a:gd name="T40" fmla="*/ 120 w 360"/>
              <a:gd name="T41" fmla="*/ 11 h 31"/>
              <a:gd name="T42" fmla="*/ 129 w 360"/>
              <a:gd name="T43" fmla="*/ 14 h 31"/>
              <a:gd name="T44" fmla="*/ 132 w 360"/>
              <a:gd name="T45" fmla="*/ 15 h 31"/>
              <a:gd name="T46" fmla="*/ 141 w 360"/>
              <a:gd name="T47" fmla="*/ 16 h 31"/>
              <a:gd name="T48" fmla="*/ 144 w 360"/>
              <a:gd name="T49" fmla="*/ 16 h 31"/>
              <a:gd name="T50" fmla="*/ 153 w 360"/>
              <a:gd name="T51" fmla="*/ 16 h 31"/>
              <a:gd name="T52" fmla="*/ 156 w 360"/>
              <a:gd name="T53" fmla="*/ 16 h 31"/>
              <a:gd name="T54" fmla="*/ 165 w 360"/>
              <a:gd name="T55" fmla="*/ 16 h 31"/>
              <a:gd name="T56" fmla="*/ 168 w 360"/>
              <a:gd name="T57" fmla="*/ 16 h 31"/>
              <a:gd name="T58" fmla="*/ 177 w 360"/>
              <a:gd name="T59" fmla="*/ 15 h 31"/>
              <a:gd name="T60" fmla="*/ 180 w 360"/>
              <a:gd name="T61" fmla="*/ 15 h 31"/>
              <a:gd name="T62" fmla="*/ 189 w 360"/>
              <a:gd name="T63" fmla="*/ 14 h 31"/>
              <a:gd name="T64" fmla="*/ 192 w 360"/>
              <a:gd name="T65" fmla="*/ 14 h 31"/>
              <a:gd name="T66" fmla="*/ 201 w 360"/>
              <a:gd name="T67" fmla="*/ 13 h 31"/>
              <a:gd name="T68" fmla="*/ 204 w 360"/>
              <a:gd name="T69" fmla="*/ 12 h 31"/>
              <a:gd name="T70" fmla="*/ 213 w 360"/>
              <a:gd name="T71" fmla="*/ 11 h 31"/>
              <a:gd name="T72" fmla="*/ 216 w 360"/>
              <a:gd name="T73" fmla="*/ 11 h 31"/>
              <a:gd name="T74" fmla="*/ 225 w 360"/>
              <a:gd name="T75" fmla="*/ 10 h 31"/>
              <a:gd name="T76" fmla="*/ 228 w 360"/>
              <a:gd name="T77" fmla="*/ 11 h 31"/>
              <a:gd name="T78" fmla="*/ 237 w 360"/>
              <a:gd name="T79" fmla="*/ 12 h 31"/>
              <a:gd name="T80" fmla="*/ 240 w 360"/>
              <a:gd name="T81" fmla="*/ 12 h 31"/>
              <a:gd name="T82" fmla="*/ 249 w 360"/>
              <a:gd name="T83" fmla="*/ 13 h 31"/>
              <a:gd name="T84" fmla="*/ 252 w 360"/>
              <a:gd name="T85" fmla="*/ 13 h 31"/>
              <a:gd name="T86" fmla="*/ 261 w 360"/>
              <a:gd name="T87" fmla="*/ 13 h 31"/>
              <a:gd name="T88" fmla="*/ 264 w 360"/>
              <a:gd name="T89" fmla="*/ 12 h 31"/>
              <a:gd name="T90" fmla="*/ 273 w 360"/>
              <a:gd name="T91" fmla="*/ 12 h 31"/>
              <a:gd name="T92" fmla="*/ 276 w 360"/>
              <a:gd name="T93" fmla="*/ 12 h 31"/>
              <a:gd name="T94" fmla="*/ 276 w 360"/>
              <a:gd name="T95" fmla="*/ 12 h 31"/>
              <a:gd name="T96" fmla="*/ 285 w 360"/>
              <a:gd name="T97" fmla="*/ 11 h 31"/>
              <a:gd name="T98" fmla="*/ 288 w 360"/>
              <a:gd name="T99" fmla="*/ 10 h 31"/>
              <a:gd name="T100" fmla="*/ 297 w 360"/>
              <a:gd name="T101" fmla="*/ 9 h 31"/>
              <a:gd name="T102" fmla="*/ 300 w 360"/>
              <a:gd name="T103" fmla="*/ 9 h 31"/>
              <a:gd name="T104" fmla="*/ 309 w 360"/>
              <a:gd name="T105" fmla="*/ 7 h 31"/>
              <a:gd name="T106" fmla="*/ 312 w 360"/>
              <a:gd name="T107" fmla="*/ 6 h 31"/>
              <a:gd name="T108" fmla="*/ 321 w 360"/>
              <a:gd name="T109" fmla="*/ 3 h 31"/>
              <a:gd name="T110" fmla="*/ 324 w 360"/>
              <a:gd name="T111" fmla="*/ 2 h 31"/>
              <a:gd name="T112" fmla="*/ 332 w 360"/>
              <a:gd name="T113" fmla="*/ 0 h 31"/>
              <a:gd name="T114" fmla="*/ 335 w 360"/>
              <a:gd name="T115" fmla="*/ 2 h 31"/>
              <a:gd name="T116" fmla="*/ 343 w 360"/>
              <a:gd name="T117" fmla="*/ 7 h 31"/>
              <a:gd name="T118" fmla="*/ 346 w 360"/>
              <a:gd name="T119" fmla="*/ 9 h 31"/>
              <a:gd name="T120" fmla="*/ 354 w 360"/>
              <a:gd name="T121" fmla="*/ 15 h 31"/>
              <a:gd name="T122" fmla="*/ 357 w 360"/>
              <a:gd name="T123" fmla="*/ 17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360" h="31">
                <a:moveTo>
                  <a:pt x="9" y="27"/>
                </a:moveTo>
                <a:lnTo>
                  <a:pt x="12" y="28"/>
                </a:lnTo>
                <a:moveTo>
                  <a:pt x="21" y="30"/>
                </a:moveTo>
                <a:lnTo>
                  <a:pt x="24" y="31"/>
                </a:lnTo>
                <a:moveTo>
                  <a:pt x="33" y="28"/>
                </a:moveTo>
                <a:lnTo>
                  <a:pt x="36" y="27"/>
                </a:lnTo>
                <a:moveTo>
                  <a:pt x="45" y="24"/>
                </a:moveTo>
                <a:lnTo>
                  <a:pt x="48" y="23"/>
                </a:lnTo>
                <a:moveTo>
                  <a:pt x="57" y="21"/>
                </a:moveTo>
                <a:lnTo>
                  <a:pt x="60" y="21"/>
                </a:lnTo>
                <a:moveTo>
                  <a:pt x="69" y="22"/>
                </a:moveTo>
                <a:lnTo>
                  <a:pt x="72" y="22"/>
                </a:lnTo>
                <a:moveTo>
                  <a:pt x="81" y="22"/>
                </a:moveTo>
                <a:lnTo>
                  <a:pt x="84" y="21"/>
                </a:lnTo>
                <a:moveTo>
                  <a:pt x="93" y="16"/>
                </a:moveTo>
                <a:lnTo>
                  <a:pt x="96" y="15"/>
                </a:lnTo>
                <a:moveTo>
                  <a:pt x="105" y="10"/>
                </a:moveTo>
                <a:lnTo>
                  <a:pt x="108" y="9"/>
                </a:lnTo>
                <a:moveTo>
                  <a:pt x="117" y="10"/>
                </a:moveTo>
                <a:lnTo>
                  <a:pt x="120" y="11"/>
                </a:lnTo>
                <a:moveTo>
                  <a:pt x="129" y="14"/>
                </a:moveTo>
                <a:lnTo>
                  <a:pt x="132" y="15"/>
                </a:lnTo>
                <a:moveTo>
                  <a:pt x="141" y="16"/>
                </a:moveTo>
                <a:lnTo>
                  <a:pt x="144" y="16"/>
                </a:lnTo>
                <a:moveTo>
                  <a:pt x="153" y="16"/>
                </a:moveTo>
                <a:lnTo>
                  <a:pt x="156" y="16"/>
                </a:lnTo>
                <a:moveTo>
                  <a:pt x="165" y="16"/>
                </a:moveTo>
                <a:lnTo>
                  <a:pt x="168" y="16"/>
                </a:lnTo>
                <a:moveTo>
                  <a:pt x="177" y="15"/>
                </a:moveTo>
                <a:lnTo>
                  <a:pt x="180" y="15"/>
                </a:lnTo>
                <a:moveTo>
                  <a:pt x="189" y="14"/>
                </a:moveTo>
                <a:lnTo>
                  <a:pt x="192" y="14"/>
                </a:lnTo>
                <a:moveTo>
                  <a:pt x="201" y="13"/>
                </a:moveTo>
                <a:lnTo>
                  <a:pt x="204" y="12"/>
                </a:lnTo>
                <a:moveTo>
                  <a:pt x="213" y="11"/>
                </a:moveTo>
                <a:lnTo>
                  <a:pt x="216" y="11"/>
                </a:lnTo>
                <a:moveTo>
                  <a:pt x="225" y="10"/>
                </a:moveTo>
                <a:lnTo>
                  <a:pt x="228" y="11"/>
                </a:lnTo>
                <a:moveTo>
                  <a:pt x="237" y="12"/>
                </a:moveTo>
                <a:lnTo>
                  <a:pt x="240" y="12"/>
                </a:lnTo>
                <a:moveTo>
                  <a:pt x="249" y="13"/>
                </a:moveTo>
                <a:lnTo>
                  <a:pt x="252" y="13"/>
                </a:lnTo>
                <a:moveTo>
                  <a:pt x="261" y="13"/>
                </a:moveTo>
                <a:lnTo>
                  <a:pt x="264" y="12"/>
                </a:lnTo>
                <a:moveTo>
                  <a:pt x="273" y="12"/>
                </a:moveTo>
                <a:lnTo>
                  <a:pt x="276" y="12"/>
                </a:lnTo>
                <a:lnTo>
                  <a:pt x="276" y="12"/>
                </a:lnTo>
                <a:moveTo>
                  <a:pt x="285" y="11"/>
                </a:moveTo>
                <a:lnTo>
                  <a:pt x="288" y="10"/>
                </a:lnTo>
                <a:moveTo>
                  <a:pt x="297" y="9"/>
                </a:moveTo>
                <a:lnTo>
                  <a:pt x="300" y="9"/>
                </a:lnTo>
                <a:moveTo>
                  <a:pt x="309" y="7"/>
                </a:moveTo>
                <a:lnTo>
                  <a:pt x="312" y="6"/>
                </a:lnTo>
                <a:moveTo>
                  <a:pt x="321" y="3"/>
                </a:moveTo>
                <a:lnTo>
                  <a:pt x="324" y="2"/>
                </a:lnTo>
                <a:moveTo>
                  <a:pt x="332" y="0"/>
                </a:moveTo>
                <a:lnTo>
                  <a:pt x="335" y="2"/>
                </a:lnTo>
                <a:moveTo>
                  <a:pt x="343" y="7"/>
                </a:moveTo>
                <a:lnTo>
                  <a:pt x="346" y="9"/>
                </a:lnTo>
                <a:moveTo>
                  <a:pt x="354" y="15"/>
                </a:moveTo>
                <a:lnTo>
                  <a:pt x="357" y="17"/>
                </a:lnTo>
              </a:path>
            </a:pathLst>
          </a:custGeom>
          <a:noFill/>
          <a:ln w="396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3" name="Rectangle 61">
            <a:extLst>
              <a:ext uri="{FF2B5EF4-FFF2-40B4-BE49-F238E27FC236}">
                <a16:creationId xmlns:a16="http://schemas.microsoft.com/office/drawing/2014/main" id="{B4C75332-6F1C-4067-AD8B-58BF58B401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7439" y="1866901"/>
            <a:ext cx="42836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4" name="Rectangle 62">
            <a:extLst>
              <a:ext uri="{FF2B5EF4-FFF2-40B4-BE49-F238E27FC236}">
                <a16:creationId xmlns:a16="http://schemas.microsoft.com/office/drawing/2014/main" id="{2F2FFCA6-15A0-4924-8747-339D5AED43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7439" y="1938338"/>
            <a:ext cx="4283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5" name="Rectangle 63">
            <a:extLst>
              <a:ext uri="{FF2B5EF4-FFF2-40B4-BE49-F238E27FC236}">
                <a16:creationId xmlns:a16="http://schemas.microsoft.com/office/drawing/2014/main" id="{4A6F6E50-DBFB-46DD-A6F9-A2E329BEA9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4258" y="1879601"/>
            <a:ext cx="69197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6" name="Rectangle 64">
            <a:extLst>
              <a:ext uri="{FF2B5EF4-FFF2-40B4-BE49-F238E27FC236}">
                <a16:creationId xmlns:a16="http://schemas.microsoft.com/office/drawing/2014/main" id="{A4194972-B6A1-4D9D-B919-AB456045A3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4258" y="1925638"/>
            <a:ext cx="69197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7" name="Rectangle 65">
            <a:extLst>
              <a:ext uri="{FF2B5EF4-FFF2-40B4-BE49-F238E27FC236}">
                <a16:creationId xmlns:a16="http://schemas.microsoft.com/office/drawing/2014/main" id="{E2AA61D8-D506-46AC-96FB-265F65025A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430" y="1890713"/>
            <a:ext cx="9720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8" name="Rectangle 66">
            <a:extLst>
              <a:ext uri="{FF2B5EF4-FFF2-40B4-BE49-F238E27FC236}">
                <a16:creationId xmlns:a16="http://schemas.microsoft.com/office/drawing/2014/main" id="{BBF42199-12D5-49A1-84A8-E62D328865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430" y="1914526"/>
            <a:ext cx="9720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9" name="Rectangle 67">
            <a:extLst>
              <a:ext uri="{FF2B5EF4-FFF2-40B4-BE49-F238E27FC236}">
                <a16:creationId xmlns:a16="http://schemas.microsoft.com/office/drawing/2014/main" id="{E00A0A3F-C0C0-401B-B291-7790362AD2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430" y="1901826"/>
            <a:ext cx="97205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0" name="Rectangle 68">
            <a:extLst>
              <a:ext uri="{FF2B5EF4-FFF2-40B4-BE49-F238E27FC236}">
                <a16:creationId xmlns:a16="http://schemas.microsoft.com/office/drawing/2014/main" id="{04DADBF6-7937-4E2B-B9F1-0605E3CE77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430" y="1901826"/>
            <a:ext cx="97205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1" name="Rectangle 69">
            <a:extLst>
              <a:ext uri="{FF2B5EF4-FFF2-40B4-BE49-F238E27FC236}">
                <a16:creationId xmlns:a16="http://schemas.microsoft.com/office/drawing/2014/main" id="{91EF4FA1-21AB-4E68-9FCD-3A030A1A47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7074" y="1679576"/>
            <a:ext cx="41189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2" name="Rectangle 70">
            <a:extLst>
              <a:ext uri="{FF2B5EF4-FFF2-40B4-BE49-F238E27FC236}">
                <a16:creationId xmlns:a16="http://schemas.microsoft.com/office/drawing/2014/main" id="{ED710108-FB13-4749-B11B-1EB8E30837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7074" y="1749426"/>
            <a:ext cx="41189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3" name="Rectangle 71">
            <a:extLst>
              <a:ext uri="{FF2B5EF4-FFF2-40B4-BE49-F238E27FC236}">
                <a16:creationId xmlns:a16="http://schemas.microsoft.com/office/drawing/2014/main" id="{BC557CC0-509D-4971-AF2C-BA81604FC8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246" y="1690688"/>
            <a:ext cx="70845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4" name="Rectangle 72">
            <a:extLst>
              <a:ext uri="{FF2B5EF4-FFF2-40B4-BE49-F238E27FC236}">
                <a16:creationId xmlns:a16="http://schemas.microsoft.com/office/drawing/2014/main" id="{8B49D3BA-DE62-4E0F-9FE9-B89BCDD69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246" y="1738313"/>
            <a:ext cx="7084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5" name="Rectangle 73">
            <a:extLst>
              <a:ext uri="{FF2B5EF4-FFF2-40B4-BE49-F238E27FC236}">
                <a16:creationId xmlns:a16="http://schemas.microsoft.com/office/drawing/2014/main" id="{DD624E8C-52CF-4EA6-8565-19EE8EB40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703388"/>
            <a:ext cx="9720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6" name="Rectangle 74">
            <a:extLst>
              <a:ext uri="{FF2B5EF4-FFF2-40B4-BE49-F238E27FC236}">
                <a16:creationId xmlns:a16="http://schemas.microsoft.com/office/drawing/2014/main" id="{3E5344A4-73AE-4EDE-A7AA-4670D74711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725613"/>
            <a:ext cx="97205" cy="1270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7" name="Rectangle 75">
            <a:extLst>
              <a:ext uri="{FF2B5EF4-FFF2-40B4-BE49-F238E27FC236}">
                <a16:creationId xmlns:a16="http://schemas.microsoft.com/office/drawing/2014/main" id="{13251DF9-344E-43F2-ACB6-5053E1C864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714501"/>
            <a:ext cx="9720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8" name="Rectangle 76">
            <a:extLst>
              <a:ext uri="{FF2B5EF4-FFF2-40B4-BE49-F238E27FC236}">
                <a16:creationId xmlns:a16="http://schemas.microsoft.com/office/drawing/2014/main" id="{2E76B69D-C37E-498B-838F-8AA1EDC85E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714501"/>
            <a:ext cx="9720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9" name="Freeform 77">
            <a:extLst>
              <a:ext uri="{FF2B5EF4-FFF2-40B4-BE49-F238E27FC236}">
                <a16:creationId xmlns:a16="http://schemas.microsoft.com/office/drawing/2014/main" id="{0871DAD8-3098-4DB5-9D7F-FC1E757086F9}"/>
              </a:ext>
            </a:extLst>
          </p:cNvPr>
          <p:cNvSpPr>
            <a:spLocks/>
          </p:cNvSpPr>
          <p:nvPr/>
        </p:nvSpPr>
        <p:spPr bwMode="auto">
          <a:xfrm>
            <a:off x="1727804" y="1503363"/>
            <a:ext cx="4672451" cy="1397000"/>
          </a:xfrm>
          <a:custGeom>
            <a:avLst/>
            <a:gdLst>
              <a:gd name="T0" fmla="*/ 0 w 335"/>
              <a:gd name="T1" fmla="*/ 21 h 119"/>
              <a:gd name="T2" fmla="*/ 28 w 335"/>
              <a:gd name="T3" fmla="*/ 34 h 119"/>
              <a:gd name="T4" fmla="*/ 56 w 335"/>
              <a:gd name="T5" fmla="*/ 18 h 119"/>
              <a:gd name="T6" fmla="*/ 84 w 335"/>
              <a:gd name="T7" fmla="*/ 62 h 119"/>
              <a:gd name="T8" fmla="*/ 112 w 335"/>
              <a:gd name="T9" fmla="*/ 119 h 119"/>
              <a:gd name="T10" fmla="*/ 140 w 335"/>
              <a:gd name="T11" fmla="*/ 64 h 119"/>
              <a:gd name="T12" fmla="*/ 168 w 335"/>
              <a:gd name="T13" fmla="*/ 51 h 119"/>
              <a:gd name="T14" fmla="*/ 196 w 335"/>
              <a:gd name="T15" fmla="*/ 36 h 119"/>
              <a:gd name="T16" fmla="*/ 224 w 335"/>
              <a:gd name="T17" fmla="*/ 101 h 119"/>
              <a:gd name="T18" fmla="*/ 251 w 335"/>
              <a:gd name="T19" fmla="*/ 76 h 119"/>
              <a:gd name="T20" fmla="*/ 279 w 335"/>
              <a:gd name="T21" fmla="*/ 64 h 119"/>
              <a:gd name="T22" fmla="*/ 307 w 335"/>
              <a:gd name="T23" fmla="*/ 57 h 119"/>
              <a:gd name="T24" fmla="*/ 335 w 335"/>
              <a:gd name="T25" fmla="*/ 0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335" h="119">
                <a:moveTo>
                  <a:pt x="0" y="21"/>
                </a:moveTo>
                <a:lnTo>
                  <a:pt x="28" y="34"/>
                </a:lnTo>
                <a:lnTo>
                  <a:pt x="56" y="18"/>
                </a:lnTo>
                <a:lnTo>
                  <a:pt x="84" y="62"/>
                </a:lnTo>
                <a:lnTo>
                  <a:pt x="112" y="119"/>
                </a:lnTo>
                <a:lnTo>
                  <a:pt x="140" y="64"/>
                </a:lnTo>
                <a:lnTo>
                  <a:pt x="168" y="51"/>
                </a:lnTo>
                <a:lnTo>
                  <a:pt x="196" y="36"/>
                </a:lnTo>
                <a:lnTo>
                  <a:pt x="224" y="101"/>
                </a:lnTo>
                <a:lnTo>
                  <a:pt x="251" y="76"/>
                </a:lnTo>
                <a:lnTo>
                  <a:pt x="279" y="64"/>
                </a:lnTo>
                <a:lnTo>
                  <a:pt x="307" y="57"/>
                </a:lnTo>
                <a:lnTo>
                  <a:pt x="335" y="0"/>
                </a:lnTo>
              </a:path>
            </a:pathLst>
          </a:custGeom>
          <a:noFill/>
          <a:ln w="396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0" name="Freeform 78">
            <a:extLst>
              <a:ext uri="{FF2B5EF4-FFF2-40B4-BE49-F238E27FC236}">
                <a16:creationId xmlns:a16="http://schemas.microsoft.com/office/drawing/2014/main" id="{C39A6DE8-F3A9-4DE9-AEA5-F8CAD9BF30A1}"/>
              </a:ext>
            </a:extLst>
          </p:cNvPr>
          <p:cNvSpPr>
            <a:spLocks noEditPoints="1"/>
          </p:cNvSpPr>
          <p:nvPr/>
        </p:nvSpPr>
        <p:spPr bwMode="auto">
          <a:xfrm>
            <a:off x="8395437" y="1490663"/>
            <a:ext cx="3067738" cy="635000"/>
          </a:xfrm>
          <a:custGeom>
            <a:avLst/>
            <a:gdLst>
              <a:gd name="T0" fmla="*/ 0 w 220"/>
              <a:gd name="T1" fmla="*/ 36 h 54"/>
              <a:gd name="T2" fmla="*/ 9 w 220"/>
              <a:gd name="T3" fmla="*/ 34 h 54"/>
              <a:gd name="T4" fmla="*/ 12 w 220"/>
              <a:gd name="T5" fmla="*/ 34 h 54"/>
              <a:gd name="T6" fmla="*/ 21 w 220"/>
              <a:gd name="T7" fmla="*/ 32 h 54"/>
              <a:gd name="T8" fmla="*/ 24 w 220"/>
              <a:gd name="T9" fmla="*/ 31 h 54"/>
              <a:gd name="T10" fmla="*/ 32 w 220"/>
              <a:gd name="T11" fmla="*/ 37 h 54"/>
              <a:gd name="T12" fmla="*/ 35 w 220"/>
              <a:gd name="T13" fmla="*/ 39 h 54"/>
              <a:gd name="T14" fmla="*/ 42 w 220"/>
              <a:gd name="T15" fmla="*/ 45 h 54"/>
              <a:gd name="T16" fmla="*/ 45 w 220"/>
              <a:gd name="T17" fmla="*/ 47 h 54"/>
              <a:gd name="T18" fmla="*/ 52 w 220"/>
              <a:gd name="T19" fmla="*/ 53 h 54"/>
              <a:gd name="T20" fmla="*/ 53 w 220"/>
              <a:gd name="T21" fmla="*/ 54 h 54"/>
              <a:gd name="T22" fmla="*/ 54 w 220"/>
              <a:gd name="T23" fmla="*/ 53 h 54"/>
              <a:gd name="T24" fmla="*/ 62 w 220"/>
              <a:gd name="T25" fmla="*/ 48 h 54"/>
              <a:gd name="T26" fmla="*/ 65 w 220"/>
              <a:gd name="T27" fmla="*/ 46 h 54"/>
              <a:gd name="T28" fmla="*/ 73 w 220"/>
              <a:gd name="T29" fmla="*/ 41 h 54"/>
              <a:gd name="T30" fmla="*/ 76 w 220"/>
              <a:gd name="T31" fmla="*/ 39 h 54"/>
              <a:gd name="T32" fmla="*/ 84 w 220"/>
              <a:gd name="T33" fmla="*/ 34 h 54"/>
              <a:gd name="T34" fmla="*/ 87 w 220"/>
              <a:gd name="T35" fmla="*/ 32 h 54"/>
              <a:gd name="T36" fmla="*/ 96 w 220"/>
              <a:gd name="T37" fmla="*/ 27 h 54"/>
              <a:gd name="T38" fmla="*/ 99 w 220"/>
              <a:gd name="T39" fmla="*/ 25 h 54"/>
              <a:gd name="T40" fmla="*/ 107 w 220"/>
              <a:gd name="T41" fmla="*/ 20 h 54"/>
              <a:gd name="T42" fmla="*/ 109 w 220"/>
              <a:gd name="T43" fmla="*/ 19 h 54"/>
              <a:gd name="T44" fmla="*/ 109 w 220"/>
              <a:gd name="T45" fmla="*/ 19 h 54"/>
              <a:gd name="T46" fmla="*/ 117 w 220"/>
              <a:gd name="T47" fmla="*/ 13 h 54"/>
              <a:gd name="T48" fmla="*/ 120 w 220"/>
              <a:gd name="T49" fmla="*/ 10 h 54"/>
              <a:gd name="T50" fmla="*/ 128 w 220"/>
              <a:gd name="T51" fmla="*/ 4 h 54"/>
              <a:gd name="T52" fmla="*/ 131 w 220"/>
              <a:gd name="T53" fmla="*/ 2 h 54"/>
              <a:gd name="T54" fmla="*/ 138 w 220"/>
              <a:gd name="T55" fmla="*/ 0 h 54"/>
              <a:gd name="T56" fmla="*/ 141 w 220"/>
              <a:gd name="T57" fmla="*/ 2 h 54"/>
              <a:gd name="T58" fmla="*/ 148 w 220"/>
              <a:gd name="T59" fmla="*/ 8 h 54"/>
              <a:gd name="T60" fmla="*/ 151 w 220"/>
              <a:gd name="T61" fmla="*/ 11 h 54"/>
              <a:gd name="T62" fmla="*/ 158 w 220"/>
              <a:gd name="T63" fmla="*/ 17 h 54"/>
              <a:gd name="T64" fmla="*/ 161 w 220"/>
              <a:gd name="T65" fmla="*/ 19 h 54"/>
              <a:gd name="T66" fmla="*/ 169 w 220"/>
              <a:gd name="T67" fmla="*/ 22 h 54"/>
              <a:gd name="T68" fmla="*/ 172 w 220"/>
              <a:gd name="T69" fmla="*/ 22 h 54"/>
              <a:gd name="T70" fmla="*/ 181 w 220"/>
              <a:gd name="T71" fmla="*/ 22 h 54"/>
              <a:gd name="T72" fmla="*/ 184 w 220"/>
              <a:gd name="T73" fmla="*/ 22 h 54"/>
              <a:gd name="T74" fmla="*/ 193 w 220"/>
              <a:gd name="T75" fmla="*/ 21 h 54"/>
              <a:gd name="T76" fmla="*/ 196 w 220"/>
              <a:gd name="T77" fmla="*/ 20 h 54"/>
              <a:gd name="T78" fmla="*/ 205 w 220"/>
              <a:gd name="T79" fmla="*/ 15 h 54"/>
              <a:gd name="T80" fmla="*/ 208 w 220"/>
              <a:gd name="T81" fmla="*/ 13 h 54"/>
              <a:gd name="T82" fmla="*/ 217 w 220"/>
              <a:gd name="T83" fmla="*/ 9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</a:cxnLst>
            <a:rect l="0" t="0" r="r" b="b"/>
            <a:pathLst>
              <a:path w="220" h="54">
                <a:moveTo>
                  <a:pt x="9" y="34"/>
                </a:moveTo>
                <a:lnTo>
                  <a:pt x="12" y="34"/>
                </a:lnTo>
                <a:moveTo>
                  <a:pt x="21" y="32"/>
                </a:moveTo>
                <a:lnTo>
                  <a:pt x="24" y="31"/>
                </a:lnTo>
                <a:moveTo>
                  <a:pt x="32" y="37"/>
                </a:moveTo>
                <a:lnTo>
                  <a:pt x="35" y="39"/>
                </a:lnTo>
                <a:moveTo>
                  <a:pt x="42" y="45"/>
                </a:moveTo>
                <a:lnTo>
                  <a:pt x="45" y="47"/>
                </a:lnTo>
                <a:moveTo>
                  <a:pt x="52" y="53"/>
                </a:moveTo>
                <a:lnTo>
                  <a:pt x="53" y="54"/>
                </a:lnTo>
                <a:lnTo>
                  <a:pt x="54" y="53"/>
                </a:lnTo>
                <a:moveTo>
                  <a:pt x="62" y="48"/>
                </a:moveTo>
                <a:lnTo>
                  <a:pt x="65" y="46"/>
                </a:lnTo>
                <a:moveTo>
                  <a:pt x="73" y="41"/>
                </a:moveTo>
                <a:lnTo>
                  <a:pt x="76" y="39"/>
                </a:lnTo>
                <a:moveTo>
                  <a:pt x="84" y="34"/>
                </a:moveTo>
                <a:lnTo>
                  <a:pt x="87" y="32"/>
                </a:lnTo>
                <a:moveTo>
                  <a:pt x="96" y="27"/>
                </a:moveTo>
                <a:lnTo>
                  <a:pt x="99" y="25"/>
                </a:lnTo>
                <a:moveTo>
                  <a:pt x="107" y="20"/>
                </a:moveTo>
                <a:lnTo>
                  <a:pt x="109" y="19"/>
                </a:lnTo>
                <a:lnTo>
                  <a:pt x="109" y="19"/>
                </a:lnTo>
                <a:moveTo>
                  <a:pt x="117" y="13"/>
                </a:moveTo>
                <a:lnTo>
                  <a:pt x="120" y="10"/>
                </a:lnTo>
                <a:moveTo>
                  <a:pt x="128" y="4"/>
                </a:moveTo>
                <a:lnTo>
                  <a:pt x="131" y="2"/>
                </a:lnTo>
                <a:moveTo>
                  <a:pt x="138" y="0"/>
                </a:moveTo>
                <a:lnTo>
                  <a:pt x="141" y="2"/>
                </a:lnTo>
                <a:moveTo>
                  <a:pt x="148" y="8"/>
                </a:moveTo>
                <a:lnTo>
                  <a:pt x="151" y="11"/>
                </a:lnTo>
                <a:moveTo>
                  <a:pt x="158" y="17"/>
                </a:moveTo>
                <a:lnTo>
                  <a:pt x="161" y="19"/>
                </a:lnTo>
                <a:moveTo>
                  <a:pt x="169" y="22"/>
                </a:moveTo>
                <a:lnTo>
                  <a:pt x="172" y="22"/>
                </a:lnTo>
                <a:moveTo>
                  <a:pt x="181" y="22"/>
                </a:moveTo>
                <a:lnTo>
                  <a:pt x="184" y="22"/>
                </a:lnTo>
                <a:moveTo>
                  <a:pt x="193" y="21"/>
                </a:moveTo>
                <a:lnTo>
                  <a:pt x="196" y="20"/>
                </a:lnTo>
                <a:moveTo>
                  <a:pt x="205" y="15"/>
                </a:moveTo>
                <a:lnTo>
                  <a:pt x="208" y="13"/>
                </a:lnTo>
                <a:moveTo>
                  <a:pt x="217" y="9"/>
                </a:moveTo>
              </a:path>
            </a:pathLst>
          </a:custGeom>
          <a:noFill/>
          <a:ln w="396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1" name="Rectangle 79">
            <a:extLst>
              <a:ext uri="{FF2B5EF4-FFF2-40B4-BE49-F238E27FC236}">
                <a16:creationId xmlns:a16="http://schemas.microsoft.com/office/drawing/2014/main" id="{5CBBE7B7-2C29-4D05-BC25-5CCD20C743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7074" y="1468438"/>
            <a:ext cx="41189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2" name="Rectangle 80">
            <a:extLst>
              <a:ext uri="{FF2B5EF4-FFF2-40B4-BE49-F238E27FC236}">
                <a16:creationId xmlns:a16="http://schemas.microsoft.com/office/drawing/2014/main" id="{23BF65EA-0E8F-40F7-9281-35EB26D5EB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7074" y="1538288"/>
            <a:ext cx="41189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3" name="Rectangle 81">
            <a:extLst>
              <a:ext uri="{FF2B5EF4-FFF2-40B4-BE49-F238E27FC236}">
                <a16:creationId xmlns:a16="http://schemas.microsoft.com/office/drawing/2014/main" id="{96AF1B35-388A-4C5B-8EA1-A24E3F2A69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246" y="1479551"/>
            <a:ext cx="70845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4" name="Rectangle 82">
            <a:extLst>
              <a:ext uri="{FF2B5EF4-FFF2-40B4-BE49-F238E27FC236}">
                <a16:creationId xmlns:a16="http://schemas.microsoft.com/office/drawing/2014/main" id="{374B8F50-CC79-4777-B592-00916A0A84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246" y="1527176"/>
            <a:ext cx="70845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5" name="Rectangle 83">
            <a:extLst>
              <a:ext uri="{FF2B5EF4-FFF2-40B4-BE49-F238E27FC236}">
                <a16:creationId xmlns:a16="http://schemas.microsoft.com/office/drawing/2014/main" id="{326A1874-3B32-47B0-915B-F2C0FE42D4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490663"/>
            <a:ext cx="97205" cy="1270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6" name="Rectangle 84">
            <a:extLst>
              <a:ext uri="{FF2B5EF4-FFF2-40B4-BE49-F238E27FC236}">
                <a16:creationId xmlns:a16="http://schemas.microsoft.com/office/drawing/2014/main" id="{17162959-E632-460F-B47D-00D45A4FE3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514476"/>
            <a:ext cx="97205" cy="1270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7" name="Rectangle 85">
            <a:extLst>
              <a:ext uri="{FF2B5EF4-FFF2-40B4-BE49-F238E27FC236}">
                <a16:creationId xmlns:a16="http://schemas.microsoft.com/office/drawing/2014/main" id="{A62020FB-DE8C-4BEE-BC39-CDC8FF3B33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503363"/>
            <a:ext cx="97205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8" name="Rectangle 86">
            <a:extLst>
              <a:ext uri="{FF2B5EF4-FFF2-40B4-BE49-F238E27FC236}">
                <a16:creationId xmlns:a16="http://schemas.microsoft.com/office/drawing/2014/main" id="{300F6F10-5A7D-41E3-B4D5-AA0EE8A26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9066" y="1503363"/>
            <a:ext cx="97205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9" name="Rectangle 87">
            <a:extLst>
              <a:ext uri="{FF2B5EF4-FFF2-40B4-BE49-F238E27FC236}">
                <a16:creationId xmlns:a16="http://schemas.microsoft.com/office/drawing/2014/main" id="{8BE653EC-B037-4A98-A3FE-FD4B58E0E7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9420" y="1890713"/>
            <a:ext cx="41189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0" name="Rectangle 88">
            <a:extLst>
              <a:ext uri="{FF2B5EF4-FFF2-40B4-BE49-F238E27FC236}">
                <a16:creationId xmlns:a16="http://schemas.microsoft.com/office/drawing/2014/main" id="{08E93A56-04B2-4959-BC8A-2A9746D468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9420" y="1960563"/>
            <a:ext cx="41189" cy="1270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1" name="Rectangle 89">
            <a:extLst>
              <a:ext uri="{FF2B5EF4-FFF2-40B4-BE49-F238E27FC236}">
                <a16:creationId xmlns:a16="http://schemas.microsoft.com/office/drawing/2014/main" id="{A75EB895-FC43-44A7-BC78-EBD5844575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26240" y="1901826"/>
            <a:ext cx="69197" cy="1270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2" name="Rectangle 90">
            <a:extLst>
              <a:ext uri="{FF2B5EF4-FFF2-40B4-BE49-F238E27FC236}">
                <a16:creationId xmlns:a16="http://schemas.microsoft.com/office/drawing/2014/main" id="{5DB75AF0-F172-4637-8E2D-586CD77A51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26240" y="1949451"/>
            <a:ext cx="69197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3" name="Rectangle 91">
            <a:extLst>
              <a:ext uri="{FF2B5EF4-FFF2-40B4-BE49-F238E27FC236}">
                <a16:creationId xmlns:a16="http://schemas.microsoft.com/office/drawing/2014/main" id="{8DED284D-53AE-4D9A-9942-3CA40A8109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1412" y="1914526"/>
            <a:ext cx="97205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4" name="Rectangle 92">
            <a:extLst>
              <a:ext uri="{FF2B5EF4-FFF2-40B4-BE49-F238E27FC236}">
                <a16:creationId xmlns:a16="http://schemas.microsoft.com/office/drawing/2014/main" id="{B0A3F2DA-3FDA-4A0D-B439-421329B78C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1412" y="1938338"/>
            <a:ext cx="97205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5" name="Rectangle 93">
            <a:extLst>
              <a:ext uri="{FF2B5EF4-FFF2-40B4-BE49-F238E27FC236}">
                <a16:creationId xmlns:a16="http://schemas.microsoft.com/office/drawing/2014/main" id="{79B55CA5-5E6D-464E-ACB1-2CA1F47AF4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1412" y="1925638"/>
            <a:ext cx="97205" cy="1270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6" name="Rectangle 94">
            <a:extLst>
              <a:ext uri="{FF2B5EF4-FFF2-40B4-BE49-F238E27FC236}">
                <a16:creationId xmlns:a16="http://schemas.microsoft.com/office/drawing/2014/main" id="{113D17B6-4086-4B7B-9757-21248756FA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1412" y="1925638"/>
            <a:ext cx="97205" cy="1270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7" name="Rectangle 95">
            <a:extLst>
              <a:ext uri="{FF2B5EF4-FFF2-40B4-BE49-F238E27FC236}">
                <a16:creationId xmlns:a16="http://schemas.microsoft.com/office/drawing/2014/main" id="{FB4F90EE-E0E0-47C5-8573-DE2D891454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41339" y="4708526"/>
            <a:ext cx="1603066" cy="9048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8" name="Rectangle 96">
            <a:extLst>
              <a:ext uri="{FF2B5EF4-FFF2-40B4-BE49-F238E27FC236}">
                <a16:creationId xmlns:a16="http://schemas.microsoft.com/office/drawing/2014/main" id="{60B6FD9D-4BAC-4563-8187-D43D68191D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41339" y="4708526"/>
            <a:ext cx="1603066" cy="90487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9" name="Line 97">
            <a:extLst>
              <a:ext uri="{FF2B5EF4-FFF2-40B4-BE49-F238E27FC236}">
                <a16:creationId xmlns:a16="http://schemas.microsoft.com/office/drawing/2014/main" id="{4B6B4F3C-AA69-4FFE-BCD2-0409F242D48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07742" y="4897438"/>
            <a:ext cx="321272" cy="0"/>
          </a:xfrm>
          <a:prstGeom prst="line">
            <a:avLst/>
          </a:prstGeom>
          <a:noFill/>
          <a:ln w="269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0" name="Line 98">
            <a:extLst>
              <a:ext uri="{FF2B5EF4-FFF2-40B4-BE49-F238E27FC236}">
                <a16:creationId xmlns:a16="http://schemas.microsoft.com/office/drawing/2014/main" id="{B64EE541-29C3-4990-9559-9852DAA0D2F3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07742" y="5073651"/>
            <a:ext cx="321272" cy="0"/>
          </a:xfrm>
          <a:prstGeom prst="line">
            <a:avLst/>
          </a:prstGeom>
          <a:noFill/>
          <a:ln w="269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1" name="Line 99">
            <a:extLst>
              <a:ext uri="{FF2B5EF4-FFF2-40B4-BE49-F238E27FC236}">
                <a16:creationId xmlns:a16="http://schemas.microsoft.com/office/drawing/2014/main" id="{25C62823-44A8-4FEE-B34B-92615E114F95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07742" y="5260976"/>
            <a:ext cx="321272" cy="0"/>
          </a:xfrm>
          <a:prstGeom prst="line">
            <a:avLst/>
          </a:prstGeom>
          <a:noFill/>
          <a:ln w="269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2" name="Line 100">
            <a:extLst>
              <a:ext uri="{FF2B5EF4-FFF2-40B4-BE49-F238E27FC236}">
                <a16:creationId xmlns:a16="http://schemas.microsoft.com/office/drawing/2014/main" id="{2C1D18C4-58FC-469F-AEE9-9A1AB9D2EB99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07742" y="5437188"/>
            <a:ext cx="321272" cy="0"/>
          </a:xfrm>
          <a:prstGeom prst="line">
            <a:avLst/>
          </a:prstGeom>
          <a:noFill/>
          <a:ln w="269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3" name="Rectangle 101">
            <a:extLst>
              <a:ext uri="{FF2B5EF4-FFF2-40B4-BE49-F238E27FC236}">
                <a16:creationId xmlns:a16="http://schemas.microsoft.com/office/drawing/2014/main" id="{91DF4835-F8FF-47C3-ACDA-75F3C699B2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82236" y="4826001"/>
            <a:ext cx="934161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6400"/>
                </a:solidFill>
                <a:effectLst/>
                <a:latin typeface="Arial" panose="020B0604020202020204" pitchFamily="34" charset="0"/>
              </a:rPr>
              <a:t>GIRANG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102">
            <a:extLst>
              <a:ext uri="{FF2B5EF4-FFF2-40B4-BE49-F238E27FC236}">
                <a16:creationId xmlns:a16="http://schemas.microsoft.com/office/drawing/2014/main" id="{64A22203-3A21-4530-A1DB-D866DE478F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82236" y="5013326"/>
            <a:ext cx="962169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LUO IMB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3">
            <a:extLst>
              <a:ext uri="{FF2B5EF4-FFF2-40B4-BE49-F238E27FC236}">
                <a16:creationId xmlns:a16="http://schemas.microsoft.com/office/drawing/2014/main" id="{F44CBCC6-1D99-4404-A0B1-2B088C6DE3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82236" y="5189538"/>
            <a:ext cx="962169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rPr>
              <a:t>NYANCH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6" name="Rectangle 104">
            <a:extLst>
              <a:ext uri="{FF2B5EF4-FFF2-40B4-BE49-F238E27FC236}">
                <a16:creationId xmlns:a16="http://schemas.microsoft.com/office/drawing/2014/main" id="{5122F872-6177-4829-B2B1-FD333CEFAA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82236" y="5378451"/>
            <a:ext cx="571700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A020F0"/>
                </a:solidFill>
                <a:effectLst/>
                <a:latin typeface="Arial" panose="020B0604020202020204" pitchFamily="34" charset="0"/>
              </a:rPr>
              <a:t>SUB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" name="Rectangle 105">
            <a:extLst>
              <a:ext uri="{FF2B5EF4-FFF2-40B4-BE49-F238E27FC236}">
                <a16:creationId xmlns:a16="http://schemas.microsoft.com/office/drawing/2014/main" id="{02C67A7B-EA85-46CF-8F4E-96500FFF97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5958" y="5260976"/>
            <a:ext cx="3960709" cy="3524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8" name="Rectangle 106">
            <a:extLst>
              <a:ext uri="{FF2B5EF4-FFF2-40B4-BE49-F238E27FC236}">
                <a16:creationId xmlns:a16="http://schemas.microsoft.com/office/drawing/2014/main" id="{C77F1AA7-2C11-4EAE-9DAF-2EE0B6C1F1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5958" y="5260976"/>
            <a:ext cx="3960709" cy="352425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9" name="Line 107">
            <a:extLst>
              <a:ext uri="{FF2B5EF4-FFF2-40B4-BE49-F238E27FC236}">
                <a16:creationId xmlns:a16="http://schemas.microsoft.com/office/drawing/2014/main" id="{8F5D95A5-ABC8-47FB-926D-94CD7329B726}"/>
              </a:ext>
            </a:extLst>
          </p:cNvPr>
          <p:cNvSpPr>
            <a:spLocks noChangeShapeType="1"/>
          </p:cNvSpPr>
          <p:nvPr/>
        </p:nvSpPr>
        <p:spPr bwMode="auto">
          <a:xfrm>
            <a:off x="4782361" y="5437188"/>
            <a:ext cx="321272" cy="0"/>
          </a:xfrm>
          <a:prstGeom prst="line">
            <a:avLst/>
          </a:pr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0" name="Freeform 108">
            <a:extLst>
              <a:ext uri="{FF2B5EF4-FFF2-40B4-BE49-F238E27FC236}">
                <a16:creationId xmlns:a16="http://schemas.microsoft.com/office/drawing/2014/main" id="{772E8293-946A-4815-9E8E-8516DB844AF7}"/>
              </a:ext>
            </a:extLst>
          </p:cNvPr>
          <p:cNvSpPr>
            <a:spLocks noEditPoints="1"/>
          </p:cNvSpPr>
          <p:nvPr/>
        </p:nvSpPr>
        <p:spPr bwMode="auto">
          <a:xfrm>
            <a:off x="6749535" y="5437188"/>
            <a:ext cx="293264" cy="0"/>
          </a:xfrm>
          <a:custGeom>
            <a:avLst/>
            <a:gdLst>
              <a:gd name="T0" fmla="*/ 0 w 21"/>
              <a:gd name="T1" fmla="*/ 6 w 21"/>
              <a:gd name="T2" fmla="*/ 8 w 21"/>
              <a:gd name="T3" fmla="*/ 14 w 21"/>
              <a:gd name="T4" fmla="*/ 16 w 2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21">
                <a:moveTo>
                  <a:pt x="6" y="0"/>
                </a:moveTo>
                <a:lnTo>
                  <a:pt x="8" y="0"/>
                </a:lnTo>
                <a:moveTo>
                  <a:pt x="14" y="0"/>
                </a:moveTo>
                <a:lnTo>
                  <a:pt x="16" y="0"/>
                </a:lnTo>
              </a:path>
            </a:pathLst>
          </a:cu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1" name="Rectangle 109">
            <a:extLst>
              <a:ext uri="{FF2B5EF4-FFF2-40B4-BE49-F238E27FC236}">
                <a16:creationId xmlns:a16="http://schemas.microsoft.com/office/drawing/2014/main" id="{CF2C5CE0-95EE-45FC-B307-C2A2EEC668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6855" y="5378451"/>
            <a:ext cx="962169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110">
            <a:extLst>
              <a:ext uri="{FF2B5EF4-FFF2-40B4-BE49-F238E27FC236}">
                <a16:creationId xmlns:a16="http://schemas.microsoft.com/office/drawing/2014/main" id="{A898C7A6-D77A-466E-8FFB-1F203CF243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96021" y="5378451"/>
            <a:ext cx="1421835" cy="18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TERVENTION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2693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 6">
            <a:extLst>
              <a:ext uri="{FF2B5EF4-FFF2-40B4-BE49-F238E27FC236}">
                <a16:creationId xmlns:a16="http://schemas.microsoft.com/office/drawing/2014/main" id="{0B7B4D33-9E8E-4B35-BFEA-CD9A5B17969B}"/>
              </a:ext>
            </a:extLst>
          </p:cNvPr>
          <p:cNvSpPr>
            <a:spLocks/>
          </p:cNvSpPr>
          <p:nvPr/>
        </p:nvSpPr>
        <p:spPr bwMode="auto">
          <a:xfrm>
            <a:off x="1715969" y="1228140"/>
            <a:ext cx="3519638" cy="330638"/>
          </a:xfrm>
          <a:custGeom>
            <a:avLst/>
            <a:gdLst>
              <a:gd name="T0" fmla="*/ 0 w 251"/>
              <a:gd name="T1" fmla="*/ 25 h 28"/>
              <a:gd name="T2" fmla="*/ 28 w 251"/>
              <a:gd name="T3" fmla="*/ 2 h 28"/>
              <a:gd name="T4" fmla="*/ 56 w 251"/>
              <a:gd name="T5" fmla="*/ 7 h 28"/>
              <a:gd name="T6" fmla="*/ 84 w 251"/>
              <a:gd name="T7" fmla="*/ 15 h 28"/>
              <a:gd name="T8" fmla="*/ 112 w 251"/>
              <a:gd name="T9" fmla="*/ 10 h 28"/>
              <a:gd name="T10" fmla="*/ 140 w 251"/>
              <a:gd name="T11" fmla="*/ 28 h 28"/>
              <a:gd name="T12" fmla="*/ 168 w 251"/>
              <a:gd name="T13" fmla="*/ 0 h 28"/>
              <a:gd name="T14" fmla="*/ 196 w 251"/>
              <a:gd name="T15" fmla="*/ 8 h 28"/>
              <a:gd name="T16" fmla="*/ 224 w 251"/>
              <a:gd name="T17" fmla="*/ 3 h 28"/>
              <a:gd name="T18" fmla="*/ 251 w 251"/>
              <a:gd name="T19" fmla="*/ 9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1" h="28">
                <a:moveTo>
                  <a:pt x="0" y="25"/>
                </a:moveTo>
                <a:lnTo>
                  <a:pt x="28" y="2"/>
                </a:lnTo>
                <a:lnTo>
                  <a:pt x="56" y="7"/>
                </a:lnTo>
                <a:lnTo>
                  <a:pt x="84" y="15"/>
                </a:lnTo>
                <a:lnTo>
                  <a:pt x="112" y="10"/>
                </a:lnTo>
                <a:lnTo>
                  <a:pt x="140" y="28"/>
                </a:lnTo>
                <a:lnTo>
                  <a:pt x="168" y="0"/>
                </a:lnTo>
                <a:lnTo>
                  <a:pt x="196" y="8"/>
                </a:lnTo>
                <a:lnTo>
                  <a:pt x="224" y="3"/>
                </a:lnTo>
                <a:lnTo>
                  <a:pt x="251" y="9"/>
                </a:lnTo>
              </a:path>
            </a:pathLst>
          </a:custGeom>
          <a:noFill/>
          <a:ln w="396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" name="Line 7">
            <a:extLst>
              <a:ext uri="{FF2B5EF4-FFF2-40B4-BE49-F238E27FC236}">
                <a16:creationId xmlns:a16="http://schemas.microsoft.com/office/drawing/2014/main" id="{E453FCD3-C1B0-4330-BB49-5490BADA787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23426" y="957316"/>
            <a:ext cx="0" cy="4461116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" name="Line 8">
            <a:extLst>
              <a:ext uri="{FF2B5EF4-FFF2-40B4-BE49-F238E27FC236}">
                <a16:creationId xmlns:a16="http://schemas.microsoft.com/office/drawing/2014/main" id="{DCEC216F-12D7-4F99-90F2-4AE5F1EB03D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197547" y="5418432"/>
            <a:ext cx="125879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" name="Line 9">
            <a:extLst>
              <a:ext uri="{FF2B5EF4-FFF2-40B4-BE49-F238E27FC236}">
                <a16:creationId xmlns:a16="http://schemas.microsoft.com/office/drawing/2014/main" id="{318A9D52-647D-4A6A-B5A5-F2072DDF34C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197547" y="4532855"/>
            <a:ext cx="125879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" name="Line 10">
            <a:extLst>
              <a:ext uri="{FF2B5EF4-FFF2-40B4-BE49-F238E27FC236}">
                <a16:creationId xmlns:a16="http://schemas.microsoft.com/office/drawing/2014/main" id="{17CC48B9-4B85-40DE-86D6-9E4CDD28FCA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197547" y="3635647"/>
            <a:ext cx="125879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" name="Line 11">
            <a:extLst>
              <a:ext uri="{FF2B5EF4-FFF2-40B4-BE49-F238E27FC236}">
                <a16:creationId xmlns:a16="http://schemas.microsoft.com/office/drawing/2014/main" id="{1BAA7F83-37E9-4190-99D0-96905E94E41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197547" y="2751732"/>
            <a:ext cx="125879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2" name="Line 12">
            <a:extLst>
              <a:ext uri="{FF2B5EF4-FFF2-40B4-BE49-F238E27FC236}">
                <a16:creationId xmlns:a16="http://schemas.microsoft.com/office/drawing/2014/main" id="{F61E7F47-684C-4C2E-9E26-F2F65D722C4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197547" y="1854524"/>
            <a:ext cx="125879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3" name="Line 13">
            <a:extLst>
              <a:ext uri="{FF2B5EF4-FFF2-40B4-BE49-F238E27FC236}">
                <a16:creationId xmlns:a16="http://schemas.microsoft.com/office/drawing/2014/main" id="{CF00444A-CFEF-4205-8E15-3B00A482629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197547" y="957316"/>
            <a:ext cx="125879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4" name="Rectangle 14">
            <a:extLst>
              <a:ext uri="{FF2B5EF4-FFF2-40B4-BE49-F238E27FC236}">
                <a16:creationId xmlns:a16="http://schemas.microsoft.com/office/drawing/2014/main" id="{E866F638-0BC8-4930-8047-7E729E0FDBF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54319" y="5282613"/>
            <a:ext cx="239255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5">
            <a:extLst>
              <a:ext uri="{FF2B5EF4-FFF2-40B4-BE49-F238E27FC236}">
                <a16:creationId xmlns:a16="http://schemas.microsoft.com/office/drawing/2014/main" id="{443FFD41-88E9-4C29-AC67-67CB06111DF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84536" y="4397036"/>
            <a:ext cx="378821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6">
            <a:extLst>
              <a:ext uri="{FF2B5EF4-FFF2-40B4-BE49-F238E27FC236}">
                <a16:creationId xmlns:a16="http://schemas.microsoft.com/office/drawing/2014/main" id="{81838300-36F8-462C-958E-24FA13882FE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84536" y="3499828"/>
            <a:ext cx="378821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7">
            <a:extLst>
              <a:ext uri="{FF2B5EF4-FFF2-40B4-BE49-F238E27FC236}">
                <a16:creationId xmlns:a16="http://schemas.microsoft.com/office/drawing/2014/main" id="{1B0CBB2B-E127-4AB2-A028-8B0C9C53215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84536" y="2615913"/>
            <a:ext cx="378821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8">
            <a:extLst>
              <a:ext uri="{FF2B5EF4-FFF2-40B4-BE49-F238E27FC236}">
                <a16:creationId xmlns:a16="http://schemas.microsoft.com/office/drawing/2014/main" id="{30B1CE1C-BBF2-46FD-B8FF-8787AD45414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84536" y="1718705"/>
            <a:ext cx="378821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F6AA8EE3-19D8-4B69-AFDF-385B87E915E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21399" y="819836"/>
            <a:ext cx="505095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20">
            <a:extLst>
              <a:ext uri="{FF2B5EF4-FFF2-40B4-BE49-F238E27FC236}">
                <a16:creationId xmlns:a16="http://schemas.microsoft.com/office/drawing/2014/main" id="{EBE66FC0-BCA7-44A0-AE5C-801525F92D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3426" y="779536"/>
            <a:ext cx="10572163" cy="4828306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1" name="Rectangle 21">
            <a:extLst>
              <a:ext uri="{FF2B5EF4-FFF2-40B4-BE49-F238E27FC236}">
                <a16:creationId xmlns:a16="http://schemas.microsoft.com/office/drawing/2014/main" id="{87744102-46C8-4D76-9959-40BA8F538A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8281" y="201336"/>
            <a:ext cx="3604109" cy="3073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7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ostpartum Care over Ti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2">
            <a:extLst>
              <a:ext uri="{FF2B5EF4-FFF2-40B4-BE49-F238E27FC236}">
                <a16:creationId xmlns:a16="http://schemas.microsoft.com/office/drawing/2014/main" id="{05862281-3ED2-444C-8A65-21288CA674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9239" y="6317301"/>
            <a:ext cx="182193" cy="2708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3">
            <a:extLst>
              <a:ext uri="{FF2B5EF4-FFF2-40B4-BE49-F238E27FC236}">
                <a16:creationId xmlns:a16="http://schemas.microsoft.com/office/drawing/2014/main" id="{22190D32-A77F-4710-A5C0-AE0DA99A128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51606" y="3051224"/>
            <a:ext cx="1784446" cy="269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cility Birth(%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Freeform 24">
            <a:extLst>
              <a:ext uri="{FF2B5EF4-FFF2-40B4-BE49-F238E27FC236}">
                <a16:creationId xmlns:a16="http://schemas.microsoft.com/office/drawing/2014/main" id="{96CDB18C-3785-4CC4-A62A-D6EC80FA321C}"/>
              </a:ext>
            </a:extLst>
          </p:cNvPr>
          <p:cNvSpPr>
            <a:spLocks noEditPoints="1"/>
          </p:cNvSpPr>
          <p:nvPr/>
        </p:nvSpPr>
        <p:spPr bwMode="auto">
          <a:xfrm>
            <a:off x="7633929" y="957316"/>
            <a:ext cx="3869117" cy="460234"/>
          </a:xfrm>
          <a:custGeom>
            <a:avLst/>
            <a:gdLst>
              <a:gd name="T0" fmla="*/ 0 w 276"/>
              <a:gd name="T1" fmla="*/ 14 h 39"/>
              <a:gd name="T2" fmla="*/ 9 w 276"/>
              <a:gd name="T3" fmla="*/ 18 h 39"/>
              <a:gd name="T4" fmla="*/ 12 w 276"/>
              <a:gd name="T5" fmla="*/ 19 h 39"/>
              <a:gd name="T6" fmla="*/ 21 w 276"/>
              <a:gd name="T7" fmla="*/ 22 h 39"/>
              <a:gd name="T8" fmla="*/ 24 w 276"/>
              <a:gd name="T9" fmla="*/ 24 h 39"/>
              <a:gd name="T10" fmla="*/ 33 w 276"/>
              <a:gd name="T11" fmla="*/ 20 h 39"/>
              <a:gd name="T12" fmla="*/ 36 w 276"/>
              <a:gd name="T13" fmla="*/ 19 h 39"/>
              <a:gd name="T14" fmla="*/ 45 w 276"/>
              <a:gd name="T15" fmla="*/ 14 h 39"/>
              <a:gd name="T16" fmla="*/ 48 w 276"/>
              <a:gd name="T17" fmla="*/ 13 h 39"/>
              <a:gd name="T18" fmla="*/ 56 w 276"/>
              <a:gd name="T19" fmla="*/ 11 h 39"/>
              <a:gd name="T20" fmla="*/ 59 w 276"/>
              <a:gd name="T21" fmla="*/ 11 h 39"/>
              <a:gd name="T22" fmla="*/ 68 w 276"/>
              <a:gd name="T23" fmla="*/ 13 h 39"/>
              <a:gd name="T24" fmla="*/ 71 w 276"/>
              <a:gd name="T25" fmla="*/ 14 h 39"/>
              <a:gd name="T26" fmla="*/ 80 w 276"/>
              <a:gd name="T27" fmla="*/ 16 h 39"/>
              <a:gd name="T28" fmla="*/ 81 w 276"/>
              <a:gd name="T29" fmla="*/ 16 h 39"/>
              <a:gd name="T30" fmla="*/ 83 w 276"/>
              <a:gd name="T31" fmla="*/ 17 h 39"/>
              <a:gd name="T32" fmla="*/ 92 w 276"/>
              <a:gd name="T33" fmla="*/ 19 h 39"/>
              <a:gd name="T34" fmla="*/ 95 w 276"/>
              <a:gd name="T35" fmla="*/ 20 h 39"/>
              <a:gd name="T36" fmla="*/ 104 w 276"/>
              <a:gd name="T37" fmla="*/ 23 h 39"/>
              <a:gd name="T38" fmla="*/ 107 w 276"/>
              <a:gd name="T39" fmla="*/ 23 h 39"/>
              <a:gd name="T40" fmla="*/ 116 w 276"/>
              <a:gd name="T41" fmla="*/ 22 h 39"/>
              <a:gd name="T42" fmla="*/ 119 w 276"/>
              <a:gd name="T43" fmla="*/ 21 h 39"/>
              <a:gd name="T44" fmla="*/ 128 w 276"/>
              <a:gd name="T45" fmla="*/ 18 h 39"/>
              <a:gd name="T46" fmla="*/ 131 w 276"/>
              <a:gd name="T47" fmla="*/ 17 h 39"/>
              <a:gd name="T48" fmla="*/ 140 w 276"/>
              <a:gd name="T49" fmla="*/ 16 h 39"/>
              <a:gd name="T50" fmla="*/ 143 w 276"/>
              <a:gd name="T51" fmla="*/ 16 h 39"/>
              <a:gd name="T52" fmla="*/ 152 w 276"/>
              <a:gd name="T53" fmla="*/ 18 h 39"/>
              <a:gd name="T54" fmla="*/ 155 w 276"/>
              <a:gd name="T55" fmla="*/ 18 h 39"/>
              <a:gd name="T56" fmla="*/ 164 w 276"/>
              <a:gd name="T57" fmla="*/ 20 h 39"/>
              <a:gd name="T58" fmla="*/ 165 w 276"/>
              <a:gd name="T59" fmla="*/ 20 h 39"/>
              <a:gd name="T60" fmla="*/ 167 w 276"/>
              <a:gd name="T61" fmla="*/ 20 h 39"/>
              <a:gd name="T62" fmla="*/ 176 w 276"/>
              <a:gd name="T63" fmla="*/ 20 h 39"/>
              <a:gd name="T64" fmla="*/ 179 w 276"/>
              <a:gd name="T65" fmla="*/ 19 h 39"/>
              <a:gd name="T66" fmla="*/ 188 w 276"/>
              <a:gd name="T67" fmla="*/ 19 h 39"/>
              <a:gd name="T68" fmla="*/ 191 w 276"/>
              <a:gd name="T69" fmla="*/ 19 h 39"/>
              <a:gd name="T70" fmla="*/ 199 w 276"/>
              <a:gd name="T71" fmla="*/ 24 h 39"/>
              <a:gd name="T72" fmla="*/ 202 w 276"/>
              <a:gd name="T73" fmla="*/ 26 h 39"/>
              <a:gd name="T74" fmla="*/ 209 w 276"/>
              <a:gd name="T75" fmla="*/ 32 h 39"/>
              <a:gd name="T76" fmla="*/ 212 w 276"/>
              <a:gd name="T77" fmla="*/ 34 h 39"/>
              <a:gd name="T78" fmla="*/ 221 w 276"/>
              <a:gd name="T79" fmla="*/ 39 h 39"/>
              <a:gd name="T80" fmla="*/ 224 w 276"/>
              <a:gd name="T81" fmla="*/ 38 h 39"/>
              <a:gd name="T82" fmla="*/ 232 w 276"/>
              <a:gd name="T83" fmla="*/ 33 h 39"/>
              <a:gd name="T84" fmla="*/ 235 w 276"/>
              <a:gd name="T85" fmla="*/ 31 h 39"/>
              <a:gd name="T86" fmla="*/ 243 w 276"/>
              <a:gd name="T87" fmla="*/ 26 h 39"/>
              <a:gd name="T88" fmla="*/ 246 w 276"/>
              <a:gd name="T89" fmla="*/ 24 h 39"/>
              <a:gd name="T90" fmla="*/ 254 w 276"/>
              <a:gd name="T91" fmla="*/ 18 h 39"/>
              <a:gd name="T92" fmla="*/ 257 w 276"/>
              <a:gd name="T93" fmla="*/ 16 h 39"/>
              <a:gd name="T94" fmla="*/ 264 w 276"/>
              <a:gd name="T95" fmla="*/ 10 h 39"/>
              <a:gd name="T96" fmla="*/ 267 w 276"/>
              <a:gd name="T97" fmla="*/ 7 h 39"/>
              <a:gd name="T98" fmla="*/ 275 w 276"/>
              <a:gd name="T99" fmla="*/ 1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276" h="39">
                <a:moveTo>
                  <a:pt x="9" y="18"/>
                </a:moveTo>
                <a:lnTo>
                  <a:pt x="12" y="19"/>
                </a:lnTo>
                <a:moveTo>
                  <a:pt x="21" y="22"/>
                </a:moveTo>
                <a:lnTo>
                  <a:pt x="24" y="24"/>
                </a:lnTo>
                <a:moveTo>
                  <a:pt x="33" y="20"/>
                </a:moveTo>
                <a:lnTo>
                  <a:pt x="36" y="19"/>
                </a:lnTo>
                <a:moveTo>
                  <a:pt x="45" y="14"/>
                </a:moveTo>
                <a:lnTo>
                  <a:pt x="48" y="13"/>
                </a:lnTo>
                <a:moveTo>
                  <a:pt x="56" y="11"/>
                </a:moveTo>
                <a:lnTo>
                  <a:pt x="59" y="11"/>
                </a:lnTo>
                <a:moveTo>
                  <a:pt x="68" y="13"/>
                </a:moveTo>
                <a:lnTo>
                  <a:pt x="71" y="14"/>
                </a:lnTo>
                <a:moveTo>
                  <a:pt x="80" y="16"/>
                </a:moveTo>
                <a:lnTo>
                  <a:pt x="81" y="16"/>
                </a:lnTo>
                <a:lnTo>
                  <a:pt x="83" y="17"/>
                </a:lnTo>
                <a:moveTo>
                  <a:pt x="92" y="19"/>
                </a:moveTo>
                <a:lnTo>
                  <a:pt x="95" y="20"/>
                </a:lnTo>
                <a:moveTo>
                  <a:pt x="104" y="23"/>
                </a:moveTo>
                <a:lnTo>
                  <a:pt x="107" y="23"/>
                </a:lnTo>
                <a:moveTo>
                  <a:pt x="116" y="22"/>
                </a:moveTo>
                <a:lnTo>
                  <a:pt x="119" y="21"/>
                </a:lnTo>
                <a:moveTo>
                  <a:pt x="128" y="18"/>
                </a:moveTo>
                <a:lnTo>
                  <a:pt x="131" y="17"/>
                </a:lnTo>
                <a:moveTo>
                  <a:pt x="140" y="16"/>
                </a:moveTo>
                <a:lnTo>
                  <a:pt x="143" y="16"/>
                </a:lnTo>
                <a:moveTo>
                  <a:pt x="152" y="18"/>
                </a:moveTo>
                <a:lnTo>
                  <a:pt x="155" y="18"/>
                </a:lnTo>
                <a:moveTo>
                  <a:pt x="164" y="20"/>
                </a:moveTo>
                <a:lnTo>
                  <a:pt x="165" y="20"/>
                </a:lnTo>
                <a:lnTo>
                  <a:pt x="167" y="20"/>
                </a:lnTo>
                <a:moveTo>
                  <a:pt x="176" y="20"/>
                </a:moveTo>
                <a:lnTo>
                  <a:pt x="179" y="19"/>
                </a:lnTo>
                <a:moveTo>
                  <a:pt x="188" y="19"/>
                </a:moveTo>
                <a:lnTo>
                  <a:pt x="191" y="19"/>
                </a:lnTo>
                <a:moveTo>
                  <a:pt x="199" y="24"/>
                </a:moveTo>
                <a:lnTo>
                  <a:pt x="202" y="26"/>
                </a:lnTo>
                <a:moveTo>
                  <a:pt x="209" y="32"/>
                </a:moveTo>
                <a:lnTo>
                  <a:pt x="212" y="34"/>
                </a:lnTo>
                <a:moveTo>
                  <a:pt x="221" y="39"/>
                </a:moveTo>
                <a:lnTo>
                  <a:pt x="224" y="38"/>
                </a:lnTo>
                <a:moveTo>
                  <a:pt x="232" y="33"/>
                </a:moveTo>
                <a:lnTo>
                  <a:pt x="235" y="31"/>
                </a:lnTo>
                <a:moveTo>
                  <a:pt x="243" y="26"/>
                </a:moveTo>
                <a:lnTo>
                  <a:pt x="246" y="24"/>
                </a:lnTo>
                <a:moveTo>
                  <a:pt x="254" y="18"/>
                </a:moveTo>
                <a:lnTo>
                  <a:pt x="257" y="16"/>
                </a:lnTo>
                <a:moveTo>
                  <a:pt x="264" y="10"/>
                </a:moveTo>
                <a:lnTo>
                  <a:pt x="267" y="7"/>
                </a:lnTo>
                <a:moveTo>
                  <a:pt x="275" y="1"/>
                </a:moveTo>
              </a:path>
            </a:pathLst>
          </a:custGeom>
          <a:noFill/>
          <a:ln w="396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5" name="Rectangle 25">
            <a:extLst>
              <a:ext uri="{FF2B5EF4-FFF2-40B4-BE49-F238E27FC236}">
                <a16:creationId xmlns:a16="http://schemas.microsoft.com/office/drawing/2014/main" id="{4E66CAF9-5310-476E-B91B-2691863A7C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2356" y="1299585"/>
            <a:ext cx="41408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6" name="Rectangle 26">
            <a:extLst>
              <a:ext uri="{FF2B5EF4-FFF2-40B4-BE49-F238E27FC236}">
                <a16:creationId xmlns:a16="http://schemas.microsoft.com/office/drawing/2014/main" id="{FEEBC652-D826-47F6-858F-C15C6F51D9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2356" y="1369367"/>
            <a:ext cx="41408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7" name="Rectangle 27">
            <a:extLst>
              <a:ext uri="{FF2B5EF4-FFF2-40B4-BE49-F238E27FC236}">
                <a16:creationId xmlns:a16="http://schemas.microsoft.com/office/drawing/2014/main" id="{CE609ADD-03FE-41D6-B7BC-644DF95A38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07449" y="1311215"/>
            <a:ext cx="71221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8" name="Rectangle 28">
            <a:extLst>
              <a:ext uri="{FF2B5EF4-FFF2-40B4-BE49-F238E27FC236}">
                <a16:creationId xmlns:a16="http://schemas.microsoft.com/office/drawing/2014/main" id="{70495144-EFB3-47E9-99F9-74C079DCA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07449" y="1357737"/>
            <a:ext cx="71221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9" name="Rectangle 29">
            <a:extLst>
              <a:ext uri="{FF2B5EF4-FFF2-40B4-BE49-F238E27FC236}">
                <a16:creationId xmlns:a16="http://schemas.microsoft.com/office/drawing/2014/main" id="{E458E156-4E63-414F-89B2-C67D094244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4199" y="1322846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0" name="Rectangle 30">
            <a:extLst>
              <a:ext uri="{FF2B5EF4-FFF2-40B4-BE49-F238E27FC236}">
                <a16:creationId xmlns:a16="http://schemas.microsoft.com/office/drawing/2014/main" id="{27451338-1F4B-4880-ABA0-F9DC159D88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4199" y="1346106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1" name="Rectangle 31">
            <a:extLst>
              <a:ext uri="{FF2B5EF4-FFF2-40B4-BE49-F238E27FC236}">
                <a16:creationId xmlns:a16="http://schemas.microsoft.com/office/drawing/2014/main" id="{CC6D7092-E440-4B62-9F70-787F6D3A94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4199" y="1334476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2" name="Rectangle 32">
            <a:extLst>
              <a:ext uri="{FF2B5EF4-FFF2-40B4-BE49-F238E27FC236}">
                <a16:creationId xmlns:a16="http://schemas.microsoft.com/office/drawing/2014/main" id="{646BC730-3AAD-4F6D-9F7B-A4FF7C1BF4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4199" y="1334476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3" name="Rectangle 33">
            <a:extLst>
              <a:ext uri="{FF2B5EF4-FFF2-40B4-BE49-F238E27FC236}">
                <a16:creationId xmlns:a16="http://schemas.microsoft.com/office/drawing/2014/main" id="{6EC73F36-0477-4F5E-90E5-5238EE0F3B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77615" y="1075283"/>
            <a:ext cx="41408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4" name="Rectangle 34">
            <a:extLst>
              <a:ext uri="{FF2B5EF4-FFF2-40B4-BE49-F238E27FC236}">
                <a16:creationId xmlns:a16="http://schemas.microsoft.com/office/drawing/2014/main" id="{343521D7-BB38-4D72-B478-13643DA959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77615" y="1145065"/>
            <a:ext cx="41408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5" name="Rectangle 35">
            <a:extLst>
              <a:ext uri="{FF2B5EF4-FFF2-40B4-BE49-F238E27FC236}">
                <a16:creationId xmlns:a16="http://schemas.microsoft.com/office/drawing/2014/main" id="{DF084B5A-01E2-4353-A971-66C23B72D6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4364" y="1086913"/>
            <a:ext cx="69565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6" name="Rectangle 36">
            <a:extLst>
              <a:ext uri="{FF2B5EF4-FFF2-40B4-BE49-F238E27FC236}">
                <a16:creationId xmlns:a16="http://schemas.microsoft.com/office/drawing/2014/main" id="{92B34BF8-E360-483D-ABE6-3EAFDE0702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4364" y="1133435"/>
            <a:ext cx="69565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7" name="Rectangle 37">
            <a:extLst>
              <a:ext uri="{FF2B5EF4-FFF2-40B4-BE49-F238E27FC236}">
                <a16:creationId xmlns:a16="http://schemas.microsoft.com/office/drawing/2014/main" id="{5B0F462A-0A38-4299-AB6F-3FFC727231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458" y="1098544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8" name="Rectangle 38">
            <a:extLst>
              <a:ext uri="{FF2B5EF4-FFF2-40B4-BE49-F238E27FC236}">
                <a16:creationId xmlns:a16="http://schemas.microsoft.com/office/drawing/2014/main" id="{7436C19F-77C1-4DA6-9C81-027D7CA56B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458" y="1121805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9" name="Rectangle 39">
            <a:extLst>
              <a:ext uri="{FF2B5EF4-FFF2-40B4-BE49-F238E27FC236}">
                <a16:creationId xmlns:a16="http://schemas.microsoft.com/office/drawing/2014/main" id="{F32709C4-EF82-485A-9020-E380B82D44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458" y="1110174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0" name="Rectangle 40">
            <a:extLst>
              <a:ext uri="{FF2B5EF4-FFF2-40B4-BE49-F238E27FC236}">
                <a16:creationId xmlns:a16="http://schemas.microsoft.com/office/drawing/2014/main" id="{E2388C4C-C7EB-49AB-BFEC-B3E53C643B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458" y="1110174"/>
            <a:ext cx="97722" cy="11630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1" name="Freeform 41">
            <a:extLst>
              <a:ext uri="{FF2B5EF4-FFF2-40B4-BE49-F238E27FC236}">
                <a16:creationId xmlns:a16="http://schemas.microsoft.com/office/drawing/2014/main" id="{3433ECF3-C91F-4CE4-88D0-552908893CDA}"/>
              </a:ext>
            </a:extLst>
          </p:cNvPr>
          <p:cNvSpPr>
            <a:spLocks/>
          </p:cNvSpPr>
          <p:nvPr/>
        </p:nvSpPr>
        <p:spPr bwMode="auto">
          <a:xfrm>
            <a:off x="1715969" y="957316"/>
            <a:ext cx="5482353" cy="2229727"/>
          </a:xfrm>
          <a:custGeom>
            <a:avLst/>
            <a:gdLst>
              <a:gd name="T0" fmla="*/ 0 w 391"/>
              <a:gd name="T1" fmla="*/ 54 h 189"/>
              <a:gd name="T2" fmla="*/ 28 w 391"/>
              <a:gd name="T3" fmla="*/ 103 h 189"/>
              <a:gd name="T4" fmla="*/ 56 w 391"/>
              <a:gd name="T5" fmla="*/ 189 h 189"/>
              <a:gd name="T6" fmla="*/ 84 w 391"/>
              <a:gd name="T7" fmla="*/ 189 h 189"/>
              <a:gd name="T8" fmla="*/ 112 w 391"/>
              <a:gd name="T9" fmla="*/ 54 h 189"/>
              <a:gd name="T10" fmla="*/ 140 w 391"/>
              <a:gd name="T11" fmla="*/ 138 h 189"/>
              <a:gd name="T12" fmla="*/ 168 w 391"/>
              <a:gd name="T13" fmla="*/ 81 h 189"/>
              <a:gd name="T14" fmla="*/ 196 w 391"/>
              <a:gd name="T15" fmla="*/ 32 h 189"/>
              <a:gd name="T16" fmla="*/ 224 w 391"/>
              <a:gd name="T17" fmla="*/ 95 h 189"/>
              <a:gd name="T18" fmla="*/ 251 w 391"/>
              <a:gd name="T19" fmla="*/ 23 h 189"/>
              <a:gd name="T20" fmla="*/ 279 w 391"/>
              <a:gd name="T21" fmla="*/ 131 h 189"/>
              <a:gd name="T22" fmla="*/ 307 w 391"/>
              <a:gd name="T23" fmla="*/ 32 h 189"/>
              <a:gd name="T24" fmla="*/ 335 w 391"/>
              <a:gd name="T25" fmla="*/ 0 h 189"/>
              <a:gd name="T26" fmla="*/ 363 w 391"/>
              <a:gd name="T27" fmla="*/ 23 h 189"/>
              <a:gd name="T28" fmla="*/ 391 w 391"/>
              <a:gd name="T29" fmla="*/ 18 h 1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91" h="189">
                <a:moveTo>
                  <a:pt x="0" y="54"/>
                </a:moveTo>
                <a:lnTo>
                  <a:pt x="28" y="103"/>
                </a:lnTo>
                <a:lnTo>
                  <a:pt x="56" y="189"/>
                </a:lnTo>
                <a:lnTo>
                  <a:pt x="84" y="189"/>
                </a:lnTo>
                <a:lnTo>
                  <a:pt x="112" y="54"/>
                </a:lnTo>
                <a:lnTo>
                  <a:pt x="140" y="138"/>
                </a:lnTo>
                <a:lnTo>
                  <a:pt x="168" y="81"/>
                </a:lnTo>
                <a:lnTo>
                  <a:pt x="196" y="32"/>
                </a:lnTo>
                <a:lnTo>
                  <a:pt x="224" y="95"/>
                </a:lnTo>
                <a:lnTo>
                  <a:pt x="251" y="23"/>
                </a:lnTo>
                <a:lnTo>
                  <a:pt x="279" y="131"/>
                </a:lnTo>
                <a:lnTo>
                  <a:pt x="307" y="32"/>
                </a:lnTo>
                <a:lnTo>
                  <a:pt x="335" y="0"/>
                </a:lnTo>
                <a:lnTo>
                  <a:pt x="363" y="23"/>
                </a:lnTo>
                <a:lnTo>
                  <a:pt x="391" y="18"/>
                </a:lnTo>
              </a:path>
            </a:pathLst>
          </a:custGeom>
          <a:noFill/>
          <a:ln w="396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2" name="Freeform 42">
            <a:extLst>
              <a:ext uri="{FF2B5EF4-FFF2-40B4-BE49-F238E27FC236}">
                <a16:creationId xmlns:a16="http://schemas.microsoft.com/office/drawing/2014/main" id="{D06320C5-15E7-43CA-8A0F-AF4B168315A4}"/>
              </a:ext>
            </a:extLst>
          </p:cNvPr>
          <p:cNvSpPr>
            <a:spLocks noEditPoints="1"/>
          </p:cNvSpPr>
          <p:nvPr/>
        </p:nvSpPr>
        <p:spPr bwMode="auto">
          <a:xfrm>
            <a:off x="9596644" y="1193249"/>
            <a:ext cx="1906401" cy="152858"/>
          </a:xfrm>
          <a:custGeom>
            <a:avLst/>
            <a:gdLst>
              <a:gd name="T0" fmla="*/ 0 w 136"/>
              <a:gd name="T1" fmla="*/ 12 h 13"/>
              <a:gd name="T2" fmla="*/ 9 w 136"/>
              <a:gd name="T3" fmla="*/ 8 h 13"/>
              <a:gd name="T4" fmla="*/ 12 w 136"/>
              <a:gd name="T5" fmla="*/ 6 h 13"/>
              <a:gd name="T6" fmla="*/ 21 w 136"/>
              <a:gd name="T7" fmla="*/ 1 h 13"/>
              <a:gd name="T8" fmla="*/ 24 w 136"/>
              <a:gd name="T9" fmla="*/ 0 h 13"/>
              <a:gd name="T10" fmla="*/ 33 w 136"/>
              <a:gd name="T11" fmla="*/ 2 h 13"/>
              <a:gd name="T12" fmla="*/ 36 w 136"/>
              <a:gd name="T13" fmla="*/ 3 h 13"/>
              <a:gd name="T14" fmla="*/ 45 w 136"/>
              <a:gd name="T15" fmla="*/ 6 h 13"/>
              <a:gd name="T16" fmla="*/ 48 w 136"/>
              <a:gd name="T17" fmla="*/ 7 h 13"/>
              <a:gd name="T18" fmla="*/ 57 w 136"/>
              <a:gd name="T19" fmla="*/ 7 h 13"/>
              <a:gd name="T20" fmla="*/ 60 w 136"/>
              <a:gd name="T21" fmla="*/ 6 h 13"/>
              <a:gd name="T22" fmla="*/ 69 w 136"/>
              <a:gd name="T23" fmla="*/ 4 h 13"/>
              <a:gd name="T24" fmla="*/ 72 w 136"/>
              <a:gd name="T25" fmla="*/ 4 h 13"/>
              <a:gd name="T26" fmla="*/ 80 w 136"/>
              <a:gd name="T27" fmla="*/ 2 h 13"/>
              <a:gd name="T28" fmla="*/ 83 w 136"/>
              <a:gd name="T29" fmla="*/ 3 h 13"/>
              <a:gd name="T30" fmla="*/ 92 w 136"/>
              <a:gd name="T31" fmla="*/ 7 h 13"/>
              <a:gd name="T32" fmla="*/ 95 w 136"/>
              <a:gd name="T33" fmla="*/ 8 h 13"/>
              <a:gd name="T34" fmla="*/ 104 w 136"/>
              <a:gd name="T35" fmla="*/ 11 h 13"/>
              <a:gd name="T36" fmla="*/ 107 w 136"/>
              <a:gd name="T37" fmla="*/ 13 h 13"/>
              <a:gd name="T38" fmla="*/ 116 w 136"/>
              <a:gd name="T39" fmla="*/ 11 h 13"/>
              <a:gd name="T40" fmla="*/ 119 w 136"/>
              <a:gd name="T41" fmla="*/ 11 h 13"/>
              <a:gd name="T42" fmla="*/ 128 w 136"/>
              <a:gd name="T43" fmla="*/ 9 h 13"/>
              <a:gd name="T44" fmla="*/ 131 w 136"/>
              <a:gd name="T45" fmla="*/ 8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>
              <a:path w="136" h="13">
                <a:moveTo>
                  <a:pt x="9" y="8"/>
                </a:moveTo>
                <a:lnTo>
                  <a:pt x="12" y="6"/>
                </a:lnTo>
                <a:moveTo>
                  <a:pt x="21" y="1"/>
                </a:moveTo>
                <a:lnTo>
                  <a:pt x="24" y="0"/>
                </a:lnTo>
                <a:moveTo>
                  <a:pt x="33" y="2"/>
                </a:moveTo>
                <a:lnTo>
                  <a:pt x="36" y="3"/>
                </a:lnTo>
                <a:moveTo>
                  <a:pt x="45" y="6"/>
                </a:moveTo>
                <a:lnTo>
                  <a:pt x="48" y="7"/>
                </a:lnTo>
                <a:moveTo>
                  <a:pt x="57" y="7"/>
                </a:moveTo>
                <a:lnTo>
                  <a:pt x="60" y="6"/>
                </a:lnTo>
                <a:moveTo>
                  <a:pt x="69" y="4"/>
                </a:moveTo>
                <a:lnTo>
                  <a:pt x="72" y="4"/>
                </a:lnTo>
                <a:moveTo>
                  <a:pt x="80" y="2"/>
                </a:moveTo>
                <a:lnTo>
                  <a:pt x="83" y="3"/>
                </a:lnTo>
                <a:moveTo>
                  <a:pt x="92" y="7"/>
                </a:moveTo>
                <a:lnTo>
                  <a:pt x="95" y="8"/>
                </a:lnTo>
                <a:moveTo>
                  <a:pt x="104" y="11"/>
                </a:moveTo>
                <a:lnTo>
                  <a:pt x="107" y="13"/>
                </a:lnTo>
                <a:moveTo>
                  <a:pt x="116" y="11"/>
                </a:moveTo>
                <a:lnTo>
                  <a:pt x="119" y="11"/>
                </a:lnTo>
                <a:moveTo>
                  <a:pt x="128" y="9"/>
                </a:moveTo>
                <a:lnTo>
                  <a:pt x="131" y="8"/>
                </a:lnTo>
              </a:path>
            </a:pathLst>
          </a:custGeom>
          <a:noFill/>
          <a:ln w="396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3" name="Rectangle 43">
            <a:extLst>
              <a:ext uri="{FF2B5EF4-FFF2-40B4-BE49-F238E27FC236}">
                <a16:creationId xmlns:a16="http://schemas.microsoft.com/office/drawing/2014/main" id="{D029F3D9-5EB4-4A5B-AC9B-8FA06EEF79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5072" y="1133435"/>
            <a:ext cx="41408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4" name="Rectangle 44">
            <a:extLst>
              <a:ext uri="{FF2B5EF4-FFF2-40B4-BE49-F238E27FC236}">
                <a16:creationId xmlns:a16="http://schemas.microsoft.com/office/drawing/2014/main" id="{CA1799F4-F696-4567-9815-C3ED132BB5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85072" y="1204879"/>
            <a:ext cx="41408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5" name="Rectangle 45">
            <a:extLst>
              <a:ext uri="{FF2B5EF4-FFF2-40B4-BE49-F238E27FC236}">
                <a16:creationId xmlns:a16="http://schemas.microsoft.com/office/drawing/2014/main" id="{EAC8ECCF-542C-4BA9-A0C9-8802900247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70165" y="1145065"/>
            <a:ext cx="71221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6" name="Rectangle 46">
            <a:extLst>
              <a:ext uri="{FF2B5EF4-FFF2-40B4-BE49-F238E27FC236}">
                <a16:creationId xmlns:a16="http://schemas.microsoft.com/office/drawing/2014/main" id="{DA395149-9758-42F9-85D3-2BC5BE4191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70165" y="1193249"/>
            <a:ext cx="71221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7" name="Rectangle 47">
            <a:extLst>
              <a:ext uri="{FF2B5EF4-FFF2-40B4-BE49-F238E27FC236}">
                <a16:creationId xmlns:a16="http://schemas.microsoft.com/office/drawing/2014/main" id="{794AC799-18EE-4537-A420-436159641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6914" y="1156696"/>
            <a:ext cx="97722" cy="13292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8" name="Rectangle 48">
            <a:extLst>
              <a:ext uri="{FF2B5EF4-FFF2-40B4-BE49-F238E27FC236}">
                <a16:creationId xmlns:a16="http://schemas.microsoft.com/office/drawing/2014/main" id="{308FE035-495A-4688-8CD5-2BA6EA4DC0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6914" y="1181618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9" name="Rectangle 49">
            <a:extLst>
              <a:ext uri="{FF2B5EF4-FFF2-40B4-BE49-F238E27FC236}">
                <a16:creationId xmlns:a16="http://schemas.microsoft.com/office/drawing/2014/main" id="{35DFF225-2CA0-4E07-AF59-67519F7033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6914" y="1169988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0" name="Rectangle 50">
            <a:extLst>
              <a:ext uri="{FF2B5EF4-FFF2-40B4-BE49-F238E27FC236}">
                <a16:creationId xmlns:a16="http://schemas.microsoft.com/office/drawing/2014/main" id="{4D122056-5F5D-42D2-B129-C73CECDAA0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6914" y="1169988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1" name="Rectangle 51">
            <a:extLst>
              <a:ext uri="{FF2B5EF4-FFF2-40B4-BE49-F238E27FC236}">
                <a16:creationId xmlns:a16="http://schemas.microsoft.com/office/drawing/2014/main" id="{DF5D834A-0EED-44F4-948E-D7DA15E3FA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40330" y="1322846"/>
            <a:ext cx="43064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2" name="Rectangle 52">
            <a:extLst>
              <a:ext uri="{FF2B5EF4-FFF2-40B4-BE49-F238E27FC236}">
                <a16:creationId xmlns:a16="http://schemas.microsoft.com/office/drawing/2014/main" id="{97214211-BC36-4A1B-8FEC-9E51379452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40330" y="1394290"/>
            <a:ext cx="43064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3" name="Rectangle 53">
            <a:extLst>
              <a:ext uri="{FF2B5EF4-FFF2-40B4-BE49-F238E27FC236}">
                <a16:creationId xmlns:a16="http://schemas.microsoft.com/office/drawing/2014/main" id="{1204AF01-810E-4441-9966-AED76F4EA9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7080" y="1334476"/>
            <a:ext cx="69565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4" name="Rectangle 54">
            <a:extLst>
              <a:ext uri="{FF2B5EF4-FFF2-40B4-BE49-F238E27FC236}">
                <a16:creationId xmlns:a16="http://schemas.microsoft.com/office/drawing/2014/main" id="{36C20816-00A3-4F23-8A7A-1019941171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7080" y="1380998"/>
            <a:ext cx="69565" cy="13292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5" name="Rectangle 55">
            <a:extLst>
              <a:ext uri="{FF2B5EF4-FFF2-40B4-BE49-F238E27FC236}">
                <a16:creationId xmlns:a16="http://schemas.microsoft.com/office/drawing/2014/main" id="{66270DBD-15B9-459B-B90A-64EB95303F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2173" y="1346106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6" name="Rectangle 56">
            <a:extLst>
              <a:ext uri="{FF2B5EF4-FFF2-40B4-BE49-F238E27FC236}">
                <a16:creationId xmlns:a16="http://schemas.microsoft.com/office/drawing/2014/main" id="{89183104-8958-4FE0-9C29-8A3425D00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2173" y="1369367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7" name="Rectangle 57">
            <a:extLst>
              <a:ext uri="{FF2B5EF4-FFF2-40B4-BE49-F238E27FC236}">
                <a16:creationId xmlns:a16="http://schemas.microsoft.com/office/drawing/2014/main" id="{A29B003D-A2BF-416C-98A4-8F3CED6ECA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2173" y="1357737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8" name="Rectangle 58">
            <a:extLst>
              <a:ext uri="{FF2B5EF4-FFF2-40B4-BE49-F238E27FC236}">
                <a16:creationId xmlns:a16="http://schemas.microsoft.com/office/drawing/2014/main" id="{2EB8A1D1-3631-4CAD-A980-5B906C07CF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12173" y="1357737"/>
            <a:ext cx="97722" cy="11630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9" name="Freeform 59">
            <a:extLst>
              <a:ext uri="{FF2B5EF4-FFF2-40B4-BE49-F238E27FC236}">
                <a16:creationId xmlns:a16="http://schemas.microsoft.com/office/drawing/2014/main" id="{71215123-27CB-44E9-9B0A-93AB81CA2614}"/>
              </a:ext>
            </a:extLst>
          </p:cNvPr>
          <p:cNvSpPr>
            <a:spLocks/>
          </p:cNvSpPr>
          <p:nvPr/>
        </p:nvSpPr>
        <p:spPr bwMode="auto">
          <a:xfrm>
            <a:off x="1715969" y="1015469"/>
            <a:ext cx="2356915" cy="353899"/>
          </a:xfrm>
          <a:custGeom>
            <a:avLst/>
            <a:gdLst>
              <a:gd name="T0" fmla="*/ 0 w 168"/>
              <a:gd name="T1" fmla="*/ 17 h 30"/>
              <a:gd name="T2" fmla="*/ 28 w 168"/>
              <a:gd name="T3" fmla="*/ 30 h 30"/>
              <a:gd name="T4" fmla="*/ 56 w 168"/>
              <a:gd name="T5" fmla="*/ 17 h 30"/>
              <a:gd name="T6" fmla="*/ 84 w 168"/>
              <a:gd name="T7" fmla="*/ 10 h 30"/>
              <a:gd name="T8" fmla="*/ 112 w 168"/>
              <a:gd name="T9" fmla="*/ 11 h 30"/>
              <a:gd name="T10" fmla="*/ 140 w 168"/>
              <a:gd name="T11" fmla="*/ 0 h 30"/>
              <a:gd name="T12" fmla="*/ 168 w 168"/>
              <a:gd name="T13" fmla="*/ 3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8" h="30">
                <a:moveTo>
                  <a:pt x="0" y="17"/>
                </a:moveTo>
                <a:lnTo>
                  <a:pt x="28" y="30"/>
                </a:lnTo>
                <a:lnTo>
                  <a:pt x="56" y="17"/>
                </a:lnTo>
                <a:lnTo>
                  <a:pt x="84" y="10"/>
                </a:lnTo>
                <a:lnTo>
                  <a:pt x="112" y="11"/>
                </a:lnTo>
                <a:lnTo>
                  <a:pt x="140" y="0"/>
                </a:lnTo>
                <a:lnTo>
                  <a:pt x="168" y="3"/>
                </a:lnTo>
              </a:path>
            </a:pathLst>
          </a:custGeom>
          <a:noFill/>
          <a:ln w="396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0" name="Freeform 60">
            <a:extLst>
              <a:ext uri="{FF2B5EF4-FFF2-40B4-BE49-F238E27FC236}">
                <a16:creationId xmlns:a16="http://schemas.microsoft.com/office/drawing/2014/main" id="{AE62C023-A443-4C99-A0E7-7AD9A2C331AE}"/>
              </a:ext>
            </a:extLst>
          </p:cNvPr>
          <p:cNvSpPr>
            <a:spLocks noEditPoints="1"/>
          </p:cNvSpPr>
          <p:nvPr/>
        </p:nvSpPr>
        <p:spPr bwMode="auto">
          <a:xfrm>
            <a:off x="6456300" y="980577"/>
            <a:ext cx="5046746" cy="58152"/>
          </a:xfrm>
          <a:custGeom>
            <a:avLst/>
            <a:gdLst>
              <a:gd name="T0" fmla="*/ 0 w 360"/>
              <a:gd name="T1" fmla="*/ 0 h 5"/>
              <a:gd name="T2" fmla="*/ 9 w 360"/>
              <a:gd name="T3" fmla="*/ 1 h 5"/>
              <a:gd name="T4" fmla="*/ 12 w 360"/>
              <a:gd name="T5" fmla="*/ 2 h 5"/>
              <a:gd name="T6" fmla="*/ 21 w 360"/>
              <a:gd name="T7" fmla="*/ 3 h 5"/>
              <a:gd name="T8" fmla="*/ 24 w 360"/>
              <a:gd name="T9" fmla="*/ 3 h 5"/>
              <a:gd name="T10" fmla="*/ 33 w 360"/>
              <a:gd name="T11" fmla="*/ 4 h 5"/>
              <a:gd name="T12" fmla="*/ 36 w 360"/>
              <a:gd name="T13" fmla="*/ 4 h 5"/>
              <a:gd name="T14" fmla="*/ 45 w 360"/>
              <a:gd name="T15" fmla="*/ 4 h 5"/>
              <a:gd name="T16" fmla="*/ 48 w 360"/>
              <a:gd name="T17" fmla="*/ 5 h 5"/>
              <a:gd name="T18" fmla="*/ 57 w 360"/>
              <a:gd name="T19" fmla="*/ 5 h 5"/>
              <a:gd name="T20" fmla="*/ 60 w 360"/>
              <a:gd name="T21" fmla="*/ 4 h 5"/>
              <a:gd name="T22" fmla="*/ 69 w 360"/>
              <a:gd name="T23" fmla="*/ 3 h 5"/>
              <a:gd name="T24" fmla="*/ 72 w 360"/>
              <a:gd name="T25" fmla="*/ 3 h 5"/>
              <a:gd name="T26" fmla="*/ 81 w 360"/>
              <a:gd name="T27" fmla="*/ 2 h 5"/>
              <a:gd name="T28" fmla="*/ 84 w 360"/>
              <a:gd name="T29" fmla="*/ 2 h 5"/>
              <a:gd name="T30" fmla="*/ 93 w 360"/>
              <a:gd name="T31" fmla="*/ 2 h 5"/>
              <a:gd name="T32" fmla="*/ 96 w 360"/>
              <a:gd name="T33" fmla="*/ 3 h 5"/>
              <a:gd name="T34" fmla="*/ 105 w 360"/>
              <a:gd name="T35" fmla="*/ 3 h 5"/>
              <a:gd name="T36" fmla="*/ 108 w 360"/>
              <a:gd name="T37" fmla="*/ 3 h 5"/>
              <a:gd name="T38" fmla="*/ 117 w 360"/>
              <a:gd name="T39" fmla="*/ 3 h 5"/>
              <a:gd name="T40" fmla="*/ 120 w 360"/>
              <a:gd name="T41" fmla="*/ 3 h 5"/>
              <a:gd name="T42" fmla="*/ 129 w 360"/>
              <a:gd name="T43" fmla="*/ 4 h 5"/>
              <a:gd name="T44" fmla="*/ 132 w 360"/>
              <a:gd name="T45" fmla="*/ 4 h 5"/>
              <a:gd name="T46" fmla="*/ 141 w 360"/>
              <a:gd name="T47" fmla="*/ 4 h 5"/>
              <a:gd name="T48" fmla="*/ 144 w 360"/>
              <a:gd name="T49" fmla="*/ 4 h 5"/>
              <a:gd name="T50" fmla="*/ 153 w 360"/>
              <a:gd name="T51" fmla="*/ 3 h 5"/>
              <a:gd name="T52" fmla="*/ 156 w 360"/>
              <a:gd name="T53" fmla="*/ 3 h 5"/>
              <a:gd name="T54" fmla="*/ 165 w 360"/>
              <a:gd name="T55" fmla="*/ 2 h 5"/>
              <a:gd name="T56" fmla="*/ 168 w 360"/>
              <a:gd name="T57" fmla="*/ 2 h 5"/>
              <a:gd name="T58" fmla="*/ 177 w 360"/>
              <a:gd name="T59" fmla="*/ 2 h 5"/>
              <a:gd name="T60" fmla="*/ 180 w 360"/>
              <a:gd name="T61" fmla="*/ 3 h 5"/>
              <a:gd name="T62" fmla="*/ 189 w 360"/>
              <a:gd name="T63" fmla="*/ 3 h 5"/>
              <a:gd name="T64" fmla="*/ 192 w 360"/>
              <a:gd name="T65" fmla="*/ 3 h 5"/>
              <a:gd name="T66" fmla="*/ 201 w 360"/>
              <a:gd name="T67" fmla="*/ 4 h 5"/>
              <a:gd name="T68" fmla="*/ 204 w 360"/>
              <a:gd name="T69" fmla="*/ 4 h 5"/>
              <a:gd name="T70" fmla="*/ 213 w 360"/>
              <a:gd name="T71" fmla="*/ 5 h 5"/>
              <a:gd name="T72" fmla="*/ 216 w 360"/>
              <a:gd name="T73" fmla="*/ 5 h 5"/>
              <a:gd name="T74" fmla="*/ 225 w 360"/>
              <a:gd name="T75" fmla="*/ 5 h 5"/>
              <a:gd name="T76" fmla="*/ 228 w 360"/>
              <a:gd name="T77" fmla="*/ 5 h 5"/>
              <a:gd name="T78" fmla="*/ 237 w 360"/>
              <a:gd name="T79" fmla="*/ 3 h 5"/>
              <a:gd name="T80" fmla="*/ 240 w 360"/>
              <a:gd name="T81" fmla="*/ 2 h 5"/>
              <a:gd name="T82" fmla="*/ 249 w 360"/>
              <a:gd name="T83" fmla="*/ 0 h 5"/>
              <a:gd name="T84" fmla="*/ 252 w 360"/>
              <a:gd name="T85" fmla="*/ 0 h 5"/>
              <a:gd name="T86" fmla="*/ 261 w 360"/>
              <a:gd name="T87" fmla="*/ 2 h 5"/>
              <a:gd name="T88" fmla="*/ 264 w 360"/>
              <a:gd name="T89" fmla="*/ 2 h 5"/>
              <a:gd name="T90" fmla="*/ 273 w 360"/>
              <a:gd name="T91" fmla="*/ 4 h 5"/>
              <a:gd name="T92" fmla="*/ 276 w 360"/>
              <a:gd name="T93" fmla="*/ 4 h 5"/>
              <a:gd name="T94" fmla="*/ 276 w 360"/>
              <a:gd name="T95" fmla="*/ 4 h 5"/>
              <a:gd name="T96" fmla="*/ 285 w 360"/>
              <a:gd name="T97" fmla="*/ 3 h 5"/>
              <a:gd name="T98" fmla="*/ 288 w 360"/>
              <a:gd name="T99" fmla="*/ 3 h 5"/>
              <a:gd name="T100" fmla="*/ 297 w 360"/>
              <a:gd name="T101" fmla="*/ 2 h 5"/>
              <a:gd name="T102" fmla="*/ 300 w 360"/>
              <a:gd name="T103" fmla="*/ 1 h 5"/>
              <a:gd name="T104" fmla="*/ 309 w 360"/>
              <a:gd name="T105" fmla="*/ 2 h 5"/>
              <a:gd name="T106" fmla="*/ 312 w 360"/>
              <a:gd name="T107" fmla="*/ 2 h 5"/>
              <a:gd name="T108" fmla="*/ 321 w 360"/>
              <a:gd name="T109" fmla="*/ 3 h 5"/>
              <a:gd name="T110" fmla="*/ 324 w 360"/>
              <a:gd name="T111" fmla="*/ 3 h 5"/>
              <a:gd name="T112" fmla="*/ 332 w 360"/>
              <a:gd name="T113" fmla="*/ 4 h 5"/>
              <a:gd name="T114" fmla="*/ 335 w 360"/>
              <a:gd name="T115" fmla="*/ 4 h 5"/>
              <a:gd name="T116" fmla="*/ 344 w 360"/>
              <a:gd name="T117" fmla="*/ 4 h 5"/>
              <a:gd name="T118" fmla="*/ 347 w 360"/>
              <a:gd name="T119" fmla="*/ 4 h 5"/>
              <a:gd name="T120" fmla="*/ 356 w 360"/>
              <a:gd name="T121" fmla="*/ 4 h 5"/>
              <a:gd name="T122" fmla="*/ 359 w 360"/>
              <a:gd name="T123" fmla="*/ 4 h 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360" h="5">
                <a:moveTo>
                  <a:pt x="9" y="1"/>
                </a:moveTo>
                <a:lnTo>
                  <a:pt x="12" y="2"/>
                </a:lnTo>
                <a:moveTo>
                  <a:pt x="21" y="3"/>
                </a:moveTo>
                <a:lnTo>
                  <a:pt x="24" y="3"/>
                </a:lnTo>
                <a:moveTo>
                  <a:pt x="33" y="4"/>
                </a:moveTo>
                <a:lnTo>
                  <a:pt x="36" y="4"/>
                </a:lnTo>
                <a:moveTo>
                  <a:pt x="45" y="4"/>
                </a:moveTo>
                <a:lnTo>
                  <a:pt x="48" y="5"/>
                </a:lnTo>
                <a:moveTo>
                  <a:pt x="57" y="5"/>
                </a:moveTo>
                <a:lnTo>
                  <a:pt x="60" y="4"/>
                </a:lnTo>
                <a:moveTo>
                  <a:pt x="69" y="3"/>
                </a:moveTo>
                <a:lnTo>
                  <a:pt x="72" y="3"/>
                </a:lnTo>
                <a:moveTo>
                  <a:pt x="81" y="2"/>
                </a:moveTo>
                <a:lnTo>
                  <a:pt x="84" y="2"/>
                </a:lnTo>
                <a:moveTo>
                  <a:pt x="93" y="2"/>
                </a:moveTo>
                <a:lnTo>
                  <a:pt x="96" y="3"/>
                </a:lnTo>
                <a:moveTo>
                  <a:pt x="105" y="3"/>
                </a:moveTo>
                <a:lnTo>
                  <a:pt x="108" y="3"/>
                </a:lnTo>
                <a:moveTo>
                  <a:pt x="117" y="3"/>
                </a:moveTo>
                <a:lnTo>
                  <a:pt x="120" y="3"/>
                </a:lnTo>
                <a:moveTo>
                  <a:pt x="129" y="4"/>
                </a:moveTo>
                <a:lnTo>
                  <a:pt x="132" y="4"/>
                </a:lnTo>
                <a:moveTo>
                  <a:pt x="141" y="4"/>
                </a:moveTo>
                <a:lnTo>
                  <a:pt x="144" y="4"/>
                </a:lnTo>
                <a:moveTo>
                  <a:pt x="153" y="3"/>
                </a:moveTo>
                <a:lnTo>
                  <a:pt x="156" y="3"/>
                </a:lnTo>
                <a:moveTo>
                  <a:pt x="165" y="2"/>
                </a:moveTo>
                <a:lnTo>
                  <a:pt x="168" y="2"/>
                </a:lnTo>
                <a:moveTo>
                  <a:pt x="177" y="2"/>
                </a:moveTo>
                <a:lnTo>
                  <a:pt x="180" y="3"/>
                </a:lnTo>
                <a:moveTo>
                  <a:pt x="189" y="3"/>
                </a:moveTo>
                <a:lnTo>
                  <a:pt x="192" y="3"/>
                </a:lnTo>
                <a:moveTo>
                  <a:pt x="201" y="4"/>
                </a:moveTo>
                <a:lnTo>
                  <a:pt x="204" y="4"/>
                </a:lnTo>
                <a:moveTo>
                  <a:pt x="213" y="5"/>
                </a:moveTo>
                <a:lnTo>
                  <a:pt x="216" y="5"/>
                </a:lnTo>
                <a:moveTo>
                  <a:pt x="225" y="5"/>
                </a:moveTo>
                <a:lnTo>
                  <a:pt x="228" y="5"/>
                </a:lnTo>
                <a:moveTo>
                  <a:pt x="237" y="3"/>
                </a:moveTo>
                <a:lnTo>
                  <a:pt x="240" y="2"/>
                </a:lnTo>
                <a:moveTo>
                  <a:pt x="249" y="0"/>
                </a:moveTo>
                <a:lnTo>
                  <a:pt x="252" y="0"/>
                </a:lnTo>
                <a:moveTo>
                  <a:pt x="261" y="2"/>
                </a:moveTo>
                <a:lnTo>
                  <a:pt x="264" y="2"/>
                </a:lnTo>
                <a:moveTo>
                  <a:pt x="273" y="4"/>
                </a:moveTo>
                <a:lnTo>
                  <a:pt x="276" y="4"/>
                </a:lnTo>
                <a:lnTo>
                  <a:pt x="276" y="4"/>
                </a:lnTo>
                <a:moveTo>
                  <a:pt x="285" y="3"/>
                </a:moveTo>
                <a:lnTo>
                  <a:pt x="288" y="3"/>
                </a:lnTo>
                <a:moveTo>
                  <a:pt x="297" y="2"/>
                </a:moveTo>
                <a:lnTo>
                  <a:pt x="300" y="1"/>
                </a:lnTo>
                <a:moveTo>
                  <a:pt x="309" y="2"/>
                </a:moveTo>
                <a:lnTo>
                  <a:pt x="312" y="2"/>
                </a:lnTo>
                <a:moveTo>
                  <a:pt x="321" y="3"/>
                </a:moveTo>
                <a:lnTo>
                  <a:pt x="324" y="3"/>
                </a:lnTo>
                <a:moveTo>
                  <a:pt x="332" y="4"/>
                </a:moveTo>
                <a:lnTo>
                  <a:pt x="335" y="4"/>
                </a:lnTo>
                <a:moveTo>
                  <a:pt x="344" y="4"/>
                </a:moveTo>
                <a:lnTo>
                  <a:pt x="347" y="4"/>
                </a:lnTo>
                <a:moveTo>
                  <a:pt x="356" y="4"/>
                </a:moveTo>
                <a:lnTo>
                  <a:pt x="359" y="4"/>
                </a:lnTo>
              </a:path>
            </a:pathLst>
          </a:custGeom>
          <a:noFill/>
          <a:ln w="396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1" name="Rectangle 61">
            <a:extLst>
              <a:ext uri="{FF2B5EF4-FFF2-40B4-BE49-F238E27FC236}">
                <a16:creationId xmlns:a16="http://schemas.microsoft.com/office/drawing/2014/main" id="{240AC683-0300-4D34-A2AE-1511CA2851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7977" y="1015469"/>
            <a:ext cx="43064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2" name="Rectangle 62">
            <a:extLst>
              <a:ext uri="{FF2B5EF4-FFF2-40B4-BE49-F238E27FC236}">
                <a16:creationId xmlns:a16="http://schemas.microsoft.com/office/drawing/2014/main" id="{525EC7AF-F0A0-426D-915A-319B646681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7977" y="1086913"/>
            <a:ext cx="43064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3" name="Rectangle 63">
            <a:extLst>
              <a:ext uri="{FF2B5EF4-FFF2-40B4-BE49-F238E27FC236}">
                <a16:creationId xmlns:a16="http://schemas.microsoft.com/office/drawing/2014/main" id="{C195BE16-E244-424F-B858-8633EA977E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4727" y="1027099"/>
            <a:ext cx="69565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4" name="Rectangle 64">
            <a:extLst>
              <a:ext uri="{FF2B5EF4-FFF2-40B4-BE49-F238E27FC236}">
                <a16:creationId xmlns:a16="http://schemas.microsoft.com/office/drawing/2014/main" id="{3A8052E8-F22A-43FE-9758-2DBABB436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4727" y="1075283"/>
            <a:ext cx="69565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5" name="Rectangle 65">
            <a:extLst>
              <a:ext uri="{FF2B5EF4-FFF2-40B4-BE49-F238E27FC236}">
                <a16:creationId xmlns:a16="http://schemas.microsoft.com/office/drawing/2014/main" id="{FF1595A8-58B2-4D41-B6CC-81E0B7E4ED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820" y="1038730"/>
            <a:ext cx="97722" cy="13292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6" name="Rectangle 66">
            <a:extLst>
              <a:ext uri="{FF2B5EF4-FFF2-40B4-BE49-F238E27FC236}">
                <a16:creationId xmlns:a16="http://schemas.microsoft.com/office/drawing/2014/main" id="{B7FE5377-477D-45C6-855D-96E75879D8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820" y="1063652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7" name="Rectangle 67">
            <a:extLst>
              <a:ext uri="{FF2B5EF4-FFF2-40B4-BE49-F238E27FC236}">
                <a16:creationId xmlns:a16="http://schemas.microsoft.com/office/drawing/2014/main" id="{3486DDFE-9E33-4840-BCDF-B0AA62E22B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820" y="1052022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8" name="Rectangle 68">
            <a:extLst>
              <a:ext uri="{FF2B5EF4-FFF2-40B4-BE49-F238E27FC236}">
                <a16:creationId xmlns:a16="http://schemas.microsoft.com/office/drawing/2014/main" id="{B9360223-EB40-49D0-A53F-810ADBA6BE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820" y="1052022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9" name="Rectangle 69">
            <a:extLst>
              <a:ext uri="{FF2B5EF4-FFF2-40B4-BE49-F238E27FC236}">
                <a16:creationId xmlns:a16="http://schemas.microsoft.com/office/drawing/2014/main" id="{C126B3C3-8E62-40DF-9B0B-48B6D0E09C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9985" y="945686"/>
            <a:ext cx="41408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0" name="Rectangle 70">
            <a:extLst>
              <a:ext uri="{FF2B5EF4-FFF2-40B4-BE49-F238E27FC236}">
                <a16:creationId xmlns:a16="http://schemas.microsoft.com/office/drawing/2014/main" id="{4E43995D-54A6-40A2-AFD4-BD694AB3A7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9985" y="1015469"/>
            <a:ext cx="41408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1" name="Rectangle 71">
            <a:extLst>
              <a:ext uri="{FF2B5EF4-FFF2-40B4-BE49-F238E27FC236}">
                <a16:creationId xmlns:a16="http://schemas.microsoft.com/office/drawing/2014/main" id="{13CF4ACB-6AC8-4FB0-8AC7-777FDA4613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5079" y="957316"/>
            <a:ext cx="71221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2" name="Rectangle 72">
            <a:extLst>
              <a:ext uri="{FF2B5EF4-FFF2-40B4-BE49-F238E27FC236}">
                <a16:creationId xmlns:a16="http://schemas.microsoft.com/office/drawing/2014/main" id="{D26C95C4-2BA4-4409-BAB2-3745BF4739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5079" y="1003838"/>
            <a:ext cx="71221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3" name="Rectangle 73">
            <a:extLst>
              <a:ext uri="{FF2B5EF4-FFF2-40B4-BE49-F238E27FC236}">
                <a16:creationId xmlns:a16="http://schemas.microsoft.com/office/drawing/2014/main" id="{F5414E81-053B-4F27-A89D-6C8F377715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968947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4" name="Rectangle 74">
            <a:extLst>
              <a:ext uri="{FF2B5EF4-FFF2-40B4-BE49-F238E27FC236}">
                <a16:creationId xmlns:a16="http://schemas.microsoft.com/office/drawing/2014/main" id="{E533637B-0DE2-43E9-AB06-EDD7CEA7FF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992208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5" name="Rectangle 75">
            <a:extLst>
              <a:ext uri="{FF2B5EF4-FFF2-40B4-BE49-F238E27FC236}">
                <a16:creationId xmlns:a16="http://schemas.microsoft.com/office/drawing/2014/main" id="{81A8119C-F946-444E-BBE6-C6447FE701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980577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6" name="Rectangle 76">
            <a:extLst>
              <a:ext uri="{FF2B5EF4-FFF2-40B4-BE49-F238E27FC236}">
                <a16:creationId xmlns:a16="http://schemas.microsoft.com/office/drawing/2014/main" id="{7A6830AA-78AD-4610-86CC-4078C930E0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980577"/>
            <a:ext cx="97722" cy="11630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7" name="Freeform 77">
            <a:extLst>
              <a:ext uri="{FF2B5EF4-FFF2-40B4-BE49-F238E27FC236}">
                <a16:creationId xmlns:a16="http://schemas.microsoft.com/office/drawing/2014/main" id="{0E4DA224-AB37-499B-987A-C6CDAA59F1B3}"/>
              </a:ext>
            </a:extLst>
          </p:cNvPr>
          <p:cNvSpPr>
            <a:spLocks/>
          </p:cNvSpPr>
          <p:nvPr/>
        </p:nvSpPr>
        <p:spPr bwMode="auto">
          <a:xfrm>
            <a:off x="1715969" y="957316"/>
            <a:ext cx="4697267" cy="212671"/>
          </a:xfrm>
          <a:custGeom>
            <a:avLst/>
            <a:gdLst>
              <a:gd name="T0" fmla="*/ 0 w 335"/>
              <a:gd name="T1" fmla="*/ 0 h 18"/>
              <a:gd name="T2" fmla="*/ 28 w 335"/>
              <a:gd name="T3" fmla="*/ 18 h 18"/>
              <a:gd name="T4" fmla="*/ 56 w 335"/>
              <a:gd name="T5" fmla="*/ 8 h 18"/>
              <a:gd name="T6" fmla="*/ 84 w 335"/>
              <a:gd name="T7" fmla="*/ 8 h 18"/>
              <a:gd name="T8" fmla="*/ 112 w 335"/>
              <a:gd name="T9" fmla="*/ 0 h 18"/>
              <a:gd name="T10" fmla="*/ 140 w 335"/>
              <a:gd name="T11" fmla="*/ 0 h 18"/>
              <a:gd name="T12" fmla="*/ 168 w 335"/>
              <a:gd name="T13" fmla="*/ 13 h 18"/>
              <a:gd name="T14" fmla="*/ 196 w 335"/>
              <a:gd name="T15" fmla="*/ 12 h 18"/>
              <a:gd name="T16" fmla="*/ 224 w 335"/>
              <a:gd name="T17" fmla="*/ 6 h 18"/>
              <a:gd name="T18" fmla="*/ 251 w 335"/>
              <a:gd name="T19" fmla="*/ 13 h 18"/>
              <a:gd name="T20" fmla="*/ 279 w 335"/>
              <a:gd name="T21" fmla="*/ 18 h 18"/>
              <a:gd name="T22" fmla="*/ 307 w 335"/>
              <a:gd name="T23" fmla="*/ 13 h 18"/>
              <a:gd name="T24" fmla="*/ 335 w 335"/>
              <a:gd name="T25" fmla="*/ 13 h 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335" h="18">
                <a:moveTo>
                  <a:pt x="0" y="0"/>
                </a:moveTo>
                <a:lnTo>
                  <a:pt x="28" y="18"/>
                </a:lnTo>
                <a:lnTo>
                  <a:pt x="56" y="8"/>
                </a:lnTo>
                <a:lnTo>
                  <a:pt x="84" y="8"/>
                </a:lnTo>
                <a:lnTo>
                  <a:pt x="112" y="0"/>
                </a:lnTo>
                <a:lnTo>
                  <a:pt x="140" y="0"/>
                </a:lnTo>
                <a:lnTo>
                  <a:pt x="168" y="13"/>
                </a:lnTo>
                <a:lnTo>
                  <a:pt x="196" y="12"/>
                </a:lnTo>
                <a:lnTo>
                  <a:pt x="224" y="6"/>
                </a:lnTo>
                <a:lnTo>
                  <a:pt x="251" y="13"/>
                </a:lnTo>
                <a:lnTo>
                  <a:pt x="279" y="18"/>
                </a:lnTo>
                <a:lnTo>
                  <a:pt x="307" y="13"/>
                </a:lnTo>
                <a:lnTo>
                  <a:pt x="335" y="13"/>
                </a:lnTo>
              </a:path>
            </a:pathLst>
          </a:custGeom>
          <a:noFill/>
          <a:ln w="396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8" name="Freeform 78">
            <a:extLst>
              <a:ext uri="{FF2B5EF4-FFF2-40B4-BE49-F238E27FC236}">
                <a16:creationId xmlns:a16="http://schemas.microsoft.com/office/drawing/2014/main" id="{C372588E-7313-4E5D-8DB6-8B52D594039F}"/>
              </a:ext>
            </a:extLst>
          </p:cNvPr>
          <p:cNvSpPr>
            <a:spLocks noEditPoints="1"/>
          </p:cNvSpPr>
          <p:nvPr/>
        </p:nvSpPr>
        <p:spPr bwMode="auto">
          <a:xfrm>
            <a:off x="8419015" y="957316"/>
            <a:ext cx="3084031" cy="294085"/>
          </a:xfrm>
          <a:custGeom>
            <a:avLst/>
            <a:gdLst>
              <a:gd name="T0" fmla="*/ 0 w 220"/>
              <a:gd name="T1" fmla="*/ 10 h 25"/>
              <a:gd name="T2" fmla="*/ 9 w 220"/>
              <a:gd name="T3" fmla="*/ 10 h 25"/>
              <a:gd name="T4" fmla="*/ 12 w 220"/>
              <a:gd name="T5" fmla="*/ 11 h 25"/>
              <a:gd name="T6" fmla="*/ 21 w 220"/>
              <a:gd name="T7" fmla="*/ 11 h 25"/>
              <a:gd name="T8" fmla="*/ 24 w 220"/>
              <a:gd name="T9" fmla="*/ 11 h 25"/>
              <a:gd name="T10" fmla="*/ 33 w 220"/>
              <a:gd name="T11" fmla="*/ 10 h 25"/>
              <a:gd name="T12" fmla="*/ 36 w 220"/>
              <a:gd name="T13" fmla="*/ 9 h 25"/>
              <a:gd name="T14" fmla="*/ 45 w 220"/>
              <a:gd name="T15" fmla="*/ 8 h 25"/>
              <a:gd name="T16" fmla="*/ 48 w 220"/>
              <a:gd name="T17" fmla="*/ 8 h 25"/>
              <a:gd name="T18" fmla="*/ 57 w 220"/>
              <a:gd name="T19" fmla="*/ 8 h 25"/>
              <a:gd name="T20" fmla="*/ 60 w 220"/>
              <a:gd name="T21" fmla="*/ 9 h 25"/>
              <a:gd name="T22" fmla="*/ 69 w 220"/>
              <a:gd name="T23" fmla="*/ 11 h 25"/>
              <a:gd name="T24" fmla="*/ 72 w 220"/>
              <a:gd name="T25" fmla="*/ 12 h 25"/>
              <a:gd name="T26" fmla="*/ 81 w 220"/>
              <a:gd name="T27" fmla="*/ 14 h 25"/>
              <a:gd name="T28" fmla="*/ 84 w 220"/>
              <a:gd name="T29" fmla="*/ 13 h 25"/>
              <a:gd name="T30" fmla="*/ 93 w 220"/>
              <a:gd name="T31" fmla="*/ 11 h 25"/>
              <a:gd name="T32" fmla="*/ 96 w 220"/>
              <a:gd name="T33" fmla="*/ 10 h 25"/>
              <a:gd name="T34" fmla="*/ 105 w 220"/>
              <a:gd name="T35" fmla="*/ 8 h 25"/>
              <a:gd name="T36" fmla="*/ 108 w 220"/>
              <a:gd name="T37" fmla="*/ 7 h 25"/>
              <a:gd name="T38" fmla="*/ 117 w 220"/>
              <a:gd name="T39" fmla="*/ 7 h 25"/>
              <a:gd name="T40" fmla="*/ 120 w 220"/>
              <a:gd name="T41" fmla="*/ 7 h 25"/>
              <a:gd name="T42" fmla="*/ 129 w 220"/>
              <a:gd name="T43" fmla="*/ 7 h 25"/>
              <a:gd name="T44" fmla="*/ 132 w 220"/>
              <a:gd name="T45" fmla="*/ 7 h 25"/>
              <a:gd name="T46" fmla="*/ 141 w 220"/>
              <a:gd name="T47" fmla="*/ 10 h 25"/>
              <a:gd name="T48" fmla="*/ 144 w 220"/>
              <a:gd name="T49" fmla="*/ 11 h 25"/>
              <a:gd name="T50" fmla="*/ 152 w 220"/>
              <a:gd name="T51" fmla="*/ 16 h 25"/>
              <a:gd name="T52" fmla="*/ 155 w 220"/>
              <a:gd name="T53" fmla="*/ 17 h 25"/>
              <a:gd name="T54" fmla="*/ 165 w 220"/>
              <a:gd name="T55" fmla="*/ 22 h 25"/>
              <a:gd name="T56" fmla="*/ 168 w 220"/>
              <a:gd name="T57" fmla="*/ 22 h 25"/>
              <a:gd name="T58" fmla="*/ 177 w 220"/>
              <a:gd name="T59" fmla="*/ 23 h 25"/>
              <a:gd name="T60" fmla="*/ 180 w 220"/>
              <a:gd name="T61" fmla="*/ 24 h 25"/>
              <a:gd name="T62" fmla="*/ 189 w 220"/>
              <a:gd name="T63" fmla="*/ 25 h 25"/>
              <a:gd name="T64" fmla="*/ 192 w 220"/>
              <a:gd name="T65" fmla="*/ 25 h 25"/>
              <a:gd name="T66" fmla="*/ 192 w 220"/>
              <a:gd name="T67" fmla="*/ 25 h 25"/>
              <a:gd name="T68" fmla="*/ 199 w 220"/>
              <a:gd name="T69" fmla="*/ 19 h 25"/>
              <a:gd name="T70" fmla="*/ 202 w 220"/>
              <a:gd name="T71" fmla="*/ 16 h 25"/>
              <a:gd name="T72" fmla="*/ 209 w 220"/>
              <a:gd name="T73" fmla="*/ 10 h 25"/>
              <a:gd name="T74" fmla="*/ 212 w 220"/>
              <a:gd name="T75" fmla="*/ 7 h 25"/>
              <a:gd name="T76" fmla="*/ 219 w 220"/>
              <a:gd name="T77" fmla="*/ 1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</a:cxnLst>
            <a:rect l="0" t="0" r="r" b="b"/>
            <a:pathLst>
              <a:path w="220" h="25">
                <a:moveTo>
                  <a:pt x="9" y="10"/>
                </a:moveTo>
                <a:lnTo>
                  <a:pt x="12" y="11"/>
                </a:lnTo>
                <a:moveTo>
                  <a:pt x="21" y="11"/>
                </a:moveTo>
                <a:lnTo>
                  <a:pt x="24" y="11"/>
                </a:lnTo>
                <a:moveTo>
                  <a:pt x="33" y="10"/>
                </a:moveTo>
                <a:lnTo>
                  <a:pt x="36" y="9"/>
                </a:lnTo>
                <a:moveTo>
                  <a:pt x="45" y="8"/>
                </a:moveTo>
                <a:lnTo>
                  <a:pt x="48" y="8"/>
                </a:lnTo>
                <a:moveTo>
                  <a:pt x="57" y="8"/>
                </a:moveTo>
                <a:lnTo>
                  <a:pt x="60" y="9"/>
                </a:lnTo>
                <a:moveTo>
                  <a:pt x="69" y="11"/>
                </a:moveTo>
                <a:lnTo>
                  <a:pt x="72" y="12"/>
                </a:lnTo>
                <a:moveTo>
                  <a:pt x="81" y="14"/>
                </a:moveTo>
                <a:lnTo>
                  <a:pt x="84" y="13"/>
                </a:lnTo>
                <a:moveTo>
                  <a:pt x="93" y="11"/>
                </a:moveTo>
                <a:lnTo>
                  <a:pt x="96" y="10"/>
                </a:lnTo>
                <a:moveTo>
                  <a:pt x="105" y="8"/>
                </a:moveTo>
                <a:lnTo>
                  <a:pt x="108" y="7"/>
                </a:lnTo>
                <a:moveTo>
                  <a:pt x="117" y="7"/>
                </a:moveTo>
                <a:lnTo>
                  <a:pt x="120" y="7"/>
                </a:lnTo>
                <a:moveTo>
                  <a:pt x="129" y="7"/>
                </a:moveTo>
                <a:lnTo>
                  <a:pt x="132" y="7"/>
                </a:lnTo>
                <a:moveTo>
                  <a:pt x="141" y="10"/>
                </a:moveTo>
                <a:lnTo>
                  <a:pt x="144" y="11"/>
                </a:lnTo>
                <a:moveTo>
                  <a:pt x="152" y="16"/>
                </a:moveTo>
                <a:lnTo>
                  <a:pt x="155" y="17"/>
                </a:lnTo>
                <a:moveTo>
                  <a:pt x="165" y="22"/>
                </a:moveTo>
                <a:lnTo>
                  <a:pt x="168" y="22"/>
                </a:lnTo>
                <a:moveTo>
                  <a:pt x="177" y="23"/>
                </a:moveTo>
                <a:lnTo>
                  <a:pt x="180" y="24"/>
                </a:lnTo>
                <a:moveTo>
                  <a:pt x="189" y="25"/>
                </a:moveTo>
                <a:lnTo>
                  <a:pt x="192" y="25"/>
                </a:lnTo>
                <a:lnTo>
                  <a:pt x="192" y="25"/>
                </a:lnTo>
                <a:moveTo>
                  <a:pt x="199" y="19"/>
                </a:moveTo>
                <a:lnTo>
                  <a:pt x="202" y="16"/>
                </a:lnTo>
                <a:moveTo>
                  <a:pt x="209" y="10"/>
                </a:moveTo>
                <a:lnTo>
                  <a:pt x="212" y="7"/>
                </a:lnTo>
                <a:moveTo>
                  <a:pt x="219" y="1"/>
                </a:moveTo>
              </a:path>
            </a:pathLst>
          </a:custGeom>
          <a:noFill/>
          <a:ln w="396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9" name="Rectangle 79">
            <a:extLst>
              <a:ext uri="{FF2B5EF4-FFF2-40B4-BE49-F238E27FC236}">
                <a16:creationId xmlns:a16="http://schemas.microsoft.com/office/drawing/2014/main" id="{0EF72269-740A-42FA-AF30-E6CFD684A5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9985" y="1075283"/>
            <a:ext cx="41408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0" name="Rectangle 80">
            <a:extLst>
              <a:ext uri="{FF2B5EF4-FFF2-40B4-BE49-F238E27FC236}">
                <a16:creationId xmlns:a16="http://schemas.microsoft.com/office/drawing/2014/main" id="{5944A299-7261-4142-ACF1-2AC3769B1A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9985" y="1145065"/>
            <a:ext cx="41408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1" name="Rectangle 81">
            <a:extLst>
              <a:ext uri="{FF2B5EF4-FFF2-40B4-BE49-F238E27FC236}">
                <a16:creationId xmlns:a16="http://schemas.microsoft.com/office/drawing/2014/main" id="{DD1B1F43-0349-4F28-A663-7BB3E9036F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5079" y="1086913"/>
            <a:ext cx="71221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2" name="Rectangle 82">
            <a:extLst>
              <a:ext uri="{FF2B5EF4-FFF2-40B4-BE49-F238E27FC236}">
                <a16:creationId xmlns:a16="http://schemas.microsoft.com/office/drawing/2014/main" id="{74853E96-4748-425D-B54D-0F89C161ED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5079" y="1133435"/>
            <a:ext cx="71221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3" name="Rectangle 83">
            <a:extLst>
              <a:ext uri="{FF2B5EF4-FFF2-40B4-BE49-F238E27FC236}">
                <a16:creationId xmlns:a16="http://schemas.microsoft.com/office/drawing/2014/main" id="{E0A30C9B-2619-4594-9D0F-48507D0816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1098544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4" name="Rectangle 84">
            <a:extLst>
              <a:ext uri="{FF2B5EF4-FFF2-40B4-BE49-F238E27FC236}">
                <a16:creationId xmlns:a16="http://schemas.microsoft.com/office/drawing/2014/main" id="{FF08D92A-9542-42E5-B0C1-66A5012D85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1121805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5" name="Rectangle 85">
            <a:extLst>
              <a:ext uri="{FF2B5EF4-FFF2-40B4-BE49-F238E27FC236}">
                <a16:creationId xmlns:a16="http://schemas.microsoft.com/office/drawing/2014/main" id="{4091F0ED-643B-4F23-8F98-EC8F03883A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1110174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6" name="Rectangle 86">
            <a:extLst>
              <a:ext uri="{FF2B5EF4-FFF2-40B4-BE49-F238E27FC236}">
                <a16:creationId xmlns:a16="http://schemas.microsoft.com/office/drawing/2014/main" id="{A80021A9-A954-49C5-B2BF-F79D51C9B8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1828" y="1110174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7" name="Rectangle 87">
            <a:extLst>
              <a:ext uri="{FF2B5EF4-FFF2-40B4-BE49-F238E27FC236}">
                <a16:creationId xmlns:a16="http://schemas.microsoft.com/office/drawing/2014/main" id="{F3F59FB0-D064-40A5-AB73-3308CAA4EE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2701" y="1038730"/>
            <a:ext cx="41408" cy="13292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8" name="Rectangle 88">
            <a:extLst>
              <a:ext uri="{FF2B5EF4-FFF2-40B4-BE49-F238E27FC236}">
                <a16:creationId xmlns:a16="http://schemas.microsoft.com/office/drawing/2014/main" id="{472A5E16-CFFC-4E02-81A9-61BC6337A2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2701" y="1110174"/>
            <a:ext cx="41408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9" name="Rectangle 89">
            <a:extLst>
              <a:ext uri="{FF2B5EF4-FFF2-40B4-BE49-F238E27FC236}">
                <a16:creationId xmlns:a16="http://schemas.microsoft.com/office/drawing/2014/main" id="{08A8DEC3-8768-4C3F-A2F6-EB151C1F87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9451" y="1052022"/>
            <a:ext cx="69565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0" name="Rectangle 90">
            <a:extLst>
              <a:ext uri="{FF2B5EF4-FFF2-40B4-BE49-F238E27FC236}">
                <a16:creationId xmlns:a16="http://schemas.microsoft.com/office/drawing/2014/main" id="{7F2C2520-FDEF-4C2D-98E9-27AABDB547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9451" y="1098544"/>
            <a:ext cx="69565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1" name="Rectangle 91">
            <a:extLst>
              <a:ext uri="{FF2B5EF4-FFF2-40B4-BE49-F238E27FC236}">
                <a16:creationId xmlns:a16="http://schemas.microsoft.com/office/drawing/2014/main" id="{951AAD78-E8FB-43C3-9FE6-9AF3B307CB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4544" y="1063652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2" name="Rectangle 92">
            <a:extLst>
              <a:ext uri="{FF2B5EF4-FFF2-40B4-BE49-F238E27FC236}">
                <a16:creationId xmlns:a16="http://schemas.microsoft.com/office/drawing/2014/main" id="{D6A399A5-4C8E-410F-AAFB-B79A7299DE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4544" y="1086913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3" name="Rectangle 93">
            <a:extLst>
              <a:ext uri="{FF2B5EF4-FFF2-40B4-BE49-F238E27FC236}">
                <a16:creationId xmlns:a16="http://schemas.microsoft.com/office/drawing/2014/main" id="{1716E75D-7970-47F9-ACA8-A751C3E197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4544" y="1075283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4" name="Rectangle 94">
            <a:extLst>
              <a:ext uri="{FF2B5EF4-FFF2-40B4-BE49-F238E27FC236}">
                <a16:creationId xmlns:a16="http://schemas.microsoft.com/office/drawing/2014/main" id="{DD110439-9032-4AD4-9C0D-6B589D6D8E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4544" y="1075283"/>
            <a:ext cx="97722" cy="11630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5" name="Rectangle 95">
            <a:extLst>
              <a:ext uri="{FF2B5EF4-FFF2-40B4-BE49-F238E27FC236}">
                <a16:creationId xmlns:a16="http://schemas.microsoft.com/office/drawing/2014/main" id="{25546388-0204-43E9-9AA0-17CAFFD375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73659" y="4592669"/>
            <a:ext cx="1611580" cy="9088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6" name="Rectangle 96">
            <a:extLst>
              <a:ext uri="{FF2B5EF4-FFF2-40B4-BE49-F238E27FC236}">
                <a16:creationId xmlns:a16="http://schemas.microsoft.com/office/drawing/2014/main" id="{9E53FEEB-56DB-44EC-93C1-01CAAE7BB4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73659" y="4592669"/>
            <a:ext cx="1611580" cy="908838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7" name="Line 97">
            <a:extLst>
              <a:ext uri="{FF2B5EF4-FFF2-40B4-BE49-F238E27FC236}">
                <a16:creationId xmlns:a16="http://schemas.microsoft.com/office/drawing/2014/main" id="{ECB0F017-9519-4BB9-A021-D391605A5EA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40945" y="4782079"/>
            <a:ext cx="322979" cy="0"/>
          </a:xfrm>
          <a:prstGeom prst="line">
            <a:avLst/>
          </a:prstGeom>
          <a:noFill/>
          <a:ln w="269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8" name="Line 98">
            <a:extLst>
              <a:ext uri="{FF2B5EF4-FFF2-40B4-BE49-F238E27FC236}">
                <a16:creationId xmlns:a16="http://schemas.microsoft.com/office/drawing/2014/main" id="{35F38BBD-7871-465D-A53E-E62F1B6DC2E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40945" y="4958198"/>
            <a:ext cx="322979" cy="0"/>
          </a:xfrm>
          <a:prstGeom prst="line">
            <a:avLst/>
          </a:prstGeom>
          <a:noFill/>
          <a:ln w="269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9" name="Line 99">
            <a:extLst>
              <a:ext uri="{FF2B5EF4-FFF2-40B4-BE49-F238E27FC236}">
                <a16:creationId xmlns:a16="http://schemas.microsoft.com/office/drawing/2014/main" id="{942B8996-EC19-46CC-8F65-CF6F46AE4111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40945" y="5147608"/>
            <a:ext cx="322979" cy="0"/>
          </a:xfrm>
          <a:prstGeom prst="line">
            <a:avLst/>
          </a:prstGeom>
          <a:noFill/>
          <a:ln w="269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0" name="Line 100">
            <a:extLst>
              <a:ext uri="{FF2B5EF4-FFF2-40B4-BE49-F238E27FC236}">
                <a16:creationId xmlns:a16="http://schemas.microsoft.com/office/drawing/2014/main" id="{6C6D1262-E2D1-4E9B-9B64-F7C5F75542A3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40945" y="5323727"/>
            <a:ext cx="322979" cy="0"/>
          </a:xfrm>
          <a:prstGeom prst="line">
            <a:avLst/>
          </a:prstGeom>
          <a:noFill/>
          <a:ln w="269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1" name="Rectangle 101">
            <a:extLst>
              <a:ext uri="{FF2B5EF4-FFF2-40B4-BE49-F238E27FC236}">
                <a16:creationId xmlns:a16="http://schemas.microsoft.com/office/drawing/2014/main" id="{34F9E438-9214-4526-A7DD-8422BAEDC5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7960" y="4710635"/>
            <a:ext cx="1010343" cy="224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6400"/>
                </a:solidFill>
                <a:effectLst/>
                <a:latin typeface="Arial" panose="020B0604020202020204" pitchFamily="34" charset="0"/>
              </a:rPr>
              <a:t>GIRANG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Rectangle 102">
            <a:extLst>
              <a:ext uri="{FF2B5EF4-FFF2-40B4-BE49-F238E27FC236}">
                <a16:creationId xmlns:a16="http://schemas.microsoft.com/office/drawing/2014/main" id="{D23B2550-76B0-4D1A-91DF-88EF4FE9EA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7960" y="4900045"/>
            <a:ext cx="1036844" cy="224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LUO IMB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103">
            <a:extLst>
              <a:ext uri="{FF2B5EF4-FFF2-40B4-BE49-F238E27FC236}">
                <a16:creationId xmlns:a16="http://schemas.microsoft.com/office/drawing/2014/main" id="{4AF3B40A-8903-4B9D-B29B-2E039E5A0E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7960" y="5076164"/>
            <a:ext cx="1036844" cy="224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rPr>
              <a:t>NYANCH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104">
            <a:extLst>
              <a:ext uri="{FF2B5EF4-FFF2-40B4-BE49-F238E27FC236}">
                <a16:creationId xmlns:a16="http://schemas.microsoft.com/office/drawing/2014/main" id="{91F8ABF9-6696-4940-8B51-146F2BD141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7960" y="5265575"/>
            <a:ext cx="616144" cy="224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A020F0"/>
                </a:solidFill>
                <a:effectLst/>
                <a:latin typeface="Arial" panose="020B0604020202020204" pitchFamily="34" charset="0"/>
              </a:rPr>
              <a:t>SUB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5">
            <a:extLst>
              <a:ext uri="{FF2B5EF4-FFF2-40B4-BE49-F238E27FC236}">
                <a16:creationId xmlns:a16="http://schemas.microsoft.com/office/drawing/2014/main" id="{298B6200-6C05-4001-965E-D9BEC49F6E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9463" y="5147608"/>
            <a:ext cx="3981745" cy="353899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6" name="Rectangle 106">
            <a:extLst>
              <a:ext uri="{FF2B5EF4-FFF2-40B4-BE49-F238E27FC236}">
                <a16:creationId xmlns:a16="http://schemas.microsoft.com/office/drawing/2014/main" id="{4747456A-54B3-4CB3-9E5E-F01A14127A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9463" y="5147608"/>
            <a:ext cx="3981745" cy="353899"/>
          </a:xfrm>
          <a:prstGeom prst="rect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7" name="Line 107">
            <a:extLst>
              <a:ext uri="{FF2B5EF4-FFF2-40B4-BE49-F238E27FC236}">
                <a16:creationId xmlns:a16="http://schemas.microsoft.com/office/drawing/2014/main" id="{B2CEA3EB-FD51-4D05-B4C1-20499483C80F}"/>
              </a:ext>
            </a:extLst>
          </p:cNvPr>
          <p:cNvSpPr>
            <a:spLocks noChangeShapeType="1"/>
          </p:cNvSpPr>
          <p:nvPr/>
        </p:nvSpPr>
        <p:spPr bwMode="auto">
          <a:xfrm>
            <a:off x="4786749" y="5323727"/>
            <a:ext cx="322979" cy="0"/>
          </a:xfrm>
          <a:prstGeom prst="line">
            <a:avLst/>
          </a:pr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8" name="Freeform 108">
            <a:extLst>
              <a:ext uri="{FF2B5EF4-FFF2-40B4-BE49-F238E27FC236}">
                <a16:creationId xmlns:a16="http://schemas.microsoft.com/office/drawing/2014/main" id="{AAB494A8-CF30-426F-8521-77E8122F20D8}"/>
              </a:ext>
            </a:extLst>
          </p:cNvPr>
          <p:cNvSpPr>
            <a:spLocks noEditPoints="1"/>
          </p:cNvSpPr>
          <p:nvPr/>
        </p:nvSpPr>
        <p:spPr bwMode="auto">
          <a:xfrm>
            <a:off x="6764371" y="5323727"/>
            <a:ext cx="294821" cy="0"/>
          </a:xfrm>
          <a:custGeom>
            <a:avLst/>
            <a:gdLst>
              <a:gd name="T0" fmla="*/ 0 w 21"/>
              <a:gd name="T1" fmla="*/ 6 w 21"/>
              <a:gd name="T2" fmla="*/ 8 w 21"/>
              <a:gd name="T3" fmla="*/ 14 w 21"/>
              <a:gd name="T4" fmla="*/ 16 w 2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21">
                <a:moveTo>
                  <a:pt x="6" y="0"/>
                </a:moveTo>
                <a:lnTo>
                  <a:pt x="8" y="0"/>
                </a:lnTo>
                <a:moveTo>
                  <a:pt x="14" y="0"/>
                </a:moveTo>
                <a:lnTo>
                  <a:pt x="16" y="0"/>
                </a:lnTo>
              </a:path>
            </a:pathLst>
          </a:cu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9" name="Rectangle 109">
            <a:extLst>
              <a:ext uri="{FF2B5EF4-FFF2-40B4-BE49-F238E27FC236}">
                <a16:creationId xmlns:a16="http://schemas.microsoft.com/office/drawing/2014/main" id="{5B9F91A6-6AAA-409E-A479-24BF53E705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3763" y="5265575"/>
            <a:ext cx="1036844" cy="224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110">
            <a:extLst>
              <a:ext uri="{FF2B5EF4-FFF2-40B4-BE49-F238E27FC236}">
                <a16:creationId xmlns:a16="http://schemas.microsoft.com/office/drawing/2014/main" id="{00FAC846-A0E0-40F0-8B80-2A43480828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3229" y="5265575"/>
            <a:ext cx="1542015" cy="224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TERVENTION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06875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 6">
            <a:extLst>
              <a:ext uri="{FF2B5EF4-FFF2-40B4-BE49-F238E27FC236}">
                <a16:creationId xmlns:a16="http://schemas.microsoft.com/office/drawing/2014/main" id="{CCC836B3-013A-46A0-8618-AA1ADBF52161}"/>
              </a:ext>
            </a:extLst>
          </p:cNvPr>
          <p:cNvSpPr>
            <a:spLocks/>
          </p:cNvSpPr>
          <p:nvPr/>
        </p:nvSpPr>
        <p:spPr bwMode="auto">
          <a:xfrm>
            <a:off x="1593625" y="3232955"/>
            <a:ext cx="3567095" cy="622442"/>
          </a:xfrm>
          <a:custGeom>
            <a:avLst/>
            <a:gdLst>
              <a:gd name="T0" fmla="*/ 0 w 251"/>
              <a:gd name="T1" fmla="*/ 0 h 52"/>
              <a:gd name="T2" fmla="*/ 28 w 251"/>
              <a:gd name="T3" fmla="*/ 34 h 52"/>
              <a:gd name="T4" fmla="*/ 56 w 251"/>
              <a:gd name="T5" fmla="*/ 35 h 52"/>
              <a:gd name="T6" fmla="*/ 84 w 251"/>
              <a:gd name="T7" fmla="*/ 19 h 52"/>
              <a:gd name="T8" fmla="*/ 112 w 251"/>
              <a:gd name="T9" fmla="*/ 35 h 52"/>
              <a:gd name="T10" fmla="*/ 140 w 251"/>
              <a:gd name="T11" fmla="*/ 38 h 52"/>
              <a:gd name="T12" fmla="*/ 168 w 251"/>
              <a:gd name="T13" fmla="*/ 26 h 52"/>
              <a:gd name="T14" fmla="*/ 196 w 251"/>
              <a:gd name="T15" fmla="*/ 21 h 52"/>
              <a:gd name="T16" fmla="*/ 224 w 251"/>
              <a:gd name="T17" fmla="*/ 52 h 52"/>
              <a:gd name="T18" fmla="*/ 251 w 251"/>
              <a:gd name="T19" fmla="*/ 26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1" h="52">
                <a:moveTo>
                  <a:pt x="0" y="0"/>
                </a:moveTo>
                <a:lnTo>
                  <a:pt x="28" y="34"/>
                </a:lnTo>
                <a:lnTo>
                  <a:pt x="56" y="35"/>
                </a:lnTo>
                <a:lnTo>
                  <a:pt x="84" y="19"/>
                </a:lnTo>
                <a:lnTo>
                  <a:pt x="112" y="35"/>
                </a:lnTo>
                <a:lnTo>
                  <a:pt x="140" y="38"/>
                </a:lnTo>
                <a:lnTo>
                  <a:pt x="168" y="26"/>
                </a:lnTo>
                <a:lnTo>
                  <a:pt x="196" y="21"/>
                </a:lnTo>
                <a:lnTo>
                  <a:pt x="224" y="52"/>
                </a:lnTo>
                <a:lnTo>
                  <a:pt x="251" y="26"/>
                </a:lnTo>
              </a:path>
            </a:pathLst>
          </a:custGeom>
          <a:noFill/>
          <a:ln w="41275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" name="Line 7">
            <a:extLst>
              <a:ext uri="{FF2B5EF4-FFF2-40B4-BE49-F238E27FC236}">
                <a16:creationId xmlns:a16="http://schemas.microsoft.com/office/drawing/2014/main" id="{87209619-1BD8-413B-8997-B30E4AB0B8B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94521" y="969529"/>
            <a:ext cx="0" cy="4526853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" name="Line 8">
            <a:extLst>
              <a:ext uri="{FF2B5EF4-FFF2-40B4-BE49-F238E27FC236}">
                <a16:creationId xmlns:a16="http://schemas.microsoft.com/office/drawing/2014/main" id="{14DB3B6B-DD1D-48F7-AA57-F63A37C187D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7007" y="5496382"/>
            <a:ext cx="127515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" name="Line 9">
            <a:extLst>
              <a:ext uri="{FF2B5EF4-FFF2-40B4-BE49-F238E27FC236}">
                <a16:creationId xmlns:a16="http://schemas.microsoft.com/office/drawing/2014/main" id="{D365D85E-0261-455B-8A50-E3BF0440B40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7007" y="4597870"/>
            <a:ext cx="127515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" name="Line 10">
            <a:extLst>
              <a:ext uri="{FF2B5EF4-FFF2-40B4-BE49-F238E27FC236}">
                <a16:creationId xmlns:a16="http://schemas.microsoft.com/office/drawing/2014/main" id="{F06AD974-E4AF-476F-8FAD-8D9C3631E6A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7007" y="3687355"/>
            <a:ext cx="127515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" name="Line 11">
            <a:extLst>
              <a:ext uri="{FF2B5EF4-FFF2-40B4-BE49-F238E27FC236}">
                <a16:creationId xmlns:a16="http://schemas.microsoft.com/office/drawing/2014/main" id="{C27F47F4-E9A4-41A3-93DB-04EF8CA971C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7007" y="2788844"/>
            <a:ext cx="127515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2" name="Line 12">
            <a:extLst>
              <a:ext uri="{FF2B5EF4-FFF2-40B4-BE49-F238E27FC236}">
                <a16:creationId xmlns:a16="http://schemas.microsoft.com/office/drawing/2014/main" id="{AE20336B-0684-4EFD-8DD9-C039465652F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7007" y="1878329"/>
            <a:ext cx="127515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3" name="Line 13">
            <a:extLst>
              <a:ext uri="{FF2B5EF4-FFF2-40B4-BE49-F238E27FC236}">
                <a16:creationId xmlns:a16="http://schemas.microsoft.com/office/drawing/2014/main" id="{4924EEE2-C68A-4BDE-8848-F0DF20F3854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067007" y="969529"/>
            <a:ext cx="127515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4" name="Rectangle 14">
            <a:extLst>
              <a:ext uri="{FF2B5EF4-FFF2-40B4-BE49-F238E27FC236}">
                <a16:creationId xmlns:a16="http://schemas.microsoft.com/office/drawing/2014/main" id="{6874368B-B3FE-480F-85A8-341318A9988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20218" y="5368867"/>
            <a:ext cx="233201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5">
            <a:extLst>
              <a:ext uri="{FF2B5EF4-FFF2-40B4-BE49-F238E27FC236}">
                <a16:creationId xmlns:a16="http://schemas.microsoft.com/office/drawing/2014/main" id="{1809A52F-8681-446D-96E4-D6619BCA7A9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53344" y="4470355"/>
            <a:ext cx="366949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6">
            <a:extLst>
              <a:ext uri="{FF2B5EF4-FFF2-40B4-BE49-F238E27FC236}">
                <a16:creationId xmlns:a16="http://schemas.microsoft.com/office/drawing/2014/main" id="{9D2AF52D-82A7-42B2-92BA-61CDF7140E3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53344" y="3559841"/>
            <a:ext cx="366949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7">
            <a:extLst>
              <a:ext uri="{FF2B5EF4-FFF2-40B4-BE49-F238E27FC236}">
                <a16:creationId xmlns:a16="http://schemas.microsoft.com/office/drawing/2014/main" id="{916D77A5-F419-4BC5-BC61-12EE4EE948E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53344" y="2661329"/>
            <a:ext cx="366949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8">
            <a:extLst>
              <a:ext uri="{FF2B5EF4-FFF2-40B4-BE49-F238E27FC236}">
                <a16:creationId xmlns:a16="http://schemas.microsoft.com/office/drawing/2014/main" id="{F2349BEA-3DB5-4004-9871-3BAD5F9FEF7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53344" y="1750815"/>
            <a:ext cx="366949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AFD6ACAF-0E2F-4F73-858B-B2548BB8DF9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86470" y="840300"/>
            <a:ext cx="500697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20">
            <a:extLst>
              <a:ext uri="{FF2B5EF4-FFF2-40B4-BE49-F238E27FC236}">
                <a16:creationId xmlns:a16="http://schemas.microsoft.com/office/drawing/2014/main" id="{9E8836EF-312C-4524-B807-4723EC5B90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4521" y="789484"/>
            <a:ext cx="10717846" cy="4898946"/>
          </a:xfrm>
          <a:prstGeom prst="rect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1" name="Rectangle 21">
            <a:extLst>
              <a:ext uri="{FF2B5EF4-FFF2-40B4-BE49-F238E27FC236}">
                <a16:creationId xmlns:a16="http://schemas.microsoft.com/office/drawing/2014/main" id="{A09C581E-3441-4ECC-AAF1-8D58364B25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3092" y="201336"/>
            <a:ext cx="5600704" cy="312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ntenatal care of atleast 4 visits over Tim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2">
            <a:extLst>
              <a:ext uri="{FF2B5EF4-FFF2-40B4-BE49-F238E27FC236}">
                <a16:creationId xmlns:a16="http://schemas.microsoft.com/office/drawing/2014/main" id="{9D174892-5A94-4641-B34D-0A140843E6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5611" y="6405182"/>
            <a:ext cx="155667" cy="264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3">
            <a:extLst>
              <a:ext uri="{FF2B5EF4-FFF2-40B4-BE49-F238E27FC236}">
                <a16:creationId xmlns:a16="http://schemas.microsoft.com/office/drawing/2014/main" id="{9ADD1942-89F1-44BB-BD54-0ED7CB50A6C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587784" y="3105441"/>
            <a:ext cx="1766158" cy="255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cility Birth(%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Freeform 24">
            <a:extLst>
              <a:ext uri="{FF2B5EF4-FFF2-40B4-BE49-F238E27FC236}">
                <a16:creationId xmlns:a16="http://schemas.microsoft.com/office/drawing/2014/main" id="{931DDA33-2818-492C-B4CA-BF740FEF20C6}"/>
              </a:ext>
            </a:extLst>
          </p:cNvPr>
          <p:cNvSpPr>
            <a:spLocks noEditPoints="1"/>
          </p:cNvSpPr>
          <p:nvPr/>
        </p:nvSpPr>
        <p:spPr bwMode="auto">
          <a:xfrm>
            <a:off x="7591777" y="3028904"/>
            <a:ext cx="3921486" cy="598436"/>
          </a:xfrm>
          <a:custGeom>
            <a:avLst/>
            <a:gdLst>
              <a:gd name="T0" fmla="*/ 0 w 276"/>
              <a:gd name="T1" fmla="*/ 26 h 50"/>
              <a:gd name="T2" fmla="*/ 9 w 276"/>
              <a:gd name="T3" fmla="*/ 30 h 50"/>
              <a:gd name="T4" fmla="*/ 12 w 276"/>
              <a:gd name="T5" fmla="*/ 32 h 50"/>
              <a:gd name="T6" fmla="*/ 21 w 276"/>
              <a:gd name="T7" fmla="*/ 37 h 50"/>
              <a:gd name="T8" fmla="*/ 24 w 276"/>
              <a:gd name="T9" fmla="*/ 38 h 50"/>
              <a:gd name="T10" fmla="*/ 33 w 276"/>
              <a:gd name="T11" fmla="*/ 40 h 50"/>
              <a:gd name="T12" fmla="*/ 36 w 276"/>
              <a:gd name="T13" fmla="*/ 40 h 50"/>
              <a:gd name="T14" fmla="*/ 45 w 276"/>
              <a:gd name="T15" fmla="*/ 40 h 50"/>
              <a:gd name="T16" fmla="*/ 48 w 276"/>
              <a:gd name="T17" fmla="*/ 41 h 50"/>
              <a:gd name="T18" fmla="*/ 57 w 276"/>
              <a:gd name="T19" fmla="*/ 42 h 50"/>
              <a:gd name="T20" fmla="*/ 60 w 276"/>
              <a:gd name="T21" fmla="*/ 43 h 50"/>
              <a:gd name="T22" fmla="*/ 69 w 276"/>
              <a:gd name="T23" fmla="*/ 46 h 50"/>
              <a:gd name="T24" fmla="*/ 72 w 276"/>
              <a:gd name="T25" fmla="*/ 47 h 50"/>
              <a:gd name="T26" fmla="*/ 81 w 276"/>
              <a:gd name="T27" fmla="*/ 50 h 50"/>
              <a:gd name="T28" fmla="*/ 84 w 276"/>
              <a:gd name="T29" fmla="*/ 47 h 50"/>
              <a:gd name="T30" fmla="*/ 90 w 276"/>
              <a:gd name="T31" fmla="*/ 40 h 50"/>
              <a:gd name="T32" fmla="*/ 93 w 276"/>
              <a:gd name="T33" fmla="*/ 37 h 50"/>
              <a:gd name="T34" fmla="*/ 100 w 276"/>
              <a:gd name="T35" fmla="*/ 30 h 50"/>
              <a:gd name="T36" fmla="*/ 102 w 276"/>
              <a:gd name="T37" fmla="*/ 27 h 50"/>
              <a:gd name="T38" fmla="*/ 109 w 276"/>
              <a:gd name="T39" fmla="*/ 20 h 50"/>
              <a:gd name="T40" fmla="*/ 112 w 276"/>
              <a:gd name="T41" fmla="*/ 21 h 50"/>
              <a:gd name="T42" fmla="*/ 121 w 276"/>
              <a:gd name="T43" fmla="*/ 24 h 50"/>
              <a:gd name="T44" fmla="*/ 124 w 276"/>
              <a:gd name="T45" fmla="*/ 25 h 50"/>
              <a:gd name="T46" fmla="*/ 133 w 276"/>
              <a:gd name="T47" fmla="*/ 29 h 50"/>
              <a:gd name="T48" fmla="*/ 136 w 276"/>
              <a:gd name="T49" fmla="*/ 30 h 50"/>
              <a:gd name="T50" fmla="*/ 145 w 276"/>
              <a:gd name="T51" fmla="*/ 26 h 50"/>
              <a:gd name="T52" fmla="*/ 148 w 276"/>
              <a:gd name="T53" fmla="*/ 25 h 50"/>
              <a:gd name="T54" fmla="*/ 157 w 276"/>
              <a:gd name="T55" fmla="*/ 20 h 50"/>
              <a:gd name="T56" fmla="*/ 160 w 276"/>
              <a:gd name="T57" fmla="*/ 19 h 50"/>
              <a:gd name="T58" fmla="*/ 168 w 276"/>
              <a:gd name="T59" fmla="*/ 15 h 50"/>
              <a:gd name="T60" fmla="*/ 171 w 276"/>
              <a:gd name="T61" fmla="*/ 14 h 50"/>
              <a:gd name="T62" fmla="*/ 180 w 276"/>
              <a:gd name="T63" fmla="*/ 11 h 50"/>
              <a:gd name="T64" fmla="*/ 183 w 276"/>
              <a:gd name="T65" fmla="*/ 10 h 50"/>
              <a:gd name="T66" fmla="*/ 192 w 276"/>
              <a:gd name="T67" fmla="*/ 7 h 50"/>
              <a:gd name="T68" fmla="*/ 195 w 276"/>
              <a:gd name="T69" fmla="*/ 9 h 50"/>
              <a:gd name="T70" fmla="*/ 204 w 276"/>
              <a:gd name="T71" fmla="*/ 14 h 50"/>
              <a:gd name="T72" fmla="*/ 207 w 276"/>
              <a:gd name="T73" fmla="*/ 16 h 50"/>
              <a:gd name="T74" fmla="*/ 216 w 276"/>
              <a:gd name="T75" fmla="*/ 21 h 50"/>
              <a:gd name="T76" fmla="*/ 219 w 276"/>
              <a:gd name="T77" fmla="*/ 22 h 50"/>
              <a:gd name="T78" fmla="*/ 228 w 276"/>
              <a:gd name="T79" fmla="*/ 25 h 50"/>
              <a:gd name="T80" fmla="*/ 231 w 276"/>
              <a:gd name="T81" fmla="*/ 26 h 50"/>
              <a:gd name="T82" fmla="*/ 240 w 276"/>
              <a:gd name="T83" fmla="*/ 29 h 50"/>
              <a:gd name="T84" fmla="*/ 243 w 276"/>
              <a:gd name="T85" fmla="*/ 30 h 50"/>
              <a:gd name="T86" fmla="*/ 251 w 276"/>
              <a:gd name="T87" fmla="*/ 28 h 50"/>
              <a:gd name="T88" fmla="*/ 253 w 276"/>
              <a:gd name="T89" fmla="*/ 25 h 50"/>
              <a:gd name="T90" fmla="*/ 260 w 276"/>
              <a:gd name="T91" fmla="*/ 18 h 50"/>
              <a:gd name="T92" fmla="*/ 262 w 276"/>
              <a:gd name="T93" fmla="*/ 15 h 50"/>
              <a:gd name="T94" fmla="*/ 269 w 276"/>
              <a:gd name="T95" fmla="*/ 8 h 50"/>
              <a:gd name="T96" fmla="*/ 271 w 276"/>
              <a:gd name="T97" fmla="*/ 5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</a:cxnLst>
            <a:rect l="0" t="0" r="r" b="b"/>
            <a:pathLst>
              <a:path w="276" h="50">
                <a:moveTo>
                  <a:pt x="9" y="30"/>
                </a:moveTo>
                <a:lnTo>
                  <a:pt x="12" y="32"/>
                </a:lnTo>
                <a:moveTo>
                  <a:pt x="21" y="37"/>
                </a:moveTo>
                <a:lnTo>
                  <a:pt x="24" y="38"/>
                </a:lnTo>
                <a:moveTo>
                  <a:pt x="33" y="40"/>
                </a:moveTo>
                <a:lnTo>
                  <a:pt x="36" y="40"/>
                </a:lnTo>
                <a:moveTo>
                  <a:pt x="45" y="40"/>
                </a:moveTo>
                <a:lnTo>
                  <a:pt x="48" y="41"/>
                </a:lnTo>
                <a:moveTo>
                  <a:pt x="57" y="42"/>
                </a:moveTo>
                <a:lnTo>
                  <a:pt x="60" y="43"/>
                </a:lnTo>
                <a:moveTo>
                  <a:pt x="69" y="46"/>
                </a:moveTo>
                <a:lnTo>
                  <a:pt x="72" y="47"/>
                </a:lnTo>
                <a:moveTo>
                  <a:pt x="81" y="50"/>
                </a:moveTo>
                <a:lnTo>
                  <a:pt x="84" y="47"/>
                </a:lnTo>
                <a:moveTo>
                  <a:pt x="90" y="40"/>
                </a:moveTo>
                <a:lnTo>
                  <a:pt x="93" y="37"/>
                </a:lnTo>
                <a:moveTo>
                  <a:pt x="100" y="30"/>
                </a:moveTo>
                <a:lnTo>
                  <a:pt x="102" y="27"/>
                </a:lnTo>
                <a:moveTo>
                  <a:pt x="109" y="20"/>
                </a:moveTo>
                <a:lnTo>
                  <a:pt x="112" y="21"/>
                </a:lnTo>
                <a:moveTo>
                  <a:pt x="121" y="24"/>
                </a:moveTo>
                <a:lnTo>
                  <a:pt x="124" y="25"/>
                </a:lnTo>
                <a:moveTo>
                  <a:pt x="133" y="29"/>
                </a:moveTo>
                <a:lnTo>
                  <a:pt x="136" y="30"/>
                </a:lnTo>
                <a:moveTo>
                  <a:pt x="145" y="26"/>
                </a:moveTo>
                <a:lnTo>
                  <a:pt x="148" y="25"/>
                </a:lnTo>
                <a:moveTo>
                  <a:pt x="157" y="20"/>
                </a:moveTo>
                <a:lnTo>
                  <a:pt x="160" y="19"/>
                </a:lnTo>
                <a:moveTo>
                  <a:pt x="168" y="15"/>
                </a:moveTo>
                <a:lnTo>
                  <a:pt x="171" y="14"/>
                </a:lnTo>
                <a:moveTo>
                  <a:pt x="180" y="11"/>
                </a:moveTo>
                <a:lnTo>
                  <a:pt x="183" y="10"/>
                </a:lnTo>
                <a:moveTo>
                  <a:pt x="192" y="7"/>
                </a:moveTo>
                <a:lnTo>
                  <a:pt x="195" y="9"/>
                </a:lnTo>
                <a:moveTo>
                  <a:pt x="204" y="14"/>
                </a:moveTo>
                <a:lnTo>
                  <a:pt x="207" y="16"/>
                </a:lnTo>
                <a:moveTo>
                  <a:pt x="216" y="21"/>
                </a:moveTo>
                <a:lnTo>
                  <a:pt x="219" y="22"/>
                </a:lnTo>
                <a:moveTo>
                  <a:pt x="228" y="25"/>
                </a:moveTo>
                <a:lnTo>
                  <a:pt x="231" y="26"/>
                </a:lnTo>
                <a:moveTo>
                  <a:pt x="240" y="29"/>
                </a:moveTo>
                <a:lnTo>
                  <a:pt x="243" y="30"/>
                </a:lnTo>
                <a:moveTo>
                  <a:pt x="251" y="28"/>
                </a:moveTo>
                <a:lnTo>
                  <a:pt x="253" y="25"/>
                </a:lnTo>
                <a:moveTo>
                  <a:pt x="260" y="18"/>
                </a:moveTo>
                <a:lnTo>
                  <a:pt x="262" y="15"/>
                </a:lnTo>
                <a:moveTo>
                  <a:pt x="269" y="8"/>
                </a:moveTo>
                <a:lnTo>
                  <a:pt x="271" y="5"/>
                </a:lnTo>
              </a:path>
            </a:pathLst>
          </a:custGeom>
          <a:noFill/>
          <a:ln w="41275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5" name="Rectangle 25">
            <a:extLst>
              <a:ext uri="{FF2B5EF4-FFF2-40B4-BE49-F238E27FC236}">
                <a16:creationId xmlns:a16="http://schemas.microsoft.com/office/drawing/2014/main" id="{195F1CCC-1064-4F9E-9390-4BE9344C41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5816" y="3507310"/>
            <a:ext cx="43057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6" name="Rectangle 26">
            <a:extLst>
              <a:ext uri="{FF2B5EF4-FFF2-40B4-BE49-F238E27FC236}">
                <a16:creationId xmlns:a16="http://schemas.microsoft.com/office/drawing/2014/main" id="{FCE8CA7F-9B57-4128-AAC5-0978E1EBF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5816" y="3579328"/>
            <a:ext cx="43057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7" name="Rectangle 27">
            <a:extLst>
              <a:ext uri="{FF2B5EF4-FFF2-40B4-BE49-F238E27FC236}">
                <a16:creationId xmlns:a16="http://schemas.microsoft.com/office/drawing/2014/main" id="{E777B8B3-E3DC-4EFB-8560-0C6BBA38AE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2568" y="3519313"/>
            <a:ext cx="71209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8" name="Rectangle 28">
            <a:extLst>
              <a:ext uri="{FF2B5EF4-FFF2-40B4-BE49-F238E27FC236}">
                <a16:creationId xmlns:a16="http://schemas.microsoft.com/office/drawing/2014/main" id="{2048D059-56E8-4F49-8C69-5B8A82B26E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2568" y="3567325"/>
            <a:ext cx="71209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9" name="Rectangle 29">
            <a:extLst>
              <a:ext uri="{FF2B5EF4-FFF2-40B4-BE49-F238E27FC236}">
                <a16:creationId xmlns:a16="http://schemas.microsoft.com/office/drawing/2014/main" id="{F6C4B160-7AC4-4D5E-AB08-DE0F4D1A91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7664" y="3531316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0" name="Rectangle 30">
            <a:extLst>
              <a:ext uri="{FF2B5EF4-FFF2-40B4-BE49-F238E27FC236}">
                <a16:creationId xmlns:a16="http://schemas.microsoft.com/office/drawing/2014/main" id="{A3A11B83-4164-41DF-BC13-35160D3AFB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7664" y="3555322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1" name="Rectangle 31">
            <a:extLst>
              <a:ext uri="{FF2B5EF4-FFF2-40B4-BE49-F238E27FC236}">
                <a16:creationId xmlns:a16="http://schemas.microsoft.com/office/drawing/2014/main" id="{2C9C935F-0587-4B0C-B44A-C07546730D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7664" y="3543319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2" name="Rectangle 32">
            <a:extLst>
              <a:ext uri="{FF2B5EF4-FFF2-40B4-BE49-F238E27FC236}">
                <a16:creationId xmlns:a16="http://schemas.microsoft.com/office/drawing/2014/main" id="{A8D8157A-28CB-4651-B612-CCFC11CF28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7664" y="3543319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3" name="Rectangle 33">
            <a:extLst>
              <a:ext uri="{FF2B5EF4-FFF2-40B4-BE49-F238E27FC236}">
                <a16:creationId xmlns:a16="http://schemas.microsoft.com/office/drawing/2014/main" id="{AE1FBE8C-7168-4B85-9697-59F78D152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3816" y="3280967"/>
            <a:ext cx="43057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4" name="Rectangle 34">
            <a:extLst>
              <a:ext uri="{FF2B5EF4-FFF2-40B4-BE49-F238E27FC236}">
                <a16:creationId xmlns:a16="http://schemas.microsoft.com/office/drawing/2014/main" id="{BA6F48D6-0845-4653-B1E9-1C8575C143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3816" y="3352986"/>
            <a:ext cx="43057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5" name="Rectangle 35">
            <a:extLst>
              <a:ext uri="{FF2B5EF4-FFF2-40B4-BE49-F238E27FC236}">
                <a16:creationId xmlns:a16="http://schemas.microsoft.com/office/drawing/2014/main" id="{41FB4EB7-59C3-4065-A679-2E11F66FD7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0567" y="3292971"/>
            <a:ext cx="71209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6" name="Rectangle 36">
            <a:extLst>
              <a:ext uri="{FF2B5EF4-FFF2-40B4-BE49-F238E27FC236}">
                <a16:creationId xmlns:a16="http://schemas.microsoft.com/office/drawing/2014/main" id="{E182122A-B932-48D7-A695-C7E1084770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0567" y="3340983"/>
            <a:ext cx="71209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7" name="Rectangle 37">
            <a:extLst>
              <a:ext uri="{FF2B5EF4-FFF2-40B4-BE49-F238E27FC236}">
                <a16:creationId xmlns:a16="http://schemas.microsoft.com/office/drawing/2014/main" id="{D2E15BBE-B88C-4367-9205-677B2509AB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5663" y="3304974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8" name="Rectangle 38">
            <a:extLst>
              <a:ext uri="{FF2B5EF4-FFF2-40B4-BE49-F238E27FC236}">
                <a16:creationId xmlns:a16="http://schemas.microsoft.com/office/drawing/2014/main" id="{DF81961A-5239-4365-9862-C3DBABDD4D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5663" y="3328980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9" name="Rectangle 39">
            <a:extLst>
              <a:ext uri="{FF2B5EF4-FFF2-40B4-BE49-F238E27FC236}">
                <a16:creationId xmlns:a16="http://schemas.microsoft.com/office/drawing/2014/main" id="{F7D6265D-D6A3-4B7C-A7D4-F6127C03F9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5663" y="3316977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0" name="Rectangle 40">
            <a:extLst>
              <a:ext uri="{FF2B5EF4-FFF2-40B4-BE49-F238E27FC236}">
                <a16:creationId xmlns:a16="http://schemas.microsoft.com/office/drawing/2014/main" id="{E9E3F90F-58BD-4AEF-9B1F-52F50AEEF1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5663" y="3316977"/>
            <a:ext cx="99362" cy="1200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1" name="Freeform 41">
            <a:extLst>
              <a:ext uri="{FF2B5EF4-FFF2-40B4-BE49-F238E27FC236}">
                <a16:creationId xmlns:a16="http://schemas.microsoft.com/office/drawing/2014/main" id="{03279474-0CF1-4F02-A93D-F57FC35EBD54}"/>
              </a:ext>
            </a:extLst>
          </p:cNvPr>
          <p:cNvSpPr>
            <a:spLocks/>
          </p:cNvSpPr>
          <p:nvPr/>
        </p:nvSpPr>
        <p:spPr bwMode="auto">
          <a:xfrm>
            <a:off x="1593625" y="1615977"/>
            <a:ext cx="5557647" cy="2909875"/>
          </a:xfrm>
          <a:custGeom>
            <a:avLst/>
            <a:gdLst>
              <a:gd name="T0" fmla="*/ 0 w 391"/>
              <a:gd name="T1" fmla="*/ 162 h 243"/>
              <a:gd name="T2" fmla="*/ 28 w 391"/>
              <a:gd name="T3" fmla="*/ 84 h 243"/>
              <a:gd name="T4" fmla="*/ 56 w 391"/>
              <a:gd name="T5" fmla="*/ 211 h 243"/>
              <a:gd name="T6" fmla="*/ 84 w 391"/>
              <a:gd name="T7" fmla="*/ 243 h 243"/>
              <a:gd name="T8" fmla="*/ 112 w 391"/>
              <a:gd name="T9" fmla="*/ 0 h 243"/>
              <a:gd name="T10" fmla="*/ 140 w 391"/>
              <a:gd name="T11" fmla="*/ 187 h 243"/>
              <a:gd name="T12" fmla="*/ 168 w 391"/>
              <a:gd name="T13" fmla="*/ 189 h 243"/>
              <a:gd name="T14" fmla="*/ 196 w 391"/>
              <a:gd name="T15" fmla="*/ 198 h 243"/>
              <a:gd name="T16" fmla="*/ 224 w 391"/>
              <a:gd name="T17" fmla="*/ 230 h 243"/>
              <a:gd name="T18" fmla="*/ 251 w 391"/>
              <a:gd name="T19" fmla="*/ 58 h 243"/>
              <a:gd name="T20" fmla="*/ 279 w 391"/>
              <a:gd name="T21" fmla="*/ 194 h 243"/>
              <a:gd name="T22" fmla="*/ 307 w 391"/>
              <a:gd name="T23" fmla="*/ 104 h 243"/>
              <a:gd name="T24" fmla="*/ 335 w 391"/>
              <a:gd name="T25" fmla="*/ 88 h 243"/>
              <a:gd name="T26" fmla="*/ 363 w 391"/>
              <a:gd name="T27" fmla="*/ 187 h 243"/>
              <a:gd name="T28" fmla="*/ 391 w 391"/>
              <a:gd name="T29" fmla="*/ 161 h 2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91" h="243">
                <a:moveTo>
                  <a:pt x="0" y="162"/>
                </a:moveTo>
                <a:lnTo>
                  <a:pt x="28" y="84"/>
                </a:lnTo>
                <a:lnTo>
                  <a:pt x="56" y="211"/>
                </a:lnTo>
                <a:lnTo>
                  <a:pt x="84" y="243"/>
                </a:lnTo>
                <a:lnTo>
                  <a:pt x="112" y="0"/>
                </a:lnTo>
                <a:lnTo>
                  <a:pt x="140" y="187"/>
                </a:lnTo>
                <a:lnTo>
                  <a:pt x="168" y="189"/>
                </a:lnTo>
                <a:lnTo>
                  <a:pt x="196" y="198"/>
                </a:lnTo>
                <a:lnTo>
                  <a:pt x="224" y="230"/>
                </a:lnTo>
                <a:lnTo>
                  <a:pt x="251" y="58"/>
                </a:lnTo>
                <a:lnTo>
                  <a:pt x="279" y="194"/>
                </a:lnTo>
                <a:lnTo>
                  <a:pt x="307" y="104"/>
                </a:lnTo>
                <a:lnTo>
                  <a:pt x="335" y="88"/>
                </a:lnTo>
                <a:lnTo>
                  <a:pt x="363" y="187"/>
                </a:lnTo>
                <a:lnTo>
                  <a:pt x="391" y="161"/>
                </a:lnTo>
              </a:path>
            </a:pathLst>
          </a:custGeom>
          <a:noFill/>
          <a:ln w="41275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2" name="Freeform 42">
            <a:extLst>
              <a:ext uri="{FF2B5EF4-FFF2-40B4-BE49-F238E27FC236}">
                <a16:creationId xmlns:a16="http://schemas.microsoft.com/office/drawing/2014/main" id="{CEE5B2D8-FADB-4986-8ED0-8B306C5E9A59}"/>
              </a:ext>
            </a:extLst>
          </p:cNvPr>
          <p:cNvSpPr>
            <a:spLocks noEditPoints="1"/>
          </p:cNvSpPr>
          <p:nvPr/>
        </p:nvSpPr>
        <p:spPr bwMode="auto">
          <a:xfrm>
            <a:off x="9567424" y="3411286"/>
            <a:ext cx="1945839" cy="612154"/>
          </a:xfrm>
          <a:custGeom>
            <a:avLst/>
            <a:gdLst>
              <a:gd name="T0" fmla="*/ 0 w 137"/>
              <a:gd name="T1" fmla="*/ 32 h 51"/>
              <a:gd name="T2" fmla="*/ 6 w 137"/>
              <a:gd name="T3" fmla="*/ 25 h 51"/>
              <a:gd name="T4" fmla="*/ 8 w 137"/>
              <a:gd name="T5" fmla="*/ 22 h 51"/>
              <a:gd name="T6" fmla="*/ 14 w 137"/>
              <a:gd name="T7" fmla="*/ 14 h 51"/>
              <a:gd name="T8" fmla="*/ 16 w 137"/>
              <a:gd name="T9" fmla="*/ 11 h 51"/>
              <a:gd name="T10" fmla="*/ 22 w 137"/>
              <a:gd name="T11" fmla="*/ 3 h 51"/>
              <a:gd name="T12" fmla="*/ 24 w 137"/>
              <a:gd name="T13" fmla="*/ 0 h 51"/>
              <a:gd name="T14" fmla="*/ 29 w 137"/>
              <a:gd name="T15" fmla="*/ 4 h 51"/>
              <a:gd name="T16" fmla="*/ 31 w 137"/>
              <a:gd name="T17" fmla="*/ 7 h 51"/>
              <a:gd name="T18" fmla="*/ 35 w 137"/>
              <a:gd name="T19" fmla="*/ 16 h 51"/>
              <a:gd name="T20" fmla="*/ 37 w 137"/>
              <a:gd name="T21" fmla="*/ 19 h 51"/>
              <a:gd name="T22" fmla="*/ 41 w 137"/>
              <a:gd name="T23" fmla="*/ 28 h 51"/>
              <a:gd name="T24" fmla="*/ 43 w 137"/>
              <a:gd name="T25" fmla="*/ 31 h 51"/>
              <a:gd name="T26" fmla="*/ 47 w 137"/>
              <a:gd name="T27" fmla="*/ 40 h 51"/>
              <a:gd name="T28" fmla="*/ 49 w 137"/>
              <a:gd name="T29" fmla="*/ 43 h 51"/>
              <a:gd name="T30" fmla="*/ 53 w 137"/>
              <a:gd name="T31" fmla="*/ 51 h 51"/>
              <a:gd name="T32" fmla="*/ 56 w 137"/>
              <a:gd name="T33" fmla="*/ 49 h 51"/>
              <a:gd name="T34" fmla="*/ 64 w 137"/>
              <a:gd name="T35" fmla="*/ 44 h 51"/>
              <a:gd name="T36" fmla="*/ 67 w 137"/>
              <a:gd name="T37" fmla="*/ 42 h 51"/>
              <a:gd name="T38" fmla="*/ 75 w 137"/>
              <a:gd name="T39" fmla="*/ 36 h 51"/>
              <a:gd name="T40" fmla="*/ 78 w 137"/>
              <a:gd name="T41" fmla="*/ 34 h 51"/>
              <a:gd name="T42" fmla="*/ 87 w 137"/>
              <a:gd name="T43" fmla="*/ 31 h 51"/>
              <a:gd name="T44" fmla="*/ 90 w 137"/>
              <a:gd name="T45" fmla="*/ 30 h 51"/>
              <a:gd name="T46" fmla="*/ 99 w 137"/>
              <a:gd name="T47" fmla="*/ 28 h 51"/>
              <a:gd name="T48" fmla="*/ 102 w 137"/>
              <a:gd name="T49" fmla="*/ 28 h 51"/>
              <a:gd name="T50" fmla="*/ 111 w 137"/>
              <a:gd name="T51" fmla="*/ 27 h 51"/>
              <a:gd name="T52" fmla="*/ 114 w 137"/>
              <a:gd name="T53" fmla="*/ 28 h 51"/>
              <a:gd name="T54" fmla="*/ 123 w 137"/>
              <a:gd name="T55" fmla="*/ 32 h 51"/>
              <a:gd name="T56" fmla="*/ 126 w 137"/>
              <a:gd name="T57" fmla="*/ 34 h 51"/>
              <a:gd name="T58" fmla="*/ 135 w 137"/>
              <a:gd name="T59" fmla="*/ 38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137" h="51">
                <a:moveTo>
                  <a:pt x="6" y="25"/>
                </a:moveTo>
                <a:lnTo>
                  <a:pt x="8" y="22"/>
                </a:lnTo>
                <a:moveTo>
                  <a:pt x="14" y="14"/>
                </a:moveTo>
                <a:lnTo>
                  <a:pt x="16" y="11"/>
                </a:lnTo>
                <a:moveTo>
                  <a:pt x="22" y="3"/>
                </a:moveTo>
                <a:lnTo>
                  <a:pt x="24" y="0"/>
                </a:lnTo>
                <a:moveTo>
                  <a:pt x="29" y="4"/>
                </a:moveTo>
                <a:lnTo>
                  <a:pt x="31" y="7"/>
                </a:lnTo>
                <a:moveTo>
                  <a:pt x="35" y="16"/>
                </a:moveTo>
                <a:lnTo>
                  <a:pt x="37" y="19"/>
                </a:lnTo>
                <a:moveTo>
                  <a:pt x="41" y="28"/>
                </a:moveTo>
                <a:lnTo>
                  <a:pt x="43" y="31"/>
                </a:lnTo>
                <a:moveTo>
                  <a:pt x="47" y="40"/>
                </a:moveTo>
                <a:lnTo>
                  <a:pt x="49" y="43"/>
                </a:lnTo>
                <a:moveTo>
                  <a:pt x="53" y="51"/>
                </a:moveTo>
                <a:lnTo>
                  <a:pt x="56" y="49"/>
                </a:lnTo>
                <a:moveTo>
                  <a:pt x="64" y="44"/>
                </a:moveTo>
                <a:lnTo>
                  <a:pt x="67" y="42"/>
                </a:lnTo>
                <a:moveTo>
                  <a:pt x="75" y="36"/>
                </a:moveTo>
                <a:lnTo>
                  <a:pt x="78" y="34"/>
                </a:lnTo>
                <a:moveTo>
                  <a:pt x="87" y="31"/>
                </a:moveTo>
                <a:lnTo>
                  <a:pt x="90" y="30"/>
                </a:lnTo>
                <a:moveTo>
                  <a:pt x="99" y="28"/>
                </a:moveTo>
                <a:lnTo>
                  <a:pt x="102" y="28"/>
                </a:lnTo>
                <a:moveTo>
                  <a:pt x="111" y="27"/>
                </a:moveTo>
                <a:lnTo>
                  <a:pt x="114" y="28"/>
                </a:lnTo>
                <a:moveTo>
                  <a:pt x="123" y="32"/>
                </a:moveTo>
                <a:lnTo>
                  <a:pt x="126" y="34"/>
                </a:lnTo>
                <a:moveTo>
                  <a:pt x="135" y="38"/>
                </a:moveTo>
              </a:path>
            </a:pathLst>
          </a:custGeom>
          <a:noFill/>
          <a:ln w="41275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3" name="Rectangle 43">
            <a:extLst>
              <a:ext uri="{FF2B5EF4-FFF2-40B4-BE49-F238E27FC236}">
                <a16:creationId xmlns:a16="http://schemas.microsoft.com/office/drawing/2014/main" id="{0F659C44-933D-4050-8A52-E0A9A6F20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6368" y="3507310"/>
            <a:ext cx="43057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4" name="Rectangle 44">
            <a:extLst>
              <a:ext uri="{FF2B5EF4-FFF2-40B4-BE49-F238E27FC236}">
                <a16:creationId xmlns:a16="http://schemas.microsoft.com/office/drawing/2014/main" id="{A21026C7-F2B6-496A-8157-A9D6B11205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6368" y="3579328"/>
            <a:ext cx="43057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5" name="Rectangle 45">
            <a:extLst>
              <a:ext uri="{FF2B5EF4-FFF2-40B4-BE49-F238E27FC236}">
                <a16:creationId xmlns:a16="http://schemas.microsoft.com/office/drawing/2014/main" id="{FBACEA72-8B06-4EF4-A68D-72F86DF512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1464" y="3519313"/>
            <a:ext cx="71209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6" name="Rectangle 46">
            <a:extLst>
              <a:ext uri="{FF2B5EF4-FFF2-40B4-BE49-F238E27FC236}">
                <a16:creationId xmlns:a16="http://schemas.microsoft.com/office/drawing/2014/main" id="{79AB325E-2F4B-4F90-B633-00936CCCC6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1464" y="3567325"/>
            <a:ext cx="71209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7" name="Rectangle 47">
            <a:extLst>
              <a:ext uri="{FF2B5EF4-FFF2-40B4-BE49-F238E27FC236}">
                <a16:creationId xmlns:a16="http://schemas.microsoft.com/office/drawing/2014/main" id="{DBE0A7A4-4143-4D18-8FEB-5F0D98EA47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8215" y="3531316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8" name="Rectangle 48">
            <a:extLst>
              <a:ext uri="{FF2B5EF4-FFF2-40B4-BE49-F238E27FC236}">
                <a16:creationId xmlns:a16="http://schemas.microsoft.com/office/drawing/2014/main" id="{C0DD9524-5D8B-476D-AAC0-BFF1F06CA8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8215" y="3555322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9" name="Rectangle 49">
            <a:extLst>
              <a:ext uri="{FF2B5EF4-FFF2-40B4-BE49-F238E27FC236}">
                <a16:creationId xmlns:a16="http://schemas.microsoft.com/office/drawing/2014/main" id="{8587000D-4182-4F9F-A4AA-6B3CE8C67E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8215" y="3543319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0" name="Rectangle 50">
            <a:extLst>
              <a:ext uri="{FF2B5EF4-FFF2-40B4-BE49-F238E27FC236}">
                <a16:creationId xmlns:a16="http://schemas.microsoft.com/office/drawing/2014/main" id="{387BC2DC-A700-4245-88E4-5089A48F85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08215" y="3543319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1" name="Rectangle 51">
            <a:extLst>
              <a:ext uri="{FF2B5EF4-FFF2-40B4-BE49-F238E27FC236}">
                <a16:creationId xmlns:a16="http://schemas.microsoft.com/office/drawing/2014/main" id="{CED38510-A647-4B92-8F2F-4BA10F6FE2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4367" y="3795383"/>
            <a:ext cx="43057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2" name="Rectangle 52">
            <a:extLst>
              <a:ext uri="{FF2B5EF4-FFF2-40B4-BE49-F238E27FC236}">
                <a16:creationId xmlns:a16="http://schemas.microsoft.com/office/drawing/2014/main" id="{B6D84014-6BA5-490B-8846-160F468F60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4367" y="3867401"/>
            <a:ext cx="43057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3" name="Rectangle 53">
            <a:extLst>
              <a:ext uri="{FF2B5EF4-FFF2-40B4-BE49-F238E27FC236}">
                <a16:creationId xmlns:a16="http://schemas.microsoft.com/office/drawing/2014/main" id="{D56FE97A-CEFB-4F2E-A08E-B6ED4FF3E7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09463" y="3807386"/>
            <a:ext cx="71209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4" name="Rectangle 54">
            <a:extLst>
              <a:ext uri="{FF2B5EF4-FFF2-40B4-BE49-F238E27FC236}">
                <a16:creationId xmlns:a16="http://schemas.microsoft.com/office/drawing/2014/main" id="{C244B0FB-A9AE-4B54-B019-1C11ECA763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09463" y="3855398"/>
            <a:ext cx="71209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5" name="Rectangle 55">
            <a:extLst>
              <a:ext uri="{FF2B5EF4-FFF2-40B4-BE49-F238E27FC236}">
                <a16:creationId xmlns:a16="http://schemas.microsoft.com/office/drawing/2014/main" id="{19E3340B-AAAB-45A9-8098-28238742BF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6215" y="3819389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6" name="Rectangle 56">
            <a:extLst>
              <a:ext uri="{FF2B5EF4-FFF2-40B4-BE49-F238E27FC236}">
                <a16:creationId xmlns:a16="http://schemas.microsoft.com/office/drawing/2014/main" id="{D94CFB30-DF91-4CE3-9313-E99A53784A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6215" y="3843395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7" name="Rectangle 57">
            <a:extLst>
              <a:ext uri="{FF2B5EF4-FFF2-40B4-BE49-F238E27FC236}">
                <a16:creationId xmlns:a16="http://schemas.microsoft.com/office/drawing/2014/main" id="{F6AF3E8F-7EAF-407C-AA4C-F71CF757BA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6215" y="3831392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8" name="Rectangle 58">
            <a:extLst>
              <a:ext uri="{FF2B5EF4-FFF2-40B4-BE49-F238E27FC236}">
                <a16:creationId xmlns:a16="http://schemas.microsoft.com/office/drawing/2014/main" id="{3EF167A5-744D-4DD6-8D4B-C51A4424EE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96215" y="3831392"/>
            <a:ext cx="99362" cy="1200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9" name="Freeform 59">
            <a:extLst>
              <a:ext uri="{FF2B5EF4-FFF2-40B4-BE49-F238E27FC236}">
                <a16:creationId xmlns:a16="http://schemas.microsoft.com/office/drawing/2014/main" id="{EC0D2604-CF97-4E98-AE6B-C0C7A5C84D35}"/>
              </a:ext>
            </a:extLst>
          </p:cNvPr>
          <p:cNvSpPr>
            <a:spLocks/>
          </p:cNvSpPr>
          <p:nvPr/>
        </p:nvSpPr>
        <p:spPr bwMode="auto">
          <a:xfrm>
            <a:off x="1593625" y="3124928"/>
            <a:ext cx="2388000" cy="442397"/>
          </a:xfrm>
          <a:custGeom>
            <a:avLst/>
            <a:gdLst>
              <a:gd name="T0" fmla="*/ 0 w 168"/>
              <a:gd name="T1" fmla="*/ 37 h 37"/>
              <a:gd name="T2" fmla="*/ 28 w 168"/>
              <a:gd name="T3" fmla="*/ 13 h 37"/>
              <a:gd name="T4" fmla="*/ 56 w 168"/>
              <a:gd name="T5" fmla="*/ 8 h 37"/>
              <a:gd name="T6" fmla="*/ 84 w 168"/>
              <a:gd name="T7" fmla="*/ 8 h 37"/>
              <a:gd name="T8" fmla="*/ 112 w 168"/>
              <a:gd name="T9" fmla="*/ 0 h 37"/>
              <a:gd name="T10" fmla="*/ 140 w 168"/>
              <a:gd name="T11" fmla="*/ 7 h 37"/>
              <a:gd name="T12" fmla="*/ 168 w 168"/>
              <a:gd name="T13" fmla="*/ 1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8" h="37">
                <a:moveTo>
                  <a:pt x="0" y="37"/>
                </a:moveTo>
                <a:lnTo>
                  <a:pt x="28" y="13"/>
                </a:lnTo>
                <a:lnTo>
                  <a:pt x="56" y="8"/>
                </a:lnTo>
                <a:lnTo>
                  <a:pt x="84" y="8"/>
                </a:lnTo>
                <a:lnTo>
                  <a:pt x="112" y="0"/>
                </a:lnTo>
                <a:lnTo>
                  <a:pt x="140" y="7"/>
                </a:lnTo>
                <a:lnTo>
                  <a:pt x="168" y="1"/>
                </a:lnTo>
              </a:path>
            </a:pathLst>
          </a:custGeom>
          <a:noFill/>
          <a:ln w="4127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0" name="Freeform 60">
            <a:extLst>
              <a:ext uri="{FF2B5EF4-FFF2-40B4-BE49-F238E27FC236}">
                <a16:creationId xmlns:a16="http://schemas.microsoft.com/office/drawing/2014/main" id="{82E252A2-FC2C-4A11-A29B-E6A30A816133}"/>
              </a:ext>
            </a:extLst>
          </p:cNvPr>
          <p:cNvSpPr>
            <a:spLocks noEditPoints="1"/>
          </p:cNvSpPr>
          <p:nvPr/>
        </p:nvSpPr>
        <p:spPr bwMode="auto">
          <a:xfrm>
            <a:off x="6397777" y="2764838"/>
            <a:ext cx="5115486" cy="528133"/>
          </a:xfrm>
          <a:custGeom>
            <a:avLst/>
            <a:gdLst>
              <a:gd name="T0" fmla="*/ 9 w 360"/>
              <a:gd name="T1" fmla="*/ 27 h 44"/>
              <a:gd name="T2" fmla="*/ 21 w 360"/>
              <a:gd name="T3" fmla="*/ 23 h 44"/>
              <a:gd name="T4" fmla="*/ 33 w 360"/>
              <a:gd name="T5" fmla="*/ 21 h 44"/>
              <a:gd name="T6" fmla="*/ 45 w 360"/>
              <a:gd name="T7" fmla="*/ 18 h 44"/>
              <a:gd name="T8" fmla="*/ 57 w 360"/>
              <a:gd name="T9" fmla="*/ 17 h 44"/>
              <a:gd name="T10" fmla="*/ 69 w 360"/>
              <a:gd name="T11" fmla="*/ 15 h 44"/>
              <a:gd name="T12" fmla="*/ 81 w 360"/>
              <a:gd name="T13" fmla="*/ 14 h 44"/>
              <a:gd name="T14" fmla="*/ 93 w 360"/>
              <a:gd name="T15" fmla="*/ 17 h 44"/>
              <a:gd name="T16" fmla="*/ 105 w 360"/>
              <a:gd name="T17" fmla="*/ 21 h 44"/>
              <a:gd name="T18" fmla="*/ 116 w 360"/>
              <a:gd name="T19" fmla="*/ 18 h 44"/>
              <a:gd name="T20" fmla="*/ 127 w 360"/>
              <a:gd name="T21" fmla="*/ 10 h 44"/>
              <a:gd name="T22" fmla="*/ 137 w 360"/>
              <a:gd name="T23" fmla="*/ 4 h 44"/>
              <a:gd name="T24" fmla="*/ 149 w 360"/>
              <a:gd name="T25" fmla="*/ 6 h 44"/>
              <a:gd name="T26" fmla="*/ 161 w 360"/>
              <a:gd name="T27" fmla="*/ 7 h 44"/>
              <a:gd name="T28" fmla="*/ 173 w 360"/>
              <a:gd name="T29" fmla="*/ 8 h 44"/>
              <a:gd name="T30" fmla="*/ 185 w 360"/>
              <a:gd name="T31" fmla="*/ 7 h 44"/>
              <a:gd name="T32" fmla="*/ 196 w 360"/>
              <a:gd name="T33" fmla="*/ 11 h 44"/>
              <a:gd name="T34" fmla="*/ 204 w 360"/>
              <a:gd name="T35" fmla="*/ 21 h 44"/>
              <a:gd name="T36" fmla="*/ 212 w 360"/>
              <a:gd name="T37" fmla="*/ 32 h 44"/>
              <a:gd name="T38" fmla="*/ 220 w 360"/>
              <a:gd name="T39" fmla="*/ 43 h 44"/>
              <a:gd name="T40" fmla="*/ 222 w 360"/>
              <a:gd name="T41" fmla="*/ 43 h 44"/>
              <a:gd name="T42" fmla="*/ 231 w 360"/>
              <a:gd name="T43" fmla="*/ 33 h 44"/>
              <a:gd name="T44" fmla="*/ 239 w 360"/>
              <a:gd name="T45" fmla="*/ 23 h 44"/>
              <a:gd name="T46" fmla="*/ 248 w 360"/>
              <a:gd name="T47" fmla="*/ 13 h 44"/>
              <a:gd name="T48" fmla="*/ 259 w 360"/>
              <a:gd name="T49" fmla="*/ 8 h 44"/>
              <a:gd name="T50" fmla="*/ 271 w 360"/>
              <a:gd name="T51" fmla="*/ 2 h 44"/>
              <a:gd name="T52" fmla="*/ 282 w 360"/>
              <a:gd name="T53" fmla="*/ 4 h 44"/>
              <a:gd name="T54" fmla="*/ 293 w 360"/>
              <a:gd name="T55" fmla="*/ 12 h 44"/>
              <a:gd name="T56" fmla="*/ 304 w 360"/>
              <a:gd name="T57" fmla="*/ 19 h 44"/>
              <a:gd name="T58" fmla="*/ 313 w 360"/>
              <a:gd name="T59" fmla="*/ 17 h 44"/>
              <a:gd name="T60" fmla="*/ 325 w 360"/>
              <a:gd name="T61" fmla="*/ 15 h 44"/>
              <a:gd name="T62" fmla="*/ 337 w 360"/>
              <a:gd name="T63" fmla="*/ 11 h 44"/>
              <a:gd name="T64" fmla="*/ 349 w 360"/>
              <a:gd name="T65" fmla="*/ 5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</a:cxnLst>
            <a:rect l="0" t="0" r="r" b="b"/>
            <a:pathLst>
              <a:path w="360" h="44">
                <a:moveTo>
                  <a:pt x="9" y="27"/>
                </a:moveTo>
                <a:lnTo>
                  <a:pt x="12" y="26"/>
                </a:lnTo>
                <a:moveTo>
                  <a:pt x="21" y="23"/>
                </a:moveTo>
                <a:lnTo>
                  <a:pt x="24" y="22"/>
                </a:lnTo>
                <a:moveTo>
                  <a:pt x="33" y="21"/>
                </a:moveTo>
                <a:lnTo>
                  <a:pt x="36" y="20"/>
                </a:lnTo>
                <a:moveTo>
                  <a:pt x="45" y="18"/>
                </a:moveTo>
                <a:lnTo>
                  <a:pt x="48" y="18"/>
                </a:lnTo>
                <a:moveTo>
                  <a:pt x="57" y="17"/>
                </a:moveTo>
                <a:lnTo>
                  <a:pt x="60" y="16"/>
                </a:lnTo>
                <a:moveTo>
                  <a:pt x="69" y="15"/>
                </a:moveTo>
                <a:lnTo>
                  <a:pt x="72" y="15"/>
                </a:lnTo>
                <a:moveTo>
                  <a:pt x="81" y="14"/>
                </a:moveTo>
                <a:lnTo>
                  <a:pt x="84" y="15"/>
                </a:lnTo>
                <a:moveTo>
                  <a:pt x="93" y="17"/>
                </a:moveTo>
                <a:lnTo>
                  <a:pt x="96" y="18"/>
                </a:lnTo>
                <a:moveTo>
                  <a:pt x="105" y="21"/>
                </a:moveTo>
                <a:lnTo>
                  <a:pt x="108" y="22"/>
                </a:lnTo>
                <a:moveTo>
                  <a:pt x="116" y="18"/>
                </a:moveTo>
                <a:lnTo>
                  <a:pt x="119" y="16"/>
                </a:lnTo>
                <a:moveTo>
                  <a:pt x="127" y="10"/>
                </a:moveTo>
                <a:lnTo>
                  <a:pt x="130" y="9"/>
                </a:lnTo>
                <a:moveTo>
                  <a:pt x="137" y="4"/>
                </a:moveTo>
                <a:lnTo>
                  <a:pt x="140" y="4"/>
                </a:lnTo>
                <a:moveTo>
                  <a:pt x="149" y="6"/>
                </a:moveTo>
                <a:lnTo>
                  <a:pt x="152" y="6"/>
                </a:lnTo>
                <a:moveTo>
                  <a:pt x="161" y="7"/>
                </a:moveTo>
                <a:lnTo>
                  <a:pt x="164" y="8"/>
                </a:lnTo>
                <a:moveTo>
                  <a:pt x="173" y="8"/>
                </a:moveTo>
                <a:lnTo>
                  <a:pt x="176" y="8"/>
                </a:lnTo>
                <a:moveTo>
                  <a:pt x="185" y="7"/>
                </a:moveTo>
                <a:lnTo>
                  <a:pt x="188" y="7"/>
                </a:lnTo>
                <a:moveTo>
                  <a:pt x="196" y="11"/>
                </a:moveTo>
                <a:lnTo>
                  <a:pt x="198" y="14"/>
                </a:lnTo>
                <a:moveTo>
                  <a:pt x="204" y="21"/>
                </a:moveTo>
                <a:lnTo>
                  <a:pt x="206" y="24"/>
                </a:lnTo>
                <a:moveTo>
                  <a:pt x="212" y="32"/>
                </a:moveTo>
                <a:lnTo>
                  <a:pt x="214" y="35"/>
                </a:lnTo>
                <a:moveTo>
                  <a:pt x="220" y="43"/>
                </a:moveTo>
                <a:lnTo>
                  <a:pt x="221" y="44"/>
                </a:lnTo>
                <a:lnTo>
                  <a:pt x="222" y="43"/>
                </a:lnTo>
                <a:moveTo>
                  <a:pt x="228" y="36"/>
                </a:moveTo>
                <a:lnTo>
                  <a:pt x="231" y="33"/>
                </a:lnTo>
                <a:moveTo>
                  <a:pt x="237" y="26"/>
                </a:moveTo>
                <a:lnTo>
                  <a:pt x="239" y="23"/>
                </a:lnTo>
                <a:moveTo>
                  <a:pt x="245" y="16"/>
                </a:moveTo>
                <a:lnTo>
                  <a:pt x="248" y="13"/>
                </a:lnTo>
                <a:moveTo>
                  <a:pt x="256" y="9"/>
                </a:moveTo>
                <a:lnTo>
                  <a:pt x="259" y="8"/>
                </a:lnTo>
                <a:moveTo>
                  <a:pt x="268" y="4"/>
                </a:moveTo>
                <a:lnTo>
                  <a:pt x="271" y="2"/>
                </a:lnTo>
                <a:moveTo>
                  <a:pt x="279" y="2"/>
                </a:moveTo>
                <a:lnTo>
                  <a:pt x="282" y="4"/>
                </a:lnTo>
                <a:moveTo>
                  <a:pt x="290" y="9"/>
                </a:moveTo>
                <a:lnTo>
                  <a:pt x="293" y="12"/>
                </a:lnTo>
                <a:moveTo>
                  <a:pt x="301" y="17"/>
                </a:moveTo>
                <a:lnTo>
                  <a:pt x="304" y="19"/>
                </a:lnTo>
                <a:lnTo>
                  <a:pt x="304" y="19"/>
                </a:lnTo>
                <a:moveTo>
                  <a:pt x="313" y="17"/>
                </a:moveTo>
                <a:lnTo>
                  <a:pt x="316" y="16"/>
                </a:lnTo>
                <a:moveTo>
                  <a:pt x="325" y="15"/>
                </a:moveTo>
                <a:lnTo>
                  <a:pt x="328" y="14"/>
                </a:lnTo>
                <a:moveTo>
                  <a:pt x="337" y="11"/>
                </a:moveTo>
                <a:lnTo>
                  <a:pt x="340" y="9"/>
                </a:lnTo>
                <a:moveTo>
                  <a:pt x="349" y="5"/>
                </a:moveTo>
                <a:lnTo>
                  <a:pt x="352" y="4"/>
                </a:lnTo>
              </a:path>
            </a:pathLst>
          </a:custGeom>
          <a:noFill/>
          <a:ln w="4127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1" name="Rectangle 61">
            <a:extLst>
              <a:ext uri="{FF2B5EF4-FFF2-40B4-BE49-F238E27FC236}">
                <a16:creationId xmlns:a16="http://schemas.microsoft.com/office/drawing/2014/main" id="{8EB279C4-C9DD-488F-AD49-369FED3785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6721" y="3100922"/>
            <a:ext cx="43057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2" name="Rectangle 62">
            <a:extLst>
              <a:ext uri="{FF2B5EF4-FFF2-40B4-BE49-F238E27FC236}">
                <a16:creationId xmlns:a16="http://schemas.microsoft.com/office/drawing/2014/main" id="{405D4492-9A5F-451A-A0FF-5BDB8FAA8D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6721" y="3172940"/>
            <a:ext cx="43057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3" name="Rectangle 63">
            <a:extLst>
              <a:ext uri="{FF2B5EF4-FFF2-40B4-BE49-F238E27FC236}">
                <a16:creationId xmlns:a16="http://schemas.microsoft.com/office/drawing/2014/main" id="{D668FD34-7FDD-4435-8798-DBAB9D7C17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1816" y="3112925"/>
            <a:ext cx="71209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4" name="Rectangle 64">
            <a:extLst>
              <a:ext uri="{FF2B5EF4-FFF2-40B4-BE49-F238E27FC236}">
                <a16:creationId xmlns:a16="http://schemas.microsoft.com/office/drawing/2014/main" id="{7AC714CF-0B43-40D0-943A-152437D9F9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1816" y="3160937"/>
            <a:ext cx="71209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5" name="Rectangle 65">
            <a:extLst>
              <a:ext uri="{FF2B5EF4-FFF2-40B4-BE49-F238E27FC236}">
                <a16:creationId xmlns:a16="http://schemas.microsoft.com/office/drawing/2014/main" id="{A87F7A7D-228F-4D1D-AD90-A0A5A692BD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8568" y="3124928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6" name="Rectangle 66">
            <a:extLst>
              <a:ext uri="{FF2B5EF4-FFF2-40B4-BE49-F238E27FC236}">
                <a16:creationId xmlns:a16="http://schemas.microsoft.com/office/drawing/2014/main" id="{43E17903-D87B-4E44-8576-5D444AE12A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8568" y="3148934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7" name="Rectangle 67">
            <a:extLst>
              <a:ext uri="{FF2B5EF4-FFF2-40B4-BE49-F238E27FC236}">
                <a16:creationId xmlns:a16="http://schemas.microsoft.com/office/drawing/2014/main" id="{486EC525-B3B6-4279-9AAA-D4A62BD285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8568" y="3136931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8" name="Rectangle 68">
            <a:extLst>
              <a:ext uri="{FF2B5EF4-FFF2-40B4-BE49-F238E27FC236}">
                <a16:creationId xmlns:a16="http://schemas.microsoft.com/office/drawing/2014/main" id="{865AD6F3-DC04-4F4E-9416-811F913B9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8568" y="3136931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9" name="Rectangle 69">
            <a:extLst>
              <a:ext uri="{FF2B5EF4-FFF2-40B4-BE49-F238E27FC236}">
                <a16:creationId xmlns:a16="http://schemas.microsoft.com/office/drawing/2014/main" id="{166810BF-8094-40A3-B571-755EBCCD4A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9816" y="3088919"/>
            <a:ext cx="43057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0" name="Rectangle 70">
            <a:extLst>
              <a:ext uri="{FF2B5EF4-FFF2-40B4-BE49-F238E27FC236}">
                <a16:creationId xmlns:a16="http://schemas.microsoft.com/office/drawing/2014/main" id="{C7EC9F79-C192-4401-8862-89C11CC674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9816" y="3160937"/>
            <a:ext cx="43057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1" name="Rectangle 71">
            <a:extLst>
              <a:ext uri="{FF2B5EF4-FFF2-40B4-BE49-F238E27FC236}">
                <a16:creationId xmlns:a16="http://schemas.microsoft.com/office/drawing/2014/main" id="{1B409BB3-1218-48A7-9DD1-0146BE68A7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6568" y="3100922"/>
            <a:ext cx="71209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2" name="Rectangle 72">
            <a:extLst>
              <a:ext uri="{FF2B5EF4-FFF2-40B4-BE49-F238E27FC236}">
                <a16:creationId xmlns:a16="http://schemas.microsoft.com/office/drawing/2014/main" id="{31C4EC42-61EE-46A5-851E-AD410724D2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6568" y="3148934"/>
            <a:ext cx="71209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3" name="Rectangle 73">
            <a:extLst>
              <a:ext uri="{FF2B5EF4-FFF2-40B4-BE49-F238E27FC236}">
                <a16:creationId xmlns:a16="http://schemas.microsoft.com/office/drawing/2014/main" id="{6C8D4494-6347-4D03-B0AB-600C76F82F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112925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4" name="Rectangle 74">
            <a:extLst>
              <a:ext uri="{FF2B5EF4-FFF2-40B4-BE49-F238E27FC236}">
                <a16:creationId xmlns:a16="http://schemas.microsoft.com/office/drawing/2014/main" id="{1403FE12-DAA3-4819-8607-0E47B478B1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136931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5" name="Rectangle 75">
            <a:extLst>
              <a:ext uri="{FF2B5EF4-FFF2-40B4-BE49-F238E27FC236}">
                <a16:creationId xmlns:a16="http://schemas.microsoft.com/office/drawing/2014/main" id="{EE906E71-A09A-4868-AAA0-F363766AAE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124928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6" name="Rectangle 76">
            <a:extLst>
              <a:ext uri="{FF2B5EF4-FFF2-40B4-BE49-F238E27FC236}">
                <a16:creationId xmlns:a16="http://schemas.microsoft.com/office/drawing/2014/main" id="{A364067D-00CB-478D-9CAF-7EE189FB7D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124928"/>
            <a:ext cx="99362" cy="1200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7" name="Freeform 77">
            <a:extLst>
              <a:ext uri="{FF2B5EF4-FFF2-40B4-BE49-F238E27FC236}">
                <a16:creationId xmlns:a16="http://schemas.microsoft.com/office/drawing/2014/main" id="{E8067316-444A-49F7-9836-0FC9FF67B1BB}"/>
              </a:ext>
            </a:extLst>
          </p:cNvPr>
          <p:cNvSpPr>
            <a:spLocks/>
          </p:cNvSpPr>
          <p:nvPr/>
        </p:nvSpPr>
        <p:spPr bwMode="auto">
          <a:xfrm>
            <a:off x="1593625" y="2872865"/>
            <a:ext cx="4761095" cy="1066554"/>
          </a:xfrm>
          <a:custGeom>
            <a:avLst/>
            <a:gdLst>
              <a:gd name="T0" fmla="*/ 0 w 335"/>
              <a:gd name="T1" fmla="*/ 44 h 89"/>
              <a:gd name="T2" fmla="*/ 28 w 335"/>
              <a:gd name="T3" fmla="*/ 73 h 89"/>
              <a:gd name="T4" fmla="*/ 56 w 335"/>
              <a:gd name="T5" fmla="*/ 0 h 89"/>
              <a:gd name="T6" fmla="*/ 84 w 335"/>
              <a:gd name="T7" fmla="*/ 12 h 89"/>
              <a:gd name="T8" fmla="*/ 112 w 335"/>
              <a:gd name="T9" fmla="*/ 65 h 89"/>
              <a:gd name="T10" fmla="*/ 140 w 335"/>
              <a:gd name="T11" fmla="*/ 21 h 89"/>
              <a:gd name="T12" fmla="*/ 168 w 335"/>
              <a:gd name="T13" fmla="*/ 61 h 89"/>
              <a:gd name="T14" fmla="*/ 196 w 335"/>
              <a:gd name="T15" fmla="*/ 7 h 89"/>
              <a:gd name="T16" fmla="*/ 224 w 335"/>
              <a:gd name="T17" fmla="*/ 36 h 89"/>
              <a:gd name="T18" fmla="*/ 251 w 335"/>
              <a:gd name="T19" fmla="*/ 89 h 89"/>
              <a:gd name="T20" fmla="*/ 279 w 335"/>
              <a:gd name="T21" fmla="*/ 4 h 89"/>
              <a:gd name="T22" fmla="*/ 307 w 335"/>
              <a:gd name="T23" fmla="*/ 49 h 89"/>
              <a:gd name="T24" fmla="*/ 335 w 335"/>
              <a:gd name="T25" fmla="*/ 48 h 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335" h="89">
                <a:moveTo>
                  <a:pt x="0" y="44"/>
                </a:moveTo>
                <a:lnTo>
                  <a:pt x="28" y="73"/>
                </a:lnTo>
                <a:lnTo>
                  <a:pt x="56" y="0"/>
                </a:lnTo>
                <a:lnTo>
                  <a:pt x="84" y="12"/>
                </a:lnTo>
                <a:lnTo>
                  <a:pt x="112" y="65"/>
                </a:lnTo>
                <a:lnTo>
                  <a:pt x="140" y="21"/>
                </a:lnTo>
                <a:lnTo>
                  <a:pt x="168" y="61"/>
                </a:lnTo>
                <a:lnTo>
                  <a:pt x="196" y="7"/>
                </a:lnTo>
                <a:lnTo>
                  <a:pt x="224" y="36"/>
                </a:lnTo>
                <a:lnTo>
                  <a:pt x="251" y="89"/>
                </a:lnTo>
                <a:lnTo>
                  <a:pt x="279" y="4"/>
                </a:lnTo>
                <a:lnTo>
                  <a:pt x="307" y="49"/>
                </a:lnTo>
                <a:lnTo>
                  <a:pt x="335" y="48"/>
                </a:lnTo>
              </a:path>
            </a:pathLst>
          </a:custGeom>
          <a:noFill/>
          <a:ln w="41275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8" name="Freeform 78">
            <a:extLst>
              <a:ext uri="{FF2B5EF4-FFF2-40B4-BE49-F238E27FC236}">
                <a16:creationId xmlns:a16="http://schemas.microsoft.com/office/drawing/2014/main" id="{40DD9220-BBFA-4052-A697-071B3F1BD64C}"/>
              </a:ext>
            </a:extLst>
          </p:cNvPr>
          <p:cNvSpPr>
            <a:spLocks noEditPoints="1"/>
          </p:cNvSpPr>
          <p:nvPr/>
        </p:nvSpPr>
        <p:spPr bwMode="auto">
          <a:xfrm>
            <a:off x="8373424" y="2466477"/>
            <a:ext cx="3139839" cy="826494"/>
          </a:xfrm>
          <a:custGeom>
            <a:avLst/>
            <a:gdLst>
              <a:gd name="T0" fmla="*/ 0 w 221"/>
              <a:gd name="T1" fmla="*/ 38 h 69"/>
              <a:gd name="T2" fmla="*/ 6 w 221"/>
              <a:gd name="T3" fmla="*/ 45 h 69"/>
              <a:gd name="T4" fmla="*/ 8 w 221"/>
              <a:gd name="T5" fmla="*/ 48 h 69"/>
              <a:gd name="T6" fmla="*/ 14 w 221"/>
              <a:gd name="T7" fmla="*/ 55 h 69"/>
              <a:gd name="T8" fmla="*/ 16 w 221"/>
              <a:gd name="T9" fmla="*/ 58 h 69"/>
              <a:gd name="T10" fmla="*/ 22 w 221"/>
              <a:gd name="T11" fmla="*/ 65 h 69"/>
              <a:gd name="T12" fmla="*/ 24 w 221"/>
              <a:gd name="T13" fmla="*/ 68 h 69"/>
              <a:gd name="T14" fmla="*/ 33 w 221"/>
              <a:gd name="T15" fmla="*/ 69 h 69"/>
              <a:gd name="T16" fmla="*/ 36 w 221"/>
              <a:gd name="T17" fmla="*/ 69 h 69"/>
              <a:gd name="T18" fmla="*/ 45 w 221"/>
              <a:gd name="T19" fmla="*/ 67 h 69"/>
              <a:gd name="T20" fmla="*/ 48 w 221"/>
              <a:gd name="T21" fmla="*/ 67 h 69"/>
              <a:gd name="T22" fmla="*/ 57 w 221"/>
              <a:gd name="T23" fmla="*/ 65 h 69"/>
              <a:gd name="T24" fmla="*/ 60 w 221"/>
              <a:gd name="T25" fmla="*/ 64 h 69"/>
              <a:gd name="T26" fmla="*/ 69 w 221"/>
              <a:gd name="T27" fmla="*/ 61 h 69"/>
              <a:gd name="T28" fmla="*/ 72 w 221"/>
              <a:gd name="T29" fmla="*/ 60 h 69"/>
              <a:gd name="T30" fmla="*/ 81 w 221"/>
              <a:gd name="T31" fmla="*/ 57 h 69"/>
              <a:gd name="T32" fmla="*/ 82 w 221"/>
              <a:gd name="T33" fmla="*/ 57 h 69"/>
              <a:gd name="T34" fmla="*/ 83 w 221"/>
              <a:gd name="T35" fmla="*/ 55 h 69"/>
              <a:gd name="T36" fmla="*/ 88 w 221"/>
              <a:gd name="T37" fmla="*/ 47 h 69"/>
              <a:gd name="T38" fmla="*/ 90 w 221"/>
              <a:gd name="T39" fmla="*/ 44 h 69"/>
              <a:gd name="T40" fmla="*/ 95 w 221"/>
              <a:gd name="T41" fmla="*/ 36 h 69"/>
              <a:gd name="T42" fmla="*/ 97 w 221"/>
              <a:gd name="T43" fmla="*/ 33 h 69"/>
              <a:gd name="T44" fmla="*/ 102 w 221"/>
              <a:gd name="T45" fmla="*/ 25 h 69"/>
              <a:gd name="T46" fmla="*/ 104 w 221"/>
              <a:gd name="T47" fmla="*/ 22 h 69"/>
              <a:gd name="T48" fmla="*/ 109 w 221"/>
              <a:gd name="T49" fmla="*/ 14 h 69"/>
              <a:gd name="T50" fmla="*/ 110 w 221"/>
              <a:gd name="T51" fmla="*/ 13 h 69"/>
              <a:gd name="T52" fmla="*/ 112 w 221"/>
              <a:gd name="T53" fmla="*/ 12 h 69"/>
              <a:gd name="T54" fmla="*/ 121 w 221"/>
              <a:gd name="T55" fmla="*/ 8 h 69"/>
              <a:gd name="T56" fmla="*/ 124 w 221"/>
              <a:gd name="T57" fmla="*/ 6 h 69"/>
              <a:gd name="T58" fmla="*/ 133 w 221"/>
              <a:gd name="T59" fmla="*/ 2 h 69"/>
              <a:gd name="T60" fmla="*/ 136 w 221"/>
              <a:gd name="T61" fmla="*/ 0 h 69"/>
              <a:gd name="T62" fmla="*/ 144 w 221"/>
              <a:gd name="T63" fmla="*/ 4 h 69"/>
              <a:gd name="T64" fmla="*/ 147 w 221"/>
              <a:gd name="T65" fmla="*/ 6 h 69"/>
              <a:gd name="T66" fmla="*/ 156 w 221"/>
              <a:gd name="T67" fmla="*/ 11 h 69"/>
              <a:gd name="T68" fmla="*/ 159 w 221"/>
              <a:gd name="T69" fmla="*/ 13 h 69"/>
              <a:gd name="T70" fmla="*/ 167 w 221"/>
              <a:gd name="T71" fmla="*/ 17 h 69"/>
              <a:gd name="T72" fmla="*/ 170 w 221"/>
              <a:gd name="T73" fmla="*/ 17 h 69"/>
              <a:gd name="T74" fmla="*/ 179 w 221"/>
              <a:gd name="T75" fmla="*/ 20 h 69"/>
              <a:gd name="T76" fmla="*/ 182 w 221"/>
              <a:gd name="T77" fmla="*/ 21 h 69"/>
              <a:gd name="T78" fmla="*/ 191 w 221"/>
              <a:gd name="T79" fmla="*/ 23 h 69"/>
              <a:gd name="T80" fmla="*/ 193 w 221"/>
              <a:gd name="T81" fmla="*/ 24 h 69"/>
              <a:gd name="T82" fmla="*/ 193 w 221"/>
              <a:gd name="T83" fmla="*/ 24 h 69"/>
              <a:gd name="T84" fmla="*/ 199 w 221"/>
              <a:gd name="T85" fmla="*/ 32 h 69"/>
              <a:gd name="T86" fmla="*/ 201 w 221"/>
              <a:gd name="T87" fmla="*/ 35 h 69"/>
              <a:gd name="T88" fmla="*/ 206 w 221"/>
              <a:gd name="T89" fmla="*/ 43 h 69"/>
              <a:gd name="T90" fmla="*/ 208 w 221"/>
              <a:gd name="T91" fmla="*/ 46 h 69"/>
              <a:gd name="T92" fmla="*/ 214 w 221"/>
              <a:gd name="T93" fmla="*/ 54 h 69"/>
              <a:gd name="T94" fmla="*/ 216 w 221"/>
              <a:gd name="T95" fmla="*/ 57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</a:cxnLst>
            <a:rect l="0" t="0" r="r" b="b"/>
            <a:pathLst>
              <a:path w="221" h="69">
                <a:moveTo>
                  <a:pt x="6" y="45"/>
                </a:moveTo>
                <a:lnTo>
                  <a:pt x="8" y="48"/>
                </a:lnTo>
                <a:moveTo>
                  <a:pt x="14" y="55"/>
                </a:moveTo>
                <a:lnTo>
                  <a:pt x="16" y="58"/>
                </a:lnTo>
                <a:moveTo>
                  <a:pt x="22" y="65"/>
                </a:moveTo>
                <a:lnTo>
                  <a:pt x="24" y="68"/>
                </a:lnTo>
                <a:moveTo>
                  <a:pt x="33" y="69"/>
                </a:moveTo>
                <a:lnTo>
                  <a:pt x="36" y="69"/>
                </a:lnTo>
                <a:moveTo>
                  <a:pt x="45" y="67"/>
                </a:moveTo>
                <a:lnTo>
                  <a:pt x="48" y="67"/>
                </a:lnTo>
                <a:moveTo>
                  <a:pt x="57" y="65"/>
                </a:moveTo>
                <a:lnTo>
                  <a:pt x="60" y="64"/>
                </a:lnTo>
                <a:moveTo>
                  <a:pt x="69" y="61"/>
                </a:moveTo>
                <a:lnTo>
                  <a:pt x="72" y="60"/>
                </a:lnTo>
                <a:moveTo>
                  <a:pt x="81" y="57"/>
                </a:moveTo>
                <a:lnTo>
                  <a:pt x="82" y="57"/>
                </a:lnTo>
                <a:lnTo>
                  <a:pt x="83" y="55"/>
                </a:lnTo>
                <a:moveTo>
                  <a:pt x="88" y="47"/>
                </a:moveTo>
                <a:lnTo>
                  <a:pt x="90" y="44"/>
                </a:lnTo>
                <a:moveTo>
                  <a:pt x="95" y="36"/>
                </a:moveTo>
                <a:lnTo>
                  <a:pt x="97" y="33"/>
                </a:lnTo>
                <a:moveTo>
                  <a:pt x="102" y="25"/>
                </a:moveTo>
                <a:lnTo>
                  <a:pt x="104" y="22"/>
                </a:lnTo>
                <a:moveTo>
                  <a:pt x="109" y="14"/>
                </a:moveTo>
                <a:lnTo>
                  <a:pt x="110" y="13"/>
                </a:lnTo>
                <a:lnTo>
                  <a:pt x="112" y="12"/>
                </a:lnTo>
                <a:moveTo>
                  <a:pt x="121" y="8"/>
                </a:moveTo>
                <a:lnTo>
                  <a:pt x="124" y="6"/>
                </a:lnTo>
                <a:moveTo>
                  <a:pt x="133" y="2"/>
                </a:moveTo>
                <a:lnTo>
                  <a:pt x="136" y="0"/>
                </a:lnTo>
                <a:moveTo>
                  <a:pt x="144" y="4"/>
                </a:moveTo>
                <a:lnTo>
                  <a:pt x="147" y="6"/>
                </a:lnTo>
                <a:moveTo>
                  <a:pt x="156" y="11"/>
                </a:moveTo>
                <a:lnTo>
                  <a:pt x="159" y="13"/>
                </a:lnTo>
                <a:moveTo>
                  <a:pt x="167" y="17"/>
                </a:moveTo>
                <a:lnTo>
                  <a:pt x="170" y="17"/>
                </a:lnTo>
                <a:moveTo>
                  <a:pt x="179" y="20"/>
                </a:moveTo>
                <a:lnTo>
                  <a:pt x="182" y="21"/>
                </a:lnTo>
                <a:moveTo>
                  <a:pt x="191" y="23"/>
                </a:moveTo>
                <a:lnTo>
                  <a:pt x="193" y="24"/>
                </a:lnTo>
                <a:lnTo>
                  <a:pt x="193" y="24"/>
                </a:lnTo>
                <a:moveTo>
                  <a:pt x="199" y="32"/>
                </a:moveTo>
                <a:lnTo>
                  <a:pt x="201" y="35"/>
                </a:lnTo>
                <a:moveTo>
                  <a:pt x="206" y="43"/>
                </a:moveTo>
                <a:lnTo>
                  <a:pt x="208" y="46"/>
                </a:lnTo>
                <a:moveTo>
                  <a:pt x="214" y="54"/>
                </a:moveTo>
                <a:lnTo>
                  <a:pt x="216" y="57"/>
                </a:lnTo>
              </a:path>
            </a:pathLst>
          </a:custGeom>
          <a:noFill/>
          <a:ln w="41275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9" name="Rectangle 79">
            <a:extLst>
              <a:ext uri="{FF2B5EF4-FFF2-40B4-BE49-F238E27FC236}">
                <a16:creationId xmlns:a16="http://schemas.microsoft.com/office/drawing/2014/main" id="{B06AC71C-7A02-4806-8735-B4453D522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9816" y="3411286"/>
            <a:ext cx="43057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0" name="Rectangle 80">
            <a:extLst>
              <a:ext uri="{FF2B5EF4-FFF2-40B4-BE49-F238E27FC236}">
                <a16:creationId xmlns:a16="http://schemas.microsoft.com/office/drawing/2014/main" id="{9C9BCBB6-62BC-4679-A623-95D1F71CBA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9816" y="3483304"/>
            <a:ext cx="43057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1" name="Rectangle 81">
            <a:extLst>
              <a:ext uri="{FF2B5EF4-FFF2-40B4-BE49-F238E27FC236}">
                <a16:creationId xmlns:a16="http://schemas.microsoft.com/office/drawing/2014/main" id="{A6C9EE1B-1256-437A-B949-F927CE840A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6568" y="3423289"/>
            <a:ext cx="71209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2" name="Rectangle 82">
            <a:extLst>
              <a:ext uri="{FF2B5EF4-FFF2-40B4-BE49-F238E27FC236}">
                <a16:creationId xmlns:a16="http://schemas.microsoft.com/office/drawing/2014/main" id="{E7E3B8FF-63D4-43F7-BF0F-73DF97537D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6568" y="3471301"/>
            <a:ext cx="71209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3" name="Rectangle 83">
            <a:extLst>
              <a:ext uri="{FF2B5EF4-FFF2-40B4-BE49-F238E27FC236}">
                <a16:creationId xmlns:a16="http://schemas.microsoft.com/office/drawing/2014/main" id="{325B58C6-1A0B-4DB8-B450-1EE7BBA595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435292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4" name="Rectangle 84">
            <a:extLst>
              <a:ext uri="{FF2B5EF4-FFF2-40B4-BE49-F238E27FC236}">
                <a16:creationId xmlns:a16="http://schemas.microsoft.com/office/drawing/2014/main" id="{42DFD022-C12D-4C11-A171-C29C0FEA30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459298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5" name="Rectangle 85">
            <a:extLst>
              <a:ext uri="{FF2B5EF4-FFF2-40B4-BE49-F238E27FC236}">
                <a16:creationId xmlns:a16="http://schemas.microsoft.com/office/drawing/2014/main" id="{01965666-E4AE-432F-927F-F59398D251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447295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6" name="Rectangle 86">
            <a:extLst>
              <a:ext uri="{FF2B5EF4-FFF2-40B4-BE49-F238E27FC236}">
                <a16:creationId xmlns:a16="http://schemas.microsoft.com/office/drawing/2014/main" id="{C7824536-3C28-4821-BC06-562F28AF6B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663" y="3447295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7" name="Rectangle 87">
            <a:extLst>
              <a:ext uri="{FF2B5EF4-FFF2-40B4-BE49-F238E27FC236}">
                <a16:creationId xmlns:a16="http://schemas.microsoft.com/office/drawing/2014/main" id="{C808F294-73C2-4BD3-B0E9-65F07DC374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0368" y="2848859"/>
            <a:ext cx="43057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8" name="Rectangle 88">
            <a:extLst>
              <a:ext uri="{FF2B5EF4-FFF2-40B4-BE49-F238E27FC236}">
                <a16:creationId xmlns:a16="http://schemas.microsoft.com/office/drawing/2014/main" id="{3B61CA16-0B48-49AA-9E89-BD6D754E15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0368" y="2920877"/>
            <a:ext cx="43057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9" name="Rectangle 89">
            <a:extLst>
              <a:ext uri="{FF2B5EF4-FFF2-40B4-BE49-F238E27FC236}">
                <a16:creationId xmlns:a16="http://schemas.microsoft.com/office/drawing/2014/main" id="{48DF42BE-01A2-4DC9-8E06-5A9B95313E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5463" y="2860862"/>
            <a:ext cx="71209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0" name="Rectangle 90">
            <a:extLst>
              <a:ext uri="{FF2B5EF4-FFF2-40B4-BE49-F238E27FC236}">
                <a16:creationId xmlns:a16="http://schemas.microsoft.com/office/drawing/2014/main" id="{E32A9669-2385-409D-AFEF-733C60D07A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5463" y="2908874"/>
            <a:ext cx="71209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1" name="Rectangle 91">
            <a:extLst>
              <a:ext uri="{FF2B5EF4-FFF2-40B4-BE49-F238E27FC236}">
                <a16:creationId xmlns:a16="http://schemas.microsoft.com/office/drawing/2014/main" id="{8757D697-F427-4BCA-B1C6-445A764A39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2215" y="2872865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2" name="Rectangle 92">
            <a:extLst>
              <a:ext uri="{FF2B5EF4-FFF2-40B4-BE49-F238E27FC236}">
                <a16:creationId xmlns:a16="http://schemas.microsoft.com/office/drawing/2014/main" id="{1C665AFC-BDE8-4993-8245-68DB9D8B5C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2215" y="2896871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3" name="Rectangle 93">
            <a:extLst>
              <a:ext uri="{FF2B5EF4-FFF2-40B4-BE49-F238E27FC236}">
                <a16:creationId xmlns:a16="http://schemas.microsoft.com/office/drawing/2014/main" id="{4E7ED13A-B7B8-413C-9C2D-1DE7B7DAC3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2215" y="2884868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4" name="Rectangle 94">
            <a:extLst>
              <a:ext uri="{FF2B5EF4-FFF2-40B4-BE49-F238E27FC236}">
                <a16:creationId xmlns:a16="http://schemas.microsoft.com/office/drawing/2014/main" id="{9C6298A9-E802-4BB8-81EF-4482EAD369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2215" y="2884868"/>
            <a:ext cx="99362" cy="1200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5" name="Rectangle 95">
            <a:extLst>
              <a:ext uri="{FF2B5EF4-FFF2-40B4-BE49-F238E27FC236}">
                <a16:creationId xmlns:a16="http://schemas.microsoft.com/office/drawing/2014/main" id="{41FFC747-BA2F-481F-B67A-C7EABB8602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64234" y="4657885"/>
            <a:ext cx="1634505" cy="92251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6" name="Rectangle 96">
            <a:extLst>
              <a:ext uri="{FF2B5EF4-FFF2-40B4-BE49-F238E27FC236}">
                <a16:creationId xmlns:a16="http://schemas.microsoft.com/office/drawing/2014/main" id="{06B3CB58-BFC8-418A-9B5E-AA32C83FF1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64234" y="4657885"/>
            <a:ext cx="1634505" cy="922518"/>
          </a:xfrm>
          <a:prstGeom prst="rect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7" name="Line 97">
            <a:extLst>
              <a:ext uri="{FF2B5EF4-FFF2-40B4-BE49-F238E27FC236}">
                <a16:creationId xmlns:a16="http://schemas.microsoft.com/office/drawing/2014/main" id="{2A0DCDB5-B65E-4ECC-8AF5-6B17B65663D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34806" y="4849933"/>
            <a:ext cx="326239" cy="0"/>
          </a:xfrm>
          <a:prstGeom prst="line">
            <a:avLst/>
          </a:prstGeom>
          <a:noFill/>
          <a:ln w="269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8" name="Line 98">
            <a:extLst>
              <a:ext uri="{FF2B5EF4-FFF2-40B4-BE49-F238E27FC236}">
                <a16:creationId xmlns:a16="http://schemas.microsoft.com/office/drawing/2014/main" id="{1823D9DC-95E7-4309-8A32-F02E16D7DADF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34806" y="5028264"/>
            <a:ext cx="326239" cy="0"/>
          </a:xfrm>
          <a:prstGeom prst="line">
            <a:avLst/>
          </a:prstGeom>
          <a:noFill/>
          <a:ln w="269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9" name="Line 99">
            <a:extLst>
              <a:ext uri="{FF2B5EF4-FFF2-40B4-BE49-F238E27FC236}">
                <a16:creationId xmlns:a16="http://schemas.microsoft.com/office/drawing/2014/main" id="{B86A643F-8807-4C3B-8D5A-8FFCC12F75DF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34806" y="5220312"/>
            <a:ext cx="326239" cy="0"/>
          </a:xfrm>
          <a:prstGeom prst="line">
            <a:avLst/>
          </a:prstGeom>
          <a:noFill/>
          <a:ln w="269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0" name="Line 100">
            <a:extLst>
              <a:ext uri="{FF2B5EF4-FFF2-40B4-BE49-F238E27FC236}">
                <a16:creationId xmlns:a16="http://schemas.microsoft.com/office/drawing/2014/main" id="{D6EC89E7-2F51-48E8-8CAF-D8497A08A2B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34806" y="5400358"/>
            <a:ext cx="326239" cy="0"/>
          </a:xfrm>
          <a:prstGeom prst="line">
            <a:avLst/>
          </a:prstGeom>
          <a:noFill/>
          <a:ln w="269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1" name="Rectangle 101">
            <a:extLst>
              <a:ext uri="{FF2B5EF4-FFF2-40B4-BE49-F238E27FC236}">
                <a16:creationId xmlns:a16="http://schemas.microsoft.com/office/drawing/2014/main" id="{750D8DB7-B659-41F9-88D2-688D2B7206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8367" y="4777915"/>
            <a:ext cx="1023428" cy="24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6400"/>
                </a:solidFill>
                <a:effectLst/>
                <a:latin typeface="Arial" panose="020B0604020202020204" pitchFamily="34" charset="0"/>
              </a:rPr>
              <a:t>GIRANG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Rectangle 102">
            <a:extLst>
              <a:ext uri="{FF2B5EF4-FFF2-40B4-BE49-F238E27FC236}">
                <a16:creationId xmlns:a16="http://schemas.microsoft.com/office/drawing/2014/main" id="{5790F22B-2440-4097-94B3-F9CA5C6ABE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8367" y="4968249"/>
            <a:ext cx="1066485" cy="24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LUO IMB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103">
            <a:extLst>
              <a:ext uri="{FF2B5EF4-FFF2-40B4-BE49-F238E27FC236}">
                <a16:creationId xmlns:a16="http://schemas.microsoft.com/office/drawing/2014/main" id="{61E53405-915A-46A3-8406-6AF783A612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8367" y="5148294"/>
            <a:ext cx="1066485" cy="24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rPr>
              <a:t>NYANCH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104">
            <a:extLst>
              <a:ext uri="{FF2B5EF4-FFF2-40B4-BE49-F238E27FC236}">
                <a16:creationId xmlns:a16="http://schemas.microsoft.com/office/drawing/2014/main" id="{0DCE1CDF-970D-4A62-BFBA-0827C94314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18367" y="5340342"/>
            <a:ext cx="625980" cy="24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A020F0"/>
                </a:solidFill>
                <a:effectLst/>
                <a:latin typeface="Arial" panose="020B0604020202020204" pitchFamily="34" charset="0"/>
              </a:rPr>
              <a:t>SUB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5">
            <a:extLst>
              <a:ext uri="{FF2B5EF4-FFF2-40B4-BE49-F238E27FC236}">
                <a16:creationId xmlns:a16="http://schemas.microsoft.com/office/drawing/2014/main" id="{8E3DBC20-59AB-438C-BD49-AC8130CD42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4740" y="5220312"/>
            <a:ext cx="4037408" cy="36009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6" name="Rectangle 106">
            <a:extLst>
              <a:ext uri="{FF2B5EF4-FFF2-40B4-BE49-F238E27FC236}">
                <a16:creationId xmlns:a16="http://schemas.microsoft.com/office/drawing/2014/main" id="{B7A6D436-0DEE-43B3-B474-431758C2D0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4740" y="5220312"/>
            <a:ext cx="4037408" cy="360091"/>
          </a:xfrm>
          <a:prstGeom prst="rect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7" name="Line 107">
            <a:extLst>
              <a:ext uri="{FF2B5EF4-FFF2-40B4-BE49-F238E27FC236}">
                <a16:creationId xmlns:a16="http://schemas.microsoft.com/office/drawing/2014/main" id="{95942108-8BBB-4564-AA3F-8A43487D05D3}"/>
              </a:ext>
            </a:extLst>
          </p:cNvPr>
          <p:cNvSpPr>
            <a:spLocks noChangeShapeType="1"/>
          </p:cNvSpPr>
          <p:nvPr/>
        </p:nvSpPr>
        <p:spPr bwMode="auto">
          <a:xfrm>
            <a:off x="4705311" y="5400358"/>
            <a:ext cx="327895" cy="0"/>
          </a:xfrm>
          <a:prstGeom prst="line">
            <a:avLst/>
          </a:pr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8" name="Freeform 108">
            <a:extLst>
              <a:ext uri="{FF2B5EF4-FFF2-40B4-BE49-F238E27FC236}">
                <a16:creationId xmlns:a16="http://schemas.microsoft.com/office/drawing/2014/main" id="{8727ED6A-D373-4A55-8266-7A8CA84E28D0}"/>
              </a:ext>
            </a:extLst>
          </p:cNvPr>
          <p:cNvSpPr>
            <a:spLocks noEditPoints="1"/>
          </p:cNvSpPr>
          <p:nvPr/>
        </p:nvSpPr>
        <p:spPr bwMode="auto">
          <a:xfrm>
            <a:off x="6709111" y="5400358"/>
            <a:ext cx="299742" cy="0"/>
          </a:xfrm>
          <a:custGeom>
            <a:avLst/>
            <a:gdLst>
              <a:gd name="T0" fmla="*/ 0 w 21"/>
              <a:gd name="T1" fmla="*/ 6 w 21"/>
              <a:gd name="T2" fmla="*/ 8 w 21"/>
              <a:gd name="T3" fmla="*/ 14 w 21"/>
              <a:gd name="T4" fmla="*/ 16 w 2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21">
                <a:moveTo>
                  <a:pt x="6" y="0"/>
                </a:moveTo>
                <a:lnTo>
                  <a:pt x="8" y="0"/>
                </a:lnTo>
                <a:moveTo>
                  <a:pt x="14" y="0"/>
                </a:moveTo>
                <a:lnTo>
                  <a:pt x="16" y="0"/>
                </a:lnTo>
              </a:path>
            </a:pathLst>
          </a:cu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9" name="Rectangle 109">
            <a:extLst>
              <a:ext uri="{FF2B5EF4-FFF2-40B4-BE49-F238E27FC236}">
                <a16:creationId xmlns:a16="http://schemas.microsoft.com/office/drawing/2014/main" id="{A7CC0183-D663-4287-AF8D-40BD90328F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8873" y="5340342"/>
            <a:ext cx="1066485" cy="24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110">
            <a:extLst>
              <a:ext uri="{FF2B5EF4-FFF2-40B4-BE49-F238E27FC236}">
                <a16:creationId xmlns:a16="http://schemas.microsoft.com/office/drawing/2014/main" id="{0DEA3B04-922E-44F4-8A6A-51568BFB9F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4520" y="5340342"/>
            <a:ext cx="1563295" cy="2400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TERVENTION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46610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 6">
            <a:extLst>
              <a:ext uri="{FF2B5EF4-FFF2-40B4-BE49-F238E27FC236}">
                <a16:creationId xmlns:a16="http://schemas.microsoft.com/office/drawing/2014/main" id="{0AC19BE4-D898-4F6B-B445-B73F4F35E6D2}"/>
              </a:ext>
            </a:extLst>
          </p:cNvPr>
          <p:cNvSpPr>
            <a:spLocks/>
          </p:cNvSpPr>
          <p:nvPr/>
        </p:nvSpPr>
        <p:spPr bwMode="auto">
          <a:xfrm>
            <a:off x="1770486" y="4764088"/>
            <a:ext cx="3515877" cy="488950"/>
          </a:xfrm>
          <a:custGeom>
            <a:avLst/>
            <a:gdLst>
              <a:gd name="T0" fmla="*/ 0 w 251"/>
              <a:gd name="T1" fmla="*/ 33 h 44"/>
              <a:gd name="T2" fmla="*/ 28 w 251"/>
              <a:gd name="T3" fmla="*/ 25 h 44"/>
              <a:gd name="T4" fmla="*/ 56 w 251"/>
              <a:gd name="T5" fmla="*/ 35 h 44"/>
              <a:gd name="T6" fmla="*/ 84 w 251"/>
              <a:gd name="T7" fmla="*/ 44 h 44"/>
              <a:gd name="T8" fmla="*/ 112 w 251"/>
              <a:gd name="T9" fmla="*/ 0 h 44"/>
              <a:gd name="T10" fmla="*/ 140 w 251"/>
              <a:gd name="T11" fmla="*/ 31 h 44"/>
              <a:gd name="T12" fmla="*/ 168 w 251"/>
              <a:gd name="T13" fmla="*/ 34 h 44"/>
              <a:gd name="T14" fmla="*/ 196 w 251"/>
              <a:gd name="T15" fmla="*/ 31 h 44"/>
              <a:gd name="T16" fmla="*/ 224 w 251"/>
              <a:gd name="T17" fmla="*/ 9 h 44"/>
              <a:gd name="T18" fmla="*/ 251 w 251"/>
              <a:gd name="T19" fmla="*/ 29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1" h="44">
                <a:moveTo>
                  <a:pt x="0" y="33"/>
                </a:moveTo>
                <a:lnTo>
                  <a:pt x="28" y="25"/>
                </a:lnTo>
                <a:lnTo>
                  <a:pt x="56" y="35"/>
                </a:lnTo>
                <a:lnTo>
                  <a:pt x="84" y="44"/>
                </a:lnTo>
                <a:lnTo>
                  <a:pt x="112" y="0"/>
                </a:lnTo>
                <a:lnTo>
                  <a:pt x="140" y="31"/>
                </a:lnTo>
                <a:lnTo>
                  <a:pt x="168" y="34"/>
                </a:lnTo>
                <a:lnTo>
                  <a:pt x="196" y="31"/>
                </a:lnTo>
                <a:lnTo>
                  <a:pt x="224" y="9"/>
                </a:lnTo>
                <a:lnTo>
                  <a:pt x="251" y="29"/>
                </a:lnTo>
              </a:path>
            </a:pathLst>
          </a:custGeom>
          <a:noFill/>
          <a:ln w="41275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" name="Line 7">
            <a:extLst>
              <a:ext uri="{FF2B5EF4-FFF2-40B4-BE49-F238E27FC236}">
                <a16:creationId xmlns:a16="http://schemas.microsoft.com/office/drawing/2014/main" id="{B77847F9-86AD-48AD-B7E9-0C8F76F0123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378369" y="1182688"/>
            <a:ext cx="0" cy="420370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" name="Line 8">
            <a:extLst>
              <a:ext uri="{FF2B5EF4-FFF2-40B4-BE49-F238E27FC236}">
                <a16:creationId xmlns:a16="http://schemas.microsoft.com/office/drawing/2014/main" id="{0538FD4D-4971-4C1D-B814-9945E2E719A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53155" y="5386388"/>
            <a:ext cx="125214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" name="Line 9">
            <a:extLst>
              <a:ext uri="{FF2B5EF4-FFF2-40B4-BE49-F238E27FC236}">
                <a16:creationId xmlns:a16="http://schemas.microsoft.com/office/drawing/2014/main" id="{1C0E5E48-B277-4D05-85C4-B254A31DD7B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53155" y="4552951"/>
            <a:ext cx="125214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" name="Line 10">
            <a:extLst>
              <a:ext uri="{FF2B5EF4-FFF2-40B4-BE49-F238E27FC236}">
                <a16:creationId xmlns:a16="http://schemas.microsoft.com/office/drawing/2014/main" id="{2755D91B-7384-4D7E-B0C2-12505667149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53155" y="3708401"/>
            <a:ext cx="125214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1" name="Line 11">
            <a:extLst>
              <a:ext uri="{FF2B5EF4-FFF2-40B4-BE49-F238E27FC236}">
                <a16:creationId xmlns:a16="http://schemas.microsoft.com/office/drawing/2014/main" id="{A4B586A6-2D11-424B-A0AF-1B36FB1788F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53155" y="2873376"/>
            <a:ext cx="125214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2" name="Line 12">
            <a:extLst>
              <a:ext uri="{FF2B5EF4-FFF2-40B4-BE49-F238E27FC236}">
                <a16:creationId xmlns:a16="http://schemas.microsoft.com/office/drawing/2014/main" id="{B5DDD63D-8D16-4AB5-8078-5B4F32D31BB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53155" y="2028826"/>
            <a:ext cx="125214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3" name="Line 13">
            <a:extLst>
              <a:ext uri="{FF2B5EF4-FFF2-40B4-BE49-F238E27FC236}">
                <a16:creationId xmlns:a16="http://schemas.microsoft.com/office/drawing/2014/main" id="{0AF36CB7-4CF7-4312-A182-D3C0589D9A4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53155" y="1182688"/>
            <a:ext cx="125214" cy="0"/>
          </a:xfrm>
          <a:prstGeom prst="line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4" name="Rectangle 14">
            <a:extLst>
              <a:ext uri="{FF2B5EF4-FFF2-40B4-BE49-F238E27FC236}">
                <a16:creationId xmlns:a16="http://schemas.microsoft.com/office/drawing/2014/main" id="{4354E82F-3140-4BB2-8E34-CB664A73666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916195" y="5259527"/>
            <a:ext cx="21590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5">
            <a:extLst>
              <a:ext uri="{FF2B5EF4-FFF2-40B4-BE49-F238E27FC236}">
                <a16:creationId xmlns:a16="http://schemas.microsoft.com/office/drawing/2014/main" id="{61181A44-E493-46A9-913A-78763CDCCEE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55870" y="4426089"/>
            <a:ext cx="33655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6">
            <a:extLst>
              <a:ext uri="{FF2B5EF4-FFF2-40B4-BE49-F238E27FC236}">
                <a16:creationId xmlns:a16="http://schemas.microsoft.com/office/drawing/2014/main" id="{E217B860-8422-40B5-9970-DD361F072E5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55870" y="3581539"/>
            <a:ext cx="33655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7">
            <a:extLst>
              <a:ext uri="{FF2B5EF4-FFF2-40B4-BE49-F238E27FC236}">
                <a16:creationId xmlns:a16="http://schemas.microsoft.com/office/drawing/2014/main" id="{D9ECE700-6685-41D4-A8F1-17985BCA054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55870" y="2746514"/>
            <a:ext cx="33655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8">
            <a:extLst>
              <a:ext uri="{FF2B5EF4-FFF2-40B4-BE49-F238E27FC236}">
                <a16:creationId xmlns:a16="http://schemas.microsoft.com/office/drawing/2014/main" id="{5365F75A-2FC6-4FA4-8799-0968F7FCB7F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855870" y="1901964"/>
            <a:ext cx="33655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9">
            <a:extLst>
              <a:ext uri="{FF2B5EF4-FFF2-40B4-BE49-F238E27FC236}">
                <a16:creationId xmlns:a16="http://schemas.microsoft.com/office/drawing/2014/main" id="{779BF2DB-65F8-4E41-8470-5EBC86CE1D5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95545" y="1054239"/>
            <a:ext cx="45720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20">
            <a:extLst>
              <a:ext uri="{FF2B5EF4-FFF2-40B4-BE49-F238E27FC236}">
                <a16:creationId xmlns:a16="http://schemas.microsoft.com/office/drawing/2014/main" id="{04C151E4-22FE-4F0E-950D-4288A44C90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8369" y="1016001"/>
            <a:ext cx="10559164" cy="4549775"/>
          </a:xfrm>
          <a:prstGeom prst="rect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1" name="Rectangle 21">
            <a:extLst>
              <a:ext uri="{FF2B5EF4-FFF2-40B4-BE49-F238E27FC236}">
                <a16:creationId xmlns:a16="http://schemas.microsoft.com/office/drawing/2014/main" id="{FBD87B17-31C1-4EFA-B440-180F87DB75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8677" y="471488"/>
            <a:ext cx="4580196" cy="28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7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ostpartum Hemorrhage over Ti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2">
            <a:extLst>
              <a:ext uri="{FF2B5EF4-FFF2-40B4-BE49-F238E27FC236}">
                <a16:creationId xmlns:a16="http://schemas.microsoft.com/office/drawing/2014/main" id="{603222E2-8834-4907-8FBC-08CEAEB63F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1340" y="6232526"/>
            <a:ext cx="15487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3">
            <a:extLst>
              <a:ext uri="{FF2B5EF4-FFF2-40B4-BE49-F238E27FC236}">
                <a16:creationId xmlns:a16="http://schemas.microsoft.com/office/drawing/2014/main" id="{09B1CE32-5510-4461-BE56-32C47435FBC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11290" y="3157677"/>
            <a:ext cx="1606550" cy="2537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cility Birth(%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Freeform 24">
            <a:extLst>
              <a:ext uri="{FF2B5EF4-FFF2-40B4-BE49-F238E27FC236}">
                <a16:creationId xmlns:a16="http://schemas.microsoft.com/office/drawing/2014/main" id="{EE24D162-3B0E-49FA-AE46-54D734BAD0F8}"/>
              </a:ext>
            </a:extLst>
          </p:cNvPr>
          <p:cNvSpPr>
            <a:spLocks noEditPoints="1"/>
          </p:cNvSpPr>
          <p:nvPr/>
        </p:nvSpPr>
        <p:spPr bwMode="auto">
          <a:xfrm>
            <a:off x="7680257" y="4541838"/>
            <a:ext cx="3865158" cy="500063"/>
          </a:xfrm>
          <a:custGeom>
            <a:avLst/>
            <a:gdLst>
              <a:gd name="T0" fmla="*/ 0 w 276"/>
              <a:gd name="T1" fmla="*/ 21 h 45"/>
              <a:gd name="T2" fmla="*/ 9 w 276"/>
              <a:gd name="T3" fmla="*/ 24 h 45"/>
              <a:gd name="T4" fmla="*/ 12 w 276"/>
              <a:gd name="T5" fmla="*/ 25 h 45"/>
              <a:gd name="T6" fmla="*/ 21 w 276"/>
              <a:gd name="T7" fmla="*/ 28 h 45"/>
              <a:gd name="T8" fmla="*/ 24 w 276"/>
              <a:gd name="T9" fmla="*/ 29 h 45"/>
              <a:gd name="T10" fmla="*/ 31 w 276"/>
              <a:gd name="T11" fmla="*/ 23 h 45"/>
              <a:gd name="T12" fmla="*/ 34 w 276"/>
              <a:gd name="T13" fmla="*/ 20 h 45"/>
              <a:gd name="T14" fmla="*/ 40 w 276"/>
              <a:gd name="T15" fmla="*/ 13 h 45"/>
              <a:gd name="T16" fmla="*/ 43 w 276"/>
              <a:gd name="T17" fmla="*/ 10 h 45"/>
              <a:gd name="T18" fmla="*/ 50 w 276"/>
              <a:gd name="T19" fmla="*/ 3 h 45"/>
              <a:gd name="T20" fmla="*/ 53 w 276"/>
              <a:gd name="T21" fmla="*/ 0 h 45"/>
              <a:gd name="T22" fmla="*/ 54 w 276"/>
              <a:gd name="T23" fmla="*/ 1 h 45"/>
              <a:gd name="T24" fmla="*/ 61 w 276"/>
              <a:gd name="T25" fmla="*/ 7 h 45"/>
              <a:gd name="T26" fmla="*/ 64 w 276"/>
              <a:gd name="T27" fmla="*/ 9 h 45"/>
              <a:gd name="T28" fmla="*/ 71 w 276"/>
              <a:gd name="T29" fmla="*/ 15 h 45"/>
              <a:gd name="T30" fmla="*/ 74 w 276"/>
              <a:gd name="T31" fmla="*/ 18 h 45"/>
              <a:gd name="T32" fmla="*/ 81 w 276"/>
              <a:gd name="T33" fmla="*/ 24 h 45"/>
              <a:gd name="T34" fmla="*/ 84 w 276"/>
              <a:gd name="T35" fmla="*/ 23 h 45"/>
              <a:gd name="T36" fmla="*/ 93 w 276"/>
              <a:gd name="T37" fmla="*/ 21 h 45"/>
              <a:gd name="T38" fmla="*/ 96 w 276"/>
              <a:gd name="T39" fmla="*/ 20 h 45"/>
              <a:gd name="T40" fmla="*/ 105 w 276"/>
              <a:gd name="T41" fmla="*/ 18 h 45"/>
              <a:gd name="T42" fmla="*/ 108 w 276"/>
              <a:gd name="T43" fmla="*/ 17 h 45"/>
              <a:gd name="T44" fmla="*/ 117 w 276"/>
              <a:gd name="T45" fmla="*/ 21 h 45"/>
              <a:gd name="T46" fmla="*/ 120 w 276"/>
              <a:gd name="T47" fmla="*/ 22 h 45"/>
              <a:gd name="T48" fmla="*/ 129 w 276"/>
              <a:gd name="T49" fmla="*/ 26 h 45"/>
              <a:gd name="T50" fmla="*/ 132 w 276"/>
              <a:gd name="T51" fmla="*/ 28 h 45"/>
              <a:gd name="T52" fmla="*/ 141 w 276"/>
              <a:gd name="T53" fmla="*/ 31 h 45"/>
              <a:gd name="T54" fmla="*/ 144 w 276"/>
              <a:gd name="T55" fmla="*/ 31 h 45"/>
              <a:gd name="T56" fmla="*/ 153 w 276"/>
              <a:gd name="T57" fmla="*/ 32 h 45"/>
              <a:gd name="T58" fmla="*/ 156 w 276"/>
              <a:gd name="T59" fmla="*/ 33 h 45"/>
              <a:gd name="T60" fmla="*/ 165 w 276"/>
              <a:gd name="T61" fmla="*/ 34 h 45"/>
              <a:gd name="T62" fmla="*/ 168 w 276"/>
              <a:gd name="T63" fmla="*/ 35 h 45"/>
              <a:gd name="T64" fmla="*/ 177 w 276"/>
              <a:gd name="T65" fmla="*/ 39 h 45"/>
              <a:gd name="T66" fmla="*/ 180 w 276"/>
              <a:gd name="T67" fmla="*/ 40 h 45"/>
              <a:gd name="T68" fmla="*/ 189 w 276"/>
              <a:gd name="T69" fmla="*/ 44 h 45"/>
              <a:gd name="T70" fmla="*/ 192 w 276"/>
              <a:gd name="T71" fmla="*/ 45 h 45"/>
              <a:gd name="T72" fmla="*/ 192 w 276"/>
              <a:gd name="T73" fmla="*/ 45 h 45"/>
              <a:gd name="T74" fmla="*/ 199 w 276"/>
              <a:gd name="T75" fmla="*/ 39 h 45"/>
              <a:gd name="T76" fmla="*/ 202 w 276"/>
              <a:gd name="T77" fmla="*/ 36 h 45"/>
              <a:gd name="T78" fmla="*/ 209 w 276"/>
              <a:gd name="T79" fmla="*/ 29 h 45"/>
              <a:gd name="T80" fmla="*/ 212 w 276"/>
              <a:gd name="T81" fmla="*/ 26 h 45"/>
              <a:gd name="T82" fmla="*/ 219 w 276"/>
              <a:gd name="T83" fmla="*/ 20 h 45"/>
              <a:gd name="T84" fmla="*/ 220 w 276"/>
              <a:gd name="T85" fmla="*/ 19 h 45"/>
              <a:gd name="T86" fmla="*/ 221 w 276"/>
              <a:gd name="T87" fmla="*/ 20 h 45"/>
              <a:gd name="T88" fmla="*/ 228 w 276"/>
              <a:gd name="T89" fmla="*/ 26 h 45"/>
              <a:gd name="T90" fmla="*/ 231 w 276"/>
              <a:gd name="T91" fmla="*/ 29 h 45"/>
              <a:gd name="T92" fmla="*/ 238 w 276"/>
              <a:gd name="T93" fmla="*/ 36 h 45"/>
              <a:gd name="T94" fmla="*/ 241 w 276"/>
              <a:gd name="T95" fmla="*/ 38 h 45"/>
              <a:gd name="T96" fmla="*/ 248 w 276"/>
              <a:gd name="T97" fmla="*/ 45 h 45"/>
              <a:gd name="T98" fmla="*/ 251 w 276"/>
              <a:gd name="T99" fmla="*/ 44 h 45"/>
              <a:gd name="T100" fmla="*/ 260 w 276"/>
              <a:gd name="T101" fmla="*/ 39 h 45"/>
              <a:gd name="T102" fmla="*/ 263 w 276"/>
              <a:gd name="T103" fmla="*/ 38 h 45"/>
              <a:gd name="T104" fmla="*/ 272 w 276"/>
              <a:gd name="T105" fmla="*/ 33 h 45"/>
              <a:gd name="T106" fmla="*/ 275 w 276"/>
              <a:gd name="T107" fmla="*/ 32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276" h="45">
                <a:moveTo>
                  <a:pt x="9" y="24"/>
                </a:moveTo>
                <a:lnTo>
                  <a:pt x="12" y="25"/>
                </a:lnTo>
                <a:moveTo>
                  <a:pt x="21" y="28"/>
                </a:moveTo>
                <a:lnTo>
                  <a:pt x="24" y="29"/>
                </a:lnTo>
                <a:moveTo>
                  <a:pt x="31" y="23"/>
                </a:moveTo>
                <a:lnTo>
                  <a:pt x="34" y="20"/>
                </a:lnTo>
                <a:moveTo>
                  <a:pt x="40" y="13"/>
                </a:moveTo>
                <a:lnTo>
                  <a:pt x="43" y="10"/>
                </a:lnTo>
                <a:moveTo>
                  <a:pt x="50" y="3"/>
                </a:moveTo>
                <a:lnTo>
                  <a:pt x="53" y="0"/>
                </a:lnTo>
                <a:lnTo>
                  <a:pt x="54" y="1"/>
                </a:lnTo>
                <a:moveTo>
                  <a:pt x="61" y="7"/>
                </a:moveTo>
                <a:lnTo>
                  <a:pt x="64" y="9"/>
                </a:lnTo>
                <a:moveTo>
                  <a:pt x="71" y="15"/>
                </a:moveTo>
                <a:lnTo>
                  <a:pt x="74" y="18"/>
                </a:lnTo>
                <a:moveTo>
                  <a:pt x="81" y="24"/>
                </a:moveTo>
                <a:lnTo>
                  <a:pt x="84" y="23"/>
                </a:lnTo>
                <a:moveTo>
                  <a:pt x="93" y="21"/>
                </a:moveTo>
                <a:lnTo>
                  <a:pt x="96" y="20"/>
                </a:lnTo>
                <a:moveTo>
                  <a:pt x="105" y="18"/>
                </a:moveTo>
                <a:lnTo>
                  <a:pt x="108" y="17"/>
                </a:lnTo>
                <a:moveTo>
                  <a:pt x="117" y="21"/>
                </a:moveTo>
                <a:lnTo>
                  <a:pt x="120" y="22"/>
                </a:lnTo>
                <a:moveTo>
                  <a:pt x="129" y="26"/>
                </a:moveTo>
                <a:lnTo>
                  <a:pt x="132" y="28"/>
                </a:lnTo>
                <a:moveTo>
                  <a:pt x="141" y="31"/>
                </a:moveTo>
                <a:lnTo>
                  <a:pt x="144" y="31"/>
                </a:lnTo>
                <a:moveTo>
                  <a:pt x="153" y="32"/>
                </a:moveTo>
                <a:lnTo>
                  <a:pt x="156" y="33"/>
                </a:lnTo>
                <a:moveTo>
                  <a:pt x="165" y="34"/>
                </a:moveTo>
                <a:lnTo>
                  <a:pt x="168" y="35"/>
                </a:lnTo>
                <a:moveTo>
                  <a:pt x="177" y="39"/>
                </a:moveTo>
                <a:lnTo>
                  <a:pt x="180" y="40"/>
                </a:lnTo>
                <a:moveTo>
                  <a:pt x="189" y="44"/>
                </a:moveTo>
                <a:lnTo>
                  <a:pt x="192" y="45"/>
                </a:lnTo>
                <a:lnTo>
                  <a:pt x="192" y="45"/>
                </a:lnTo>
                <a:moveTo>
                  <a:pt x="199" y="39"/>
                </a:moveTo>
                <a:lnTo>
                  <a:pt x="202" y="36"/>
                </a:lnTo>
                <a:moveTo>
                  <a:pt x="209" y="29"/>
                </a:moveTo>
                <a:lnTo>
                  <a:pt x="212" y="26"/>
                </a:lnTo>
                <a:moveTo>
                  <a:pt x="219" y="20"/>
                </a:moveTo>
                <a:lnTo>
                  <a:pt x="220" y="19"/>
                </a:lnTo>
                <a:lnTo>
                  <a:pt x="221" y="20"/>
                </a:lnTo>
                <a:moveTo>
                  <a:pt x="228" y="26"/>
                </a:moveTo>
                <a:lnTo>
                  <a:pt x="231" y="29"/>
                </a:lnTo>
                <a:moveTo>
                  <a:pt x="238" y="36"/>
                </a:moveTo>
                <a:lnTo>
                  <a:pt x="241" y="38"/>
                </a:lnTo>
                <a:moveTo>
                  <a:pt x="248" y="45"/>
                </a:moveTo>
                <a:lnTo>
                  <a:pt x="251" y="44"/>
                </a:lnTo>
                <a:moveTo>
                  <a:pt x="260" y="39"/>
                </a:moveTo>
                <a:lnTo>
                  <a:pt x="263" y="38"/>
                </a:lnTo>
                <a:moveTo>
                  <a:pt x="272" y="33"/>
                </a:moveTo>
                <a:lnTo>
                  <a:pt x="275" y="32"/>
                </a:lnTo>
              </a:path>
            </a:pathLst>
          </a:custGeom>
          <a:noFill/>
          <a:ln w="41275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5" name="Rectangle 25">
            <a:extLst>
              <a:ext uri="{FF2B5EF4-FFF2-40B4-BE49-F238E27FC236}">
                <a16:creationId xmlns:a16="http://schemas.microsoft.com/office/drawing/2014/main" id="{41EAE2F9-C16F-490E-9286-534A2ACB7F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1535" y="5053013"/>
            <a:ext cx="42836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6" name="Rectangle 26">
            <a:extLst>
              <a:ext uri="{FF2B5EF4-FFF2-40B4-BE49-F238E27FC236}">
                <a16:creationId xmlns:a16="http://schemas.microsoft.com/office/drawing/2014/main" id="{8266989D-63E4-460B-9F6F-3E97A9FA00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1535" y="5119688"/>
            <a:ext cx="42836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7" name="Rectangle 27">
            <a:extLst>
              <a:ext uri="{FF2B5EF4-FFF2-40B4-BE49-F238E27FC236}">
                <a16:creationId xmlns:a16="http://schemas.microsoft.com/office/drawing/2014/main" id="{6898F3FA-8BC2-4098-88B3-9795FFD664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8355" y="5064126"/>
            <a:ext cx="69197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8" name="Rectangle 28">
            <a:extLst>
              <a:ext uri="{FF2B5EF4-FFF2-40B4-BE49-F238E27FC236}">
                <a16:creationId xmlns:a16="http://schemas.microsoft.com/office/drawing/2014/main" id="{BA3C4603-F291-4D36-AB9F-6AE9FF2BBC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8355" y="5108576"/>
            <a:ext cx="69197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29" name="Rectangle 29">
            <a:extLst>
              <a:ext uri="{FF2B5EF4-FFF2-40B4-BE49-F238E27FC236}">
                <a16:creationId xmlns:a16="http://schemas.microsoft.com/office/drawing/2014/main" id="{39156EB2-1F37-4FB6-B20B-9D9BBD17BC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3527" y="5075238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0" name="Rectangle 30">
            <a:extLst>
              <a:ext uri="{FF2B5EF4-FFF2-40B4-BE49-F238E27FC236}">
                <a16:creationId xmlns:a16="http://schemas.microsoft.com/office/drawing/2014/main" id="{492FA703-4C34-403C-92A3-98323BC15F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3527" y="5097463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1" name="Rectangle 31">
            <a:extLst>
              <a:ext uri="{FF2B5EF4-FFF2-40B4-BE49-F238E27FC236}">
                <a16:creationId xmlns:a16="http://schemas.microsoft.com/office/drawing/2014/main" id="{84D31DE6-0F78-4DC6-A20A-E8F85BB415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3527" y="5086351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2" name="Rectangle 32">
            <a:extLst>
              <a:ext uri="{FF2B5EF4-FFF2-40B4-BE49-F238E27FC236}">
                <a16:creationId xmlns:a16="http://schemas.microsoft.com/office/drawing/2014/main" id="{4CC2B1CD-D45E-43B7-9C47-5C25A9B2A9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3527" y="5086351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3" name="Rectangle 33">
            <a:extLst>
              <a:ext uri="{FF2B5EF4-FFF2-40B4-BE49-F238E27FC236}">
                <a16:creationId xmlns:a16="http://schemas.microsoft.com/office/drawing/2014/main" id="{F7872B46-94E5-4467-80E1-B02F92E276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4240" y="4730751"/>
            <a:ext cx="42836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4" name="Rectangle 34">
            <a:extLst>
              <a:ext uri="{FF2B5EF4-FFF2-40B4-BE49-F238E27FC236}">
                <a16:creationId xmlns:a16="http://schemas.microsoft.com/office/drawing/2014/main" id="{1E4C9FCA-5E27-4D84-AD24-4050E937C7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4240" y="4797426"/>
            <a:ext cx="42836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5" name="Rectangle 35">
            <a:extLst>
              <a:ext uri="{FF2B5EF4-FFF2-40B4-BE49-F238E27FC236}">
                <a16:creationId xmlns:a16="http://schemas.microsoft.com/office/drawing/2014/main" id="{D2FF2C63-BCF3-47EB-995A-252E4615FE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11060" y="4741863"/>
            <a:ext cx="69197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6" name="Rectangle 36">
            <a:extLst>
              <a:ext uri="{FF2B5EF4-FFF2-40B4-BE49-F238E27FC236}">
                <a16:creationId xmlns:a16="http://schemas.microsoft.com/office/drawing/2014/main" id="{257DEA77-B6DF-419B-A23F-C9839E374C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11060" y="4786313"/>
            <a:ext cx="69197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7" name="Rectangle 37">
            <a:extLst>
              <a:ext uri="{FF2B5EF4-FFF2-40B4-BE49-F238E27FC236}">
                <a16:creationId xmlns:a16="http://schemas.microsoft.com/office/drawing/2014/main" id="{C3419909-704B-4652-8B77-2F56C67F00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6232" y="4752976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8" name="Rectangle 38">
            <a:extLst>
              <a:ext uri="{FF2B5EF4-FFF2-40B4-BE49-F238E27FC236}">
                <a16:creationId xmlns:a16="http://schemas.microsoft.com/office/drawing/2014/main" id="{76420E96-C0E6-41B8-A93C-E88DA55C0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6232" y="4775201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39" name="Rectangle 39">
            <a:extLst>
              <a:ext uri="{FF2B5EF4-FFF2-40B4-BE49-F238E27FC236}">
                <a16:creationId xmlns:a16="http://schemas.microsoft.com/office/drawing/2014/main" id="{2D73F612-83C1-430C-8005-03F333C4BA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6232" y="4764088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0" name="Rectangle 40">
            <a:extLst>
              <a:ext uri="{FF2B5EF4-FFF2-40B4-BE49-F238E27FC236}">
                <a16:creationId xmlns:a16="http://schemas.microsoft.com/office/drawing/2014/main" id="{F91A127A-31B8-4DA8-A0FB-0578263C62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6232" y="4764088"/>
            <a:ext cx="98853" cy="11113"/>
          </a:xfrm>
          <a:prstGeom prst="rect">
            <a:avLst/>
          </a:prstGeom>
          <a:solidFill>
            <a:srgbClr val="0064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1" name="Freeform 41">
            <a:extLst>
              <a:ext uri="{FF2B5EF4-FFF2-40B4-BE49-F238E27FC236}">
                <a16:creationId xmlns:a16="http://schemas.microsoft.com/office/drawing/2014/main" id="{666FB3DD-89D0-4DBD-80F6-0F1C9DA9C916}"/>
              </a:ext>
            </a:extLst>
          </p:cNvPr>
          <p:cNvSpPr>
            <a:spLocks/>
          </p:cNvSpPr>
          <p:nvPr/>
        </p:nvSpPr>
        <p:spPr bwMode="auto">
          <a:xfrm>
            <a:off x="1770486" y="2984501"/>
            <a:ext cx="5476465" cy="2401888"/>
          </a:xfrm>
          <a:custGeom>
            <a:avLst/>
            <a:gdLst>
              <a:gd name="T0" fmla="*/ 0 w 391"/>
              <a:gd name="T1" fmla="*/ 0 h 216"/>
              <a:gd name="T2" fmla="*/ 28 w 391"/>
              <a:gd name="T3" fmla="*/ 216 h 216"/>
              <a:gd name="T4" fmla="*/ 56 w 391"/>
              <a:gd name="T5" fmla="*/ 216 h 216"/>
              <a:gd name="T6" fmla="*/ 84 w 391"/>
              <a:gd name="T7" fmla="*/ 189 h 216"/>
              <a:gd name="T8" fmla="*/ 112 w 391"/>
              <a:gd name="T9" fmla="*/ 216 h 216"/>
              <a:gd name="T10" fmla="*/ 140 w 391"/>
              <a:gd name="T11" fmla="*/ 216 h 216"/>
              <a:gd name="T12" fmla="*/ 168 w 391"/>
              <a:gd name="T13" fmla="*/ 216 h 216"/>
              <a:gd name="T14" fmla="*/ 196 w 391"/>
              <a:gd name="T15" fmla="*/ 185 h 216"/>
              <a:gd name="T16" fmla="*/ 224 w 391"/>
              <a:gd name="T17" fmla="*/ 216 h 216"/>
              <a:gd name="T18" fmla="*/ 251 w 391"/>
              <a:gd name="T19" fmla="*/ 105 h 216"/>
              <a:gd name="T20" fmla="*/ 279 w 391"/>
              <a:gd name="T21" fmla="*/ 190 h 216"/>
              <a:gd name="T22" fmla="*/ 307 w 391"/>
              <a:gd name="T23" fmla="*/ 185 h 216"/>
              <a:gd name="T24" fmla="*/ 335 w 391"/>
              <a:gd name="T25" fmla="*/ 193 h 216"/>
              <a:gd name="T26" fmla="*/ 363 w 391"/>
              <a:gd name="T27" fmla="*/ 216 h 216"/>
              <a:gd name="T28" fmla="*/ 391 w 391"/>
              <a:gd name="T29" fmla="*/ 199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391" h="216">
                <a:moveTo>
                  <a:pt x="0" y="0"/>
                </a:moveTo>
                <a:lnTo>
                  <a:pt x="28" y="216"/>
                </a:lnTo>
                <a:lnTo>
                  <a:pt x="56" y="216"/>
                </a:lnTo>
                <a:lnTo>
                  <a:pt x="84" y="189"/>
                </a:lnTo>
                <a:lnTo>
                  <a:pt x="112" y="216"/>
                </a:lnTo>
                <a:lnTo>
                  <a:pt x="140" y="216"/>
                </a:lnTo>
                <a:lnTo>
                  <a:pt x="168" y="216"/>
                </a:lnTo>
                <a:lnTo>
                  <a:pt x="196" y="185"/>
                </a:lnTo>
                <a:lnTo>
                  <a:pt x="224" y="216"/>
                </a:lnTo>
                <a:lnTo>
                  <a:pt x="251" y="105"/>
                </a:lnTo>
                <a:lnTo>
                  <a:pt x="279" y="190"/>
                </a:lnTo>
                <a:lnTo>
                  <a:pt x="307" y="185"/>
                </a:lnTo>
                <a:lnTo>
                  <a:pt x="335" y="193"/>
                </a:lnTo>
                <a:lnTo>
                  <a:pt x="363" y="216"/>
                </a:lnTo>
                <a:lnTo>
                  <a:pt x="391" y="199"/>
                </a:lnTo>
              </a:path>
            </a:pathLst>
          </a:custGeom>
          <a:noFill/>
          <a:ln w="41275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2" name="Freeform 42">
            <a:extLst>
              <a:ext uri="{FF2B5EF4-FFF2-40B4-BE49-F238E27FC236}">
                <a16:creationId xmlns:a16="http://schemas.microsoft.com/office/drawing/2014/main" id="{7595C1AE-AF6B-4569-BBA8-3A90D6C18378}"/>
              </a:ext>
            </a:extLst>
          </p:cNvPr>
          <p:cNvSpPr>
            <a:spLocks noEditPoints="1"/>
          </p:cNvSpPr>
          <p:nvPr/>
        </p:nvSpPr>
        <p:spPr bwMode="auto">
          <a:xfrm>
            <a:off x="9640845" y="4786313"/>
            <a:ext cx="1904571" cy="600075"/>
          </a:xfrm>
          <a:custGeom>
            <a:avLst/>
            <a:gdLst>
              <a:gd name="T0" fmla="*/ 0 w 136"/>
              <a:gd name="T1" fmla="*/ 36 h 54"/>
              <a:gd name="T2" fmla="*/ 9 w 136"/>
              <a:gd name="T3" fmla="*/ 41 h 54"/>
              <a:gd name="T4" fmla="*/ 12 w 136"/>
              <a:gd name="T5" fmla="*/ 42 h 54"/>
              <a:gd name="T6" fmla="*/ 21 w 136"/>
              <a:gd name="T7" fmla="*/ 46 h 54"/>
              <a:gd name="T8" fmla="*/ 24 w 136"/>
              <a:gd name="T9" fmla="*/ 48 h 54"/>
              <a:gd name="T10" fmla="*/ 32 w 136"/>
              <a:gd name="T11" fmla="*/ 44 h 54"/>
              <a:gd name="T12" fmla="*/ 35 w 136"/>
              <a:gd name="T13" fmla="*/ 43 h 54"/>
              <a:gd name="T14" fmla="*/ 44 w 136"/>
              <a:gd name="T15" fmla="*/ 38 h 54"/>
              <a:gd name="T16" fmla="*/ 47 w 136"/>
              <a:gd name="T17" fmla="*/ 37 h 54"/>
              <a:gd name="T18" fmla="*/ 55 w 136"/>
              <a:gd name="T19" fmla="*/ 36 h 54"/>
              <a:gd name="T20" fmla="*/ 58 w 136"/>
              <a:gd name="T21" fmla="*/ 38 h 54"/>
              <a:gd name="T22" fmla="*/ 66 w 136"/>
              <a:gd name="T23" fmla="*/ 44 h 54"/>
              <a:gd name="T24" fmla="*/ 69 w 136"/>
              <a:gd name="T25" fmla="*/ 46 h 54"/>
              <a:gd name="T26" fmla="*/ 77 w 136"/>
              <a:gd name="T27" fmla="*/ 52 h 54"/>
              <a:gd name="T28" fmla="*/ 80 w 136"/>
              <a:gd name="T29" fmla="*/ 54 h 54"/>
              <a:gd name="T30" fmla="*/ 80 w 136"/>
              <a:gd name="T31" fmla="*/ 54 h 54"/>
              <a:gd name="T32" fmla="*/ 88 w 136"/>
              <a:gd name="T33" fmla="*/ 49 h 54"/>
              <a:gd name="T34" fmla="*/ 91 w 136"/>
              <a:gd name="T35" fmla="*/ 48 h 54"/>
              <a:gd name="T36" fmla="*/ 99 w 136"/>
              <a:gd name="T37" fmla="*/ 43 h 54"/>
              <a:gd name="T38" fmla="*/ 102 w 136"/>
              <a:gd name="T39" fmla="*/ 41 h 54"/>
              <a:gd name="T40" fmla="*/ 109 w 136"/>
              <a:gd name="T41" fmla="*/ 36 h 54"/>
              <a:gd name="T42" fmla="*/ 112 w 136"/>
              <a:gd name="T43" fmla="*/ 33 h 54"/>
              <a:gd name="T44" fmla="*/ 118 w 136"/>
              <a:gd name="T45" fmla="*/ 25 h 54"/>
              <a:gd name="T46" fmla="*/ 120 w 136"/>
              <a:gd name="T47" fmla="*/ 22 h 54"/>
              <a:gd name="T48" fmla="*/ 126 w 136"/>
              <a:gd name="T49" fmla="*/ 14 h 54"/>
              <a:gd name="T50" fmla="*/ 128 w 136"/>
              <a:gd name="T51" fmla="*/ 11 h 54"/>
              <a:gd name="T52" fmla="*/ 134 w 136"/>
              <a:gd name="T53" fmla="*/ 3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</a:cxnLst>
            <a:rect l="0" t="0" r="r" b="b"/>
            <a:pathLst>
              <a:path w="136" h="54">
                <a:moveTo>
                  <a:pt x="9" y="41"/>
                </a:moveTo>
                <a:lnTo>
                  <a:pt x="12" y="42"/>
                </a:lnTo>
                <a:moveTo>
                  <a:pt x="21" y="46"/>
                </a:moveTo>
                <a:lnTo>
                  <a:pt x="24" y="48"/>
                </a:lnTo>
                <a:moveTo>
                  <a:pt x="32" y="44"/>
                </a:moveTo>
                <a:lnTo>
                  <a:pt x="35" y="43"/>
                </a:lnTo>
                <a:moveTo>
                  <a:pt x="44" y="38"/>
                </a:moveTo>
                <a:lnTo>
                  <a:pt x="47" y="37"/>
                </a:lnTo>
                <a:moveTo>
                  <a:pt x="55" y="36"/>
                </a:moveTo>
                <a:lnTo>
                  <a:pt x="58" y="38"/>
                </a:lnTo>
                <a:moveTo>
                  <a:pt x="66" y="44"/>
                </a:moveTo>
                <a:lnTo>
                  <a:pt x="69" y="46"/>
                </a:lnTo>
                <a:moveTo>
                  <a:pt x="77" y="52"/>
                </a:moveTo>
                <a:lnTo>
                  <a:pt x="80" y="54"/>
                </a:lnTo>
                <a:lnTo>
                  <a:pt x="80" y="54"/>
                </a:lnTo>
                <a:moveTo>
                  <a:pt x="88" y="49"/>
                </a:moveTo>
                <a:lnTo>
                  <a:pt x="91" y="48"/>
                </a:lnTo>
                <a:moveTo>
                  <a:pt x="99" y="43"/>
                </a:moveTo>
                <a:lnTo>
                  <a:pt x="102" y="41"/>
                </a:lnTo>
                <a:moveTo>
                  <a:pt x="109" y="36"/>
                </a:moveTo>
                <a:lnTo>
                  <a:pt x="112" y="33"/>
                </a:lnTo>
                <a:moveTo>
                  <a:pt x="118" y="25"/>
                </a:moveTo>
                <a:lnTo>
                  <a:pt x="120" y="22"/>
                </a:lnTo>
                <a:moveTo>
                  <a:pt x="126" y="14"/>
                </a:moveTo>
                <a:lnTo>
                  <a:pt x="128" y="11"/>
                </a:lnTo>
                <a:moveTo>
                  <a:pt x="134" y="3"/>
                </a:moveTo>
              </a:path>
            </a:pathLst>
          </a:custGeom>
          <a:noFill/>
          <a:ln w="41275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3" name="Rectangle 43">
            <a:extLst>
              <a:ext uri="{FF2B5EF4-FFF2-40B4-BE49-F238E27FC236}">
                <a16:creationId xmlns:a16="http://schemas.microsoft.com/office/drawing/2014/main" id="{7F958F4A-1E80-477A-864B-657279316D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2123" y="5164138"/>
            <a:ext cx="42836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4" name="Rectangle 44">
            <a:extLst>
              <a:ext uri="{FF2B5EF4-FFF2-40B4-BE49-F238E27FC236}">
                <a16:creationId xmlns:a16="http://schemas.microsoft.com/office/drawing/2014/main" id="{5ADCAA9E-46C1-4F9C-9807-9D8E9E2C1E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2123" y="5230813"/>
            <a:ext cx="42836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5" name="Rectangle 45">
            <a:extLst>
              <a:ext uri="{FF2B5EF4-FFF2-40B4-BE49-F238E27FC236}">
                <a16:creationId xmlns:a16="http://schemas.microsoft.com/office/drawing/2014/main" id="{9879B277-2BEE-47B7-BC12-A9AAF63957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943" y="5175251"/>
            <a:ext cx="69197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6" name="Rectangle 46">
            <a:extLst>
              <a:ext uri="{FF2B5EF4-FFF2-40B4-BE49-F238E27FC236}">
                <a16:creationId xmlns:a16="http://schemas.microsoft.com/office/drawing/2014/main" id="{72529D55-7C74-41B3-BB08-F897220476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18943" y="5219701"/>
            <a:ext cx="69197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7" name="Rectangle 47">
            <a:extLst>
              <a:ext uri="{FF2B5EF4-FFF2-40B4-BE49-F238E27FC236}">
                <a16:creationId xmlns:a16="http://schemas.microsoft.com/office/drawing/2014/main" id="{8C396B84-D411-4D76-88AE-322FE3C152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4115" y="5186363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8" name="Rectangle 48">
            <a:extLst>
              <a:ext uri="{FF2B5EF4-FFF2-40B4-BE49-F238E27FC236}">
                <a16:creationId xmlns:a16="http://schemas.microsoft.com/office/drawing/2014/main" id="{67062223-DD38-452C-B67F-A46CF704D1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4115" y="5208588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49" name="Rectangle 49">
            <a:extLst>
              <a:ext uri="{FF2B5EF4-FFF2-40B4-BE49-F238E27FC236}">
                <a16:creationId xmlns:a16="http://schemas.microsoft.com/office/drawing/2014/main" id="{1A1B0371-6C1F-4E7F-BB13-8961173EE7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4115" y="5197476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0" name="Rectangle 50">
            <a:extLst>
              <a:ext uri="{FF2B5EF4-FFF2-40B4-BE49-F238E27FC236}">
                <a16:creationId xmlns:a16="http://schemas.microsoft.com/office/drawing/2014/main" id="{E9E9320A-62AC-4A6E-BB92-57FF89AEFE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04115" y="5197476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1" name="Rectangle 51">
            <a:extLst>
              <a:ext uri="{FF2B5EF4-FFF2-40B4-BE49-F238E27FC236}">
                <a16:creationId xmlns:a16="http://schemas.microsoft.com/office/drawing/2014/main" id="{4FC61F1B-F14E-4B30-8956-470A73B015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84828" y="5141913"/>
            <a:ext cx="42836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2" name="Rectangle 52">
            <a:extLst>
              <a:ext uri="{FF2B5EF4-FFF2-40B4-BE49-F238E27FC236}">
                <a16:creationId xmlns:a16="http://schemas.microsoft.com/office/drawing/2014/main" id="{5AED8E50-9B28-4252-8E4C-154518C692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84828" y="5208588"/>
            <a:ext cx="42836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3" name="Rectangle 53">
            <a:extLst>
              <a:ext uri="{FF2B5EF4-FFF2-40B4-BE49-F238E27FC236}">
                <a16:creationId xmlns:a16="http://schemas.microsoft.com/office/drawing/2014/main" id="{2D2A4C75-2881-4F1F-9C6B-A942626B7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71648" y="5153026"/>
            <a:ext cx="69197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4" name="Rectangle 54">
            <a:extLst>
              <a:ext uri="{FF2B5EF4-FFF2-40B4-BE49-F238E27FC236}">
                <a16:creationId xmlns:a16="http://schemas.microsoft.com/office/drawing/2014/main" id="{D5C4A0E4-464F-445A-9E37-1F4C9CE8F3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71648" y="5197476"/>
            <a:ext cx="69197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5" name="Rectangle 55">
            <a:extLst>
              <a:ext uri="{FF2B5EF4-FFF2-40B4-BE49-F238E27FC236}">
                <a16:creationId xmlns:a16="http://schemas.microsoft.com/office/drawing/2014/main" id="{F6510198-077D-4278-A395-78F50F2403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820" y="5164138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6" name="Rectangle 56">
            <a:extLst>
              <a:ext uri="{FF2B5EF4-FFF2-40B4-BE49-F238E27FC236}">
                <a16:creationId xmlns:a16="http://schemas.microsoft.com/office/drawing/2014/main" id="{084DED89-35CD-4E50-846F-76DBB43C8D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820" y="5186363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7" name="Rectangle 57">
            <a:extLst>
              <a:ext uri="{FF2B5EF4-FFF2-40B4-BE49-F238E27FC236}">
                <a16:creationId xmlns:a16="http://schemas.microsoft.com/office/drawing/2014/main" id="{A57FA30D-05E9-45F7-964F-61CB9D97D1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820" y="5175251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8" name="Rectangle 58">
            <a:extLst>
              <a:ext uri="{FF2B5EF4-FFF2-40B4-BE49-F238E27FC236}">
                <a16:creationId xmlns:a16="http://schemas.microsoft.com/office/drawing/2014/main" id="{4B754AC7-0AA2-41AE-819E-53E2D64647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820" y="5175251"/>
            <a:ext cx="98853" cy="11113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59" name="Freeform 59">
            <a:extLst>
              <a:ext uri="{FF2B5EF4-FFF2-40B4-BE49-F238E27FC236}">
                <a16:creationId xmlns:a16="http://schemas.microsoft.com/office/drawing/2014/main" id="{C04EF741-60D1-4DDD-BB49-CE80CDBA6F5B}"/>
              </a:ext>
            </a:extLst>
          </p:cNvPr>
          <p:cNvSpPr>
            <a:spLocks/>
          </p:cNvSpPr>
          <p:nvPr/>
        </p:nvSpPr>
        <p:spPr bwMode="auto">
          <a:xfrm>
            <a:off x="1770486" y="4786313"/>
            <a:ext cx="2352705" cy="277813"/>
          </a:xfrm>
          <a:custGeom>
            <a:avLst/>
            <a:gdLst>
              <a:gd name="T0" fmla="*/ 0 w 168"/>
              <a:gd name="T1" fmla="*/ 25 h 25"/>
              <a:gd name="T2" fmla="*/ 28 w 168"/>
              <a:gd name="T3" fmla="*/ 0 h 25"/>
              <a:gd name="T4" fmla="*/ 56 w 168"/>
              <a:gd name="T5" fmla="*/ 3 h 25"/>
              <a:gd name="T6" fmla="*/ 84 w 168"/>
              <a:gd name="T7" fmla="*/ 3 h 25"/>
              <a:gd name="T8" fmla="*/ 112 w 168"/>
              <a:gd name="T9" fmla="*/ 14 h 25"/>
              <a:gd name="T10" fmla="*/ 140 w 168"/>
              <a:gd name="T11" fmla="*/ 17 h 25"/>
              <a:gd name="T12" fmla="*/ 168 w 168"/>
              <a:gd name="T13" fmla="*/ 4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8" h="25">
                <a:moveTo>
                  <a:pt x="0" y="25"/>
                </a:moveTo>
                <a:lnTo>
                  <a:pt x="28" y="0"/>
                </a:lnTo>
                <a:lnTo>
                  <a:pt x="56" y="3"/>
                </a:lnTo>
                <a:lnTo>
                  <a:pt x="84" y="3"/>
                </a:lnTo>
                <a:lnTo>
                  <a:pt x="112" y="14"/>
                </a:lnTo>
                <a:lnTo>
                  <a:pt x="140" y="17"/>
                </a:lnTo>
                <a:lnTo>
                  <a:pt x="168" y="4"/>
                </a:lnTo>
              </a:path>
            </a:pathLst>
          </a:custGeom>
          <a:noFill/>
          <a:ln w="4127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0" name="Freeform 60">
            <a:extLst>
              <a:ext uri="{FF2B5EF4-FFF2-40B4-BE49-F238E27FC236}">
                <a16:creationId xmlns:a16="http://schemas.microsoft.com/office/drawing/2014/main" id="{529F8720-DC8C-4A27-8EC7-3278A23372B1}"/>
              </a:ext>
            </a:extLst>
          </p:cNvPr>
          <p:cNvSpPr>
            <a:spLocks noEditPoints="1"/>
          </p:cNvSpPr>
          <p:nvPr/>
        </p:nvSpPr>
        <p:spPr bwMode="auto">
          <a:xfrm>
            <a:off x="6503905" y="4819651"/>
            <a:ext cx="5041511" cy="355600"/>
          </a:xfrm>
          <a:custGeom>
            <a:avLst/>
            <a:gdLst>
              <a:gd name="T0" fmla="*/ 7 w 360"/>
              <a:gd name="T1" fmla="*/ 14 h 32"/>
              <a:gd name="T2" fmla="*/ 17 w 360"/>
              <a:gd name="T3" fmla="*/ 5 h 32"/>
              <a:gd name="T4" fmla="*/ 28 w 360"/>
              <a:gd name="T5" fmla="*/ 0 h 32"/>
              <a:gd name="T6" fmla="*/ 39 w 360"/>
              <a:gd name="T7" fmla="*/ 7 h 32"/>
              <a:gd name="T8" fmla="*/ 50 w 360"/>
              <a:gd name="T9" fmla="*/ 15 h 32"/>
              <a:gd name="T10" fmla="*/ 53 w 360"/>
              <a:gd name="T11" fmla="*/ 17 h 32"/>
              <a:gd name="T12" fmla="*/ 65 w 360"/>
              <a:gd name="T13" fmla="*/ 21 h 32"/>
              <a:gd name="T14" fmla="*/ 77 w 360"/>
              <a:gd name="T15" fmla="*/ 25 h 32"/>
              <a:gd name="T16" fmla="*/ 89 w 360"/>
              <a:gd name="T17" fmla="*/ 25 h 32"/>
              <a:gd name="T18" fmla="*/ 101 w 360"/>
              <a:gd name="T19" fmla="*/ 24 h 32"/>
              <a:gd name="T20" fmla="*/ 112 w 360"/>
              <a:gd name="T21" fmla="*/ 22 h 32"/>
              <a:gd name="T22" fmla="*/ 124 w 360"/>
              <a:gd name="T23" fmla="*/ 20 h 32"/>
              <a:gd name="T24" fmla="*/ 136 w 360"/>
              <a:gd name="T25" fmla="*/ 18 h 32"/>
              <a:gd name="T26" fmla="*/ 148 w 360"/>
              <a:gd name="T27" fmla="*/ 17 h 32"/>
              <a:gd name="T28" fmla="*/ 160 w 360"/>
              <a:gd name="T29" fmla="*/ 16 h 32"/>
              <a:gd name="T30" fmla="*/ 172 w 360"/>
              <a:gd name="T31" fmla="*/ 12 h 32"/>
              <a:gd name="T32" fmla="*/ 184 w 360"/>
              <a:gd name="T33" fmla="*/ 8 h 32"/>
              <a:gd name="T34" fmla="*/ 196 w 360"/>
              <a:gd name="T35" fmla="*/ 4 h 32"/>
              <a:gd name="T36" fmla="*/ 208 w 360"/>
              <a:gd name="T37" fmla="*/ 6 h 32"/>
              <a:gd name="T38" fmla="*/ 220 w 360"/>
              <a:gd name="T39" fmla="*/ 8 h 32"/>
              <a:gd name="T40" fmla="*/ 231 w 360"/>
              <a:gd name="T41" fmla="*/ 13 h 32"/>
              <a:gd name="T42" fmla="*/ 242 w 360"/>
              <a:gd name="T43" fmla="*/ 19 h 32"/>
              <a:gd name="T44" fmla="*/ 252 w 360"/>
              <a:gd name="T45" fmla="*/ 22 h 32"/>
              <a:gd name="T46" fmla="*/ 264 w 360"/>
              <a:gd name="T47" fmla="*/ 19 h 32"/>
              <a:gd name="T48" fmla="*/ 276 w 360"/>
              <a:gd name="T49" fmla="*/ 16 h 32"/>
              <a:gd name="T50" fmla="*/ 285 w 360"/>
              <a:gd name="T51" fmla="*/ 19 h 32"/>
              <a:gd name="T52" fmla="*/ 297 w 360"/>
              <a:gd name="T53" fmla="*/ 22 h 32"/>
              <a:gd name="T54" fmla="*/ 309 w 360"/>
              <a:gd name="T55" fmla="*/ 22 h 32"/>
              <a:gd name="T56" fmla="*/ 321 w 360"/>
              <a:gd name="T57" fmla="*/ 17 h 32"/>
              <a:gd name="T58" fmla="*/ 332 w 360"/>
              <a:gd name="T59" fmla="*/ 12 h 32"/>
              <a:gd name="T60" fmla="*/ 343 w 360"/>
              <a:gd name="T61" fmla="*/ 20 h 32"/>
              <a:gd name="T62" fmla="*/ 354 w 360"/>
              <a:gd name="T63" fmla="*/ 28 h 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0" h="32">
                <a:moveTo>
                  <a:pt x="7" y="14"/>
                </a:moveTo>
                <a:lnTo>
                  <a:pt x="10" y="11"/>
                </a:lnTo>
                <a:moveTo>
                  <a:pt x="17" y="5"/>
                </a:moveTo>
                <a:lnTo>
                  <a:pt x="20" y="2"/>
                </a:lnTo>
                <a:moveTo>
                  <a:pt x="28" y="0"/>
                </a:moveTo>
                <a:lnTo>
                  <a:pt x="31" y="2"/>
                </a:lnTo>
                <a:moveTo>
                  <a:pt x="39" y="7"/>
                </a:moveTo>
                <a:lnTo>
                  <a:pt x="42" y="10"/>
                </a:lnTo>
                <a:moveTo>
                  <a:pt x="50" y="15"/>
                </a:moveTo>
                <a:lnTo>
                  <a:pt x="53" y="17"/>
                </a:lnTo>
                <a:lnTo>
                  <a:pt x="53" y="17"/>
                </a:lnTo>
                <a:moveTo>
                  <a:pt x="62" y="20"/>
                </a:moveTo>
                <a:lnTo>
                  <a:pt x="65" y="21"/>
                </a:lnTo>
                <a:moveTo>
                  <a:pt x="74" y="24"/>
                </a:moveTo>
                <a:lnTo>
                  <a:pt x="77" y="25"/>
                </a:lnTo>
                <a:moveTo>
                  <a:pt x="86" y="25"/>
                </a:moveTo>
                <a:lnTo>
                  <a:pt x="89" y="25"/>
                </a:lnTo>
                <a:moveTo>
                  <a:pt x="98" y="24"/>
                </a:moveTo>
                <a:lnTo>
                  <a:pt x="101" y="24"/>
                </a:lnTo>
                <a:moveTo>
                  <a:pt x="109" y="23"/>
                </a:moveTo>
                <a:lnTo>
                  <a:pt x="112" y="22"/>
                </a:lnTo>
                <a:moveTo>
                  <a:pt x="121" y="21"/>
                </a:moveTo>
                <a:lnTo>
                  <a:pt x="124" y="20"/>
                </a:lnTo>
                <a:moveTo>
                  <a:pt x="133" y="19"/>
                </a:moveTo>
                <a:lnTo>
                  <a:pt x="136" y="18"/>
                </a:lnTo>
                <a:moveTo>
                  <a:pt x="145" y="17"/>
                </a:moveTo>
                <a:lnTo>
                  <a:pt x="148" y="17"/>
                </a:lnTo>
                <a:moveTo>
                  <a:pt x="157" y="16"/>
                </a:moveTo>
                <a:lnTo>
                  <a:pt x="160" y="16"/>
                </a:lnTo>
                <a:moveTo>
                  <a:pt x="169" y="13"/>
                </a:moveTo>
                <a:lnTo>
                  <a:pt x="172" y="12"/>
                </a:lnTo>
                <a:moveTo>
                  <a:pt x="181" y="9"/>
                </a:moveTo>
                <a:lnTo>
                  <a:pt x="184" y="8"/>
                </a:lnTo>
                <a:moveTo>
                  <a:pt x="193" y="4"/>
                </a:moveTo>
                <a:lnTo>
                  <a:pt x="196" y="4"/>
                </a:lnTo>
                <a:moveTo>
                  <a:pt x="205" y="6"/>
                </a:moveTo>
                <a:lnTo>
                  <a:pt x="208" y="6"/>
                </a:lnTo>
                <a:moveTo>
                  <a:pt x="217" y="7"/>
                </a:moveTo>
                <a:lnTo>
                  <a:pt x="220" y="8"/>
                </a:lnTo>
                <a:moveTo>
                  <a:pt x="228" y="12"/>
                </a:moveTo>
                <a:lnTo>
                  <a:pt x="231" y="13"/>
                </a:lnTo>
                <a:moveTo>
                  <a:pt x="239" y="18"/>
                </a:moveTo>
                <a:lnTo>
                  <a:pt x="242" y="19"/>
                </a:lnTo>
                <a:moveTo>
                  <a:pt x="249" y="23"/>
                </a:moveTo>
                <a:lnTo>
                  <a:pt x="252" y="22"/>
                </a:lnTo>
                <a:moveTo>
                  <a:pt x="261" y="20"/>
                </a:moveTo>
                <a:lnTo>
                  <a:pt x="264" y="19"/>
                </a:lnTo>
                <a:moveTo>
                  <a:pt x="273" y="17"/>
                </a:moveTo>
                <a:lnTo>
                  <a:pt x="276" y="16"/>
                </a:lnTo>
                <a:lnTo>
                  <a:pt x="276" y="16"/>
                </a:lnTo>
                <a:moveTo>
                  <a:pt x="285" y="19"/>
                </a:moveTo>
                <a:lnTo>
                  <a:pt x="288" y="19"/>
                </a:lnTo>
                <a:moveTo>
                  <a:pt x="297" y="22"/>
                </a:moveTo>
                <a:lnTo>
                  <a:pt x="300" y="23"/>
                </a:lnTo>
                <a:moveTo>
                  <a:pt x="309" y="22"/>
                </a:moveTo>
                <a:lnTo>
                  <a:pt x="312" y="21"/>
                </a:lnTo>
                <a:moveTo>
                  <a:pt x="321" y="17"/>
                </a:moveTo>
                <a:lnTo>
                  <a:pt x="324" y="15"/>
                </a:lnTo>
                <a:moveTo>
                  <a:pt x="332" y="12"/>
                </a:moveTo>
                <a:lnTo>
                  <a:pt x="335" y="14"/>
                </a:lnTo>
                <a:moveTo>
                  <a:pt x="343" y="20"/>
                </a:moveTo>
                <a:lnTo>
                  <a:pt x="346" y="22"/>
                </a:lnTo>
                <a:moveTo>
                  <a:pt x="354" y="28"/>
                </a:moveTo>
                <a:lnTo>
                  <a:pt x="357" y="30"/>
                </a:lnTo>
              </a:path>
            </a:pathLst>
          </a:custGeom>
          <a:noFill/>
          <a:ln w="4127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1" name="Rectangle 61">
            <a:extLst>
              <a:ext uri="{FF2B5EF4-FFF2-40B4-BE49-F238E27FC236}">
                <a16:creationId xmlns:a16="http://schemas.microsoft.com/office/drawing/2014/main" id="{12CF4C12-44BF-4646-B78F-F1C901E18D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0011" y="4797426"/>
            <a:ext cx="41189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2" name="Rectangle 62">
            <a:extLst>
              <a:ext uri="{FF2B5EF4-FFF2-40B4-BE49-F238E27FC236}">
                <a16:creationId xmlns:a16="http://schemas.microsoft.com/office/drawing/2014/main" id="{AE613921-2D9D-4C3A-AC9B-3B206CBD7F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0011" y="4864101"/>
            <a:ext cx="41189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3" name="Rectangle 63">
            <a:extLst>
              <a:ext uri="{FF2B5EF4-FFF2-40B4-BE49-F238E27FC236}">
                <a16:creationId xmlns:a16="http://schemas.microsoft.com/office/drawing/2014/main" id="{31909B98-1F48-474B-A9B3-0FA96F5733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183" y="4808538"/>
            <a:ext cx="7084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4" name="Rectangle 64">
            <a:extLst>
              <a:ext uri="{FF2B5EF4-FFF2-40B4-BE49-F238E27FC236}">
                <a16:creationId xmlns:a16="http://schemas.microsoft.com/office/drawing/2014/main" id="{A7AEA7E1-68D6-49EF-8EE2-12F4B0E53C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183" y="4852988"/>
            <a:ext cx="70845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5" name="Rectangle 65">
            <a:extLst>
              <a:ext uri="{FF2B5EF4-FFF2-40B4-BE49-F238E27FC236}">
                <a16:creationId xmlns:a16="http://schemas.microsoft.com/office/drawing/2014/main" id="{2F50AE73-31FA-4590-9025-97BFFE1164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2003" y="4819651"/>
            <a:ext cx="9720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6" name="Rectangle 66">
            <a:extLst>
              <a:ext uri="{FF2B5EF4-FFF2-40B4-BE49-F238E27FC236}">
                <a16:creationId xmlns:a16="http://schemas.microsoft.com/office/drawing/2014/main" id="{061D28B5-4E3D-4AC7-B84B-D95B1FE825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2003" y="4841876"/>
            <a:ext cx="9720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7" name="Rectangle 67">
            <a:extLst>
              <a:ext uri="{FF2B5EF4-FFF2-40B4-BE49-F238E27FC236}">
                <a16:creationId xmlns:a16="http://schemas.microsoft.com/office/drawing/2014/main" id="{63CEB79C-1956-443A-89EF-98C102ADAF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2003" y="4830763"/>
            <a:ext cx="9720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8" name="Rectangle 68">
            <a:extLst>
              <a:ext uri="{FF2B5EF4-FFF2-40B4-BE49-F238E27FC236}">
                <a16:creationId xmlns:a16="http://schemas.microsoft.com/office/drawing/2014/main" id="{D6A266E9-4AA2-4040-A707-818DD9AD61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2003" y="4830763"/>
            <a:ext cx="9720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69" name="Rectangle 69">
            <a:extLst>
              <a:ext uri="{FF2B5EF4-FFF2-40B4-BE49-F238E27FC236}">
                <a16:creationId xmlns:a16="http://schemas.microsoft.com/office/drawing/2014/main" id="{8D84CD1D-6C38-4757-B4F1-B1A3475FD0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7888" y="5041901"/>
            <a:ext cx="4283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0" name="Rectangle 70">
            <a:extLst>
              <a:ext uri="{FF2B5EF4-FFF2-40B4-BE49-F238E27FC236}">
                <a16:creationId xmlns:a16="http://schemas.microsoft.com/office/drawing/2014/main" id="{698A1355-73C2-4A6F-B035-D7D0C20573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7888" y="5108576"/>
            <a:ext cx="42836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1" name="Rectangle 71">
            <a:extLst>
              <a:ext uri="{FF2B5EF4-FFF2-40B4-BE49-F238E27FC236}">
                <a16:creationId xmlns:a16="http://schemas.microsoft.com/office/drawing/2014/main" id="{F73FADF0-F6D5-4998-BAA1-D3D1102677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4708" y="5053013"/>
            <a:ext cx="69197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2" name="Rectangle 72">
            <a:extLst>
              <a:ext uri="{FF2B5EF4-FFF2-40B4-BE49-F238E27FC236}">
                <a16:creationId xmlns:a16="http://schemas.microsoft.com/office/drawing/2014/main" id="{B270869A-FF04-403D-A5BA-B1AE829706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4708" y="5097463"/>
            <a:ext cx="69197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3" name="Rectangle 73">
            <a:extLst>
              <a:ext uri="{FF2B5EF4-FFF2-40B4-BE49-F238E27FC236}">
                <a16:creationId xmlns:a16="http://schemas.microsoft.com/office/drawing/2014/main" id="{CCFEB796-6A38-4C24-BCBB-92F21EED30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64126"/>
            <a:ext cx="98853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4" name="Rectangle 74">
            <a:extLst>
              <a:ext uri="{FF2B5EF4-FFF2-40B4-BE49-F238E27FC236}">
                <a16:creationId xmlns:a16="http://schemas.microsoft.com/office/drawing/2014/main" id="{24B042F5-9C98-4332-9905-5121719146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86351"/>
            <a:ext cx="98853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5" name="Rectangle 75">
            <a:extLst>
              <a:ext uri="{FF2B5EF4-FFF2-40B4-BE49-F238E27FC236}">
                <a16:creationId xmlns:a16="http://schemas.microsoft.com/office/drawing/2014/main" id="{9183A0EF-8094-4647-8055-2DB5A5EEE0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75238"/>
            <a:ext cx="98853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6" name="Rectangle 76">
            <a:extLst>
              <a:ext uri="{FF2B5EF4-FFF2-40B4-BE49-F238E27FC236}">
                <a16:creationId xmlns:a16="http://schemas.microsoft.com/office/drawing/2014/main" id="{F9F38687-514C-4813-BA3D-8788665C7E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75238"/>
            <a:ext cx="98853" cy="11113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7" name="Freeform 77">
            <a:extLst>
              <a:ext uri="{FF2B5EF4-FFF2-40B4-BE49-F238E27FC236}">
                <a16:creationId xmlns:a16="http://schemas.microsoft.com/office/drawing/2014/main" id="{9FBB4AA6-9A22-454F-B8CB-8142E3CFE21C}"/>
              </a:ext>
            </a:extLst>
          </p:cNvPr>
          <p:cNvSpPr>
            <a:spLocks/>
          </p:cNvSpPr>
          <p:nvPr/>
        </p:nvSpPr>
        <p:spPr bwMode="auto">
          <a:xfrm>
            <a:off x="1770486" y="4852988"/>
            <a:ext cx="4692230" cy="455613"/>
          </a:xfrm>
          <a:custGeom>
            <a:avLst/>
            <a:gdLst>
              <a:gd name="T0" fmla="*/ 0 w 335"/>
              <a:gd name="T1" fmla="*/ 12 h 41"/>
              <a:gd name="T2" fmla="*/ 28 w 335"/>
              <a:gd name="T3" fmla="*/ 14 h 41"/>
              <a:gd name="T4" fmla="*/ 56 w 335"/>
              <a:gd name="T5" fmla="*/ 26 h 41"/>
              <a:gd name="T6" fmla="*/ 84 w 335"/>
              <a:gd name="T7" fmla="*/ 41 h 41"/>
              <a:gd name="T8" fmla="*/ 112 w 335"/>
              <a:gd name="T9" fmla="*/ 20 h 41"/>
              <a:gd name="T10" fmla="*/ 140 w 335"/>
              <a:gd name="T11" fmla="*/ 3 h 41"/>
              <a:gd name="T12" fmla="*/ 168 w 335"/>
              <a:gd name="T13" fmla="*/ 0 h 41"/>
              <a:gd name="T14" fmla="*/ 196 w 335"/>
              <a:gd name="T15" fmla="*/ 13 h 41"/>
              <a:gd name="T16" fmla="*/ 224 w 335"/>
              <a:gd name="T17" fmla="*/ 13 h 41"/>
              <a:gd name="T18" fmla="*/ 251 w 335"/>
              <a:gd name="T19" fmla="*/ 16 h 41"/>
              <a:gd name="T20" fmla="*/ 279 w 335"/>
              <a:gd name="T21" fmla="*/ 37 h 41"/>
              <a:gd name="T22" fmla="*/ 307 w 335"/>
              <a:gd name="T23" fmla="*/ 30 h 41"/>
              <a:gd name="T24" fmla="*/ 335 w 335"/>
              <a:gd name="T25" fmla="*/ 17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335" h="41">
                <a:moveTo>
                  <a:pt x="0" y="12"/>
                </a:moveTo>
                <a:lnTo>
                  <a:pt x="28" y="14"/>
                </a:lnTo>
                <a:lnTo>
                  <a:pt x="56" y="26"/>
                </a:lnTo>
                <a:lnTo>
                  <a:pt x="84" y="41"/>
                </a:lnTo>
                <a:lnTo>
                  <a:pt x="112" y="20"/>
                </a:lnTo>
                <a:lnTo>
                  <a:pt x="140" y="3"/>
                </a:lnTo>
                <a:lnTo>
                  <a:pt x="168" y="0"/>
                </a:lnTo>
                <a:lnTo>
                  <a:pt x="196" y="13"/>
                </a:lnTo>
                <a:lnTo>
                  <a:pt x="224" y="13"/>
                </a:lnTo>
                <a:lnTo>
                  <a:pt x="251" y="16"/>
                </a:lnTo>
                <a:lnTo>
                  <a:pt x="279" y="37"/>
                </a:lnTo>
                <a:lnTo>
                  <a:pt x="307" y="30"/>
                </a:lnTo>
                <a:lnTo>
                  <a:pt x="335" y="17"/>
                </a:lnTo>
              </a:path>
            </a:pathLst>
          </a:custGeom>
          <a:noFill/>
          <a:ln w="41275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8" name="Freeform 78">
            <a:extLst>
              <a:ext uri="{FF2B5EF4-FFF2-40B4-BE49-F238E27FC236}">
                <a16:creationId xmlns:a16="http://schemas.microsoft.com/office/drawing/2014/main" id="{DB78E4FE-5FFF-4DDA-BE3D-0200948D5E19}"/>
              </a:ext>
            </a:extLst>
          </p:cNvPr>
          <p:cNvSpPr>
            <a:spLocks noEditPoints="1"/>
          </p:cNvSpPr>
          <p:nvPr/>
        </p:nvSpPr>
        <p:spPr bwMode="auto">
          <a:xfrm>
            <a:off x="8464492" y="4986338"/>
            <a:ext cx="3080923" cy="255588"/>
          </a:xfrm>
          <a:custGeom>
            <a:avLst/>
            <a:gdLst>
              <a:gd name="T0" fmla="*/ 0 w 220"/>
              <a:gd name="T1" fmla="*/ 10 h 23"/>
              <a:gd name="T2" fmla="*/ 9 w 220"/>
              <a:gd name="T3" fmla="*/ 6 h 23"/>
              <a:gd name="T4" fmla="*/ 12 w 220"/>
              <a:gd name="T5" fmla="*/ 5 h 23"/>
              <a:gd name="T6" fmla="*/ 21 w 220"/>
              <a:gd name="T7" fmla="*/ 2 h 23"/>
              <a:gd name="T8" fmla="*/ 24 w 220"/>
              <a:gd name="T9" fmla="*/ 0 h 23"/>
              <a:gd name="T10" fmla="*/ 32 w 220"/>
              <a:gd name="T11" fmla="*/ 5 h 23"/>
              <a:gd name="T12" fmla="*/ 35 w 220"/>
              <a:gd name="T13" fmla="*/ 7 h 23"/>
              <a:gd name="T14" fmla="*/ 43 w 220"/>
              <a:gd name="T15" fmla="*/ 13 h 23"/>
              <a:gd name="T16" fmla="*/ 46 w 220"/>
              <a:gd name="T17" fmla="*/ 15 h 23"/>
              <a:gd name="T18" fmla="*/ 53 w 220"/>
              <a:gd name="T19" fmla="*/ 20 h 23"/>
              <a:gd name="T20" fmla="*/ 56 w 220"/>
              <a:gd name="T21" fmla="*/ 20 h 23"/>
              <a:gd name="T22" fmla="*/ 65 w 220"/>
              <a:gd name="T23" fmla="*/ 21 h 23"/>
              <a:gd name="T24" fmla="*/ 68 w 220"/>
              <a:gd name="T25" fmla="*/ 22 h 23"/>
              <a:gd name="T26" fmla="*/ 77 w 220"/>
              <a:gd name="T27" fmla="*/ 23 h 23"/>
              <a:gd name="T28" fmla="*/ 80 w 220"/>
              <a:gd name="T29" fmla="*/ 23 h 23"/>
              <a:gd name="T30" fmla="*/ 88 w 220"/>
              <a:gd name="T31" fmla="*/ 17 h 23"/>
              <a:gd name="T32" fmla="*/ 91 w 220"/>
              <a:gd name="T33" fmla="*/ 15 h 23"/>
              <a:gd name="T34" fmla="*/ 98 w 220"/>
              <a:gd name="T35" fmla="*/ 9 h 23"/>
              <a:gd name="T36" fmla="*/ 101 w 220"/>
              <a:gd name="T37" fmla="*/ 7 h 23"/>
              <a:gd name="T38" fmla="*/ 108 w 220"/>
              <a:gd name="T39" fmla="*/ 1 h 23"/>
              <a:gd name="T40" fmla="*/ 109 w 220"/>
              <a:gd name="T41" fmla="*/ 0 h 23"/>
              <a:gd name="T42" fmla="*/ 110 w 220"/>
              <a:gd name="T43" fmla="*/ 1 h 23"/>
              <a:gd name="T44" fmla="*/ 119 w 220"/>
              <a:gd name="T45" fmla="*/ 5 h 23"/>
              <a:gd name="T46" fmla="*/ 122 w 220"/>
              <a:gd name="T47" fmla="*/ 7 h 23"/>
              <a:gd name="T48" fmla="*/ 131 w 220"/>
              <a:gd name="T49" fmla="*/ 11 h 23"/>
              <a:gd name="T50" fmla="*/ 134 w 220"/>
              <a:gd name="T51" fmla="*/ 13 h 23"/>
              <a:gd name="T52" fmla="*/ 142 w 220"/>
              <a:gd name="T53" fmla="*/ 11 h 23"/>
              <a:gd name="T54" fmla="*/ 145 w 220"/>
              <a:gd name="T55" fmla="*/ 10 h 23"/>
              <a:gd name="T56" fmla="*/ 154 w 220"/>
              <a:gd name="T57" fmla="*/ 6 h 23"/>
              <a:gd name="T58" fmla="*/ 157 w 220"/>
              <a:gd name="T59" fmla="*/ 5 h 23"/>
              <a:gd name="T60" fmla="*/ 165 w 220"/>
              <a:gd name="T61" fmla="*/ 3 h 23"/>
              <a:gd name="T62" fmla="*/ 168 w 220"/>
              <a:gd name="T63" fmla="*/ 4 h 23"/>
              <a:gd name="T64" fmla="*/ 176 w 220"/>
              <a:gd name="T65" fmla="*/ 9 h 23"/>
              <a:gd name="T66" fmla="*/ 179 w 220"/>
              <a:gd name="T67" fmla="*/ 11 h 23"/>
              <a:gd name="T68" fmla="*/ 188 w 220"/>
              <a:gd name="T69" fmla="*/ 16 h 23"/>
              <a:gd name="T70" fmla="*/ 191 w 220"/>
              <a:gd name="T71" fmla="*/ 17 h 23"/>
              <a:gd name="T72" fmla="*/ 200 w 220"/>
              <a:gd name="T73" fmla="*/ 19 h 23"/>
              <a:gd name="T74" fmla="*/ 203 w 220"/>
              <a:gd name="T75" fmla="*/ 20 h 23"/>
              <a:gd name="T76" fmla="*/ 212 w 220"/>
              <a:gd name="T77" fmla="*/ 22 h 23"/>
              <a:gd name="T78" fmla="*/ 215 w 220"/>
              <a:gd name="T79" fmla="*/ 22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220" h="23">
                <a:moveTo>
                  <a:pt x="9" y="6"/>
                </a:moveTo>
                <a:lnTo>
                  <a:pt x="12" y="5"/>
                </a:lnTo>
                <a:moveTo>
                  <a:pt x="21" y="2"/>
                </a:moveTo>
                <a:lnTo>
                  <a:pt x="24" y="0"/>
                </a:lnTo>
                <a:moveTo>
                  <a:pt x="32" y="5"/>
                </a:moveTo>
                <a:lnTo>
                  <a:pt x="35" y="7"/>
                </a:lnTo>
                <a:moveTo>
                  <a:pt x="43" y="13"/>
                </a:moveTo>
                <a:lnTo>
                  <a:pt x="46" y="15"/>
                </a:lnTo>
                <a:moveTo>
                  <a:pt x="53" y="20"/>
                </a:moveTo>
                <a:lnTo>
                  <a:pt x="56" y="20"/>
                </a:lnTo>
                <a:moveTo>
                  <a:pt x="65" y="21"/>
                </a:moveTo>
                <a:lnTo>
                  <a:pt x="68" y="22"/>
                </a:lnTo>
                <a:moveTo>
                  <a:pt x="77" y="23"/>
                </a:moveTo>
                <a:lnTo>
                  <a:pt x="80" y="23"/>
                </a:lnTo>
                <a:moveTo>
                  <a:pt x="88" y="17"/>
                </a:moveTo>
                <a:lnTo>
                  <a:pt x="91" y="15"/>
                </a:lnTo>
                <a:moveTo>
                  <a:pt x="98" y="9"/>
                </a:moveTo>
                <a:lnTo>
                  <a:pt x="101" y="7"/>
                </a:lnTo>
                <a:moveTo>
                  <a:pt x="108" y="1"/>
                </a:moveTo>
                <a:lnTo>
                  <a:pt x="109" y="0"/>
                </a:lnTo>
                <a:lnTo>
                  <a:pt x="110" y="1"/>
                </a:lnTo>
                <a:moveTo>
                  <a:pt x="119" y="5"/>
                </a:moveTo>
                <a:lnTo>
                  <a:pt x="122" y="7"/>
                </a:lnTo>
                <a:moveTo>
                  <a:pt x="131" y="11"/>
                </a:moveTo>
                <a:lnTo>
                  <a:pt x="134" y="13"/>
                </a:lnTo>
                <a:moveTo>
                  <a:pt x="142" y="11"/>
                </a:moveTo>
                <a:lnTo>
                  <a:pt x="145" y="10"/>
                </a:lnTo>
                <a:moveTo>
                  <a:pt x="154" y="6"/>
                </a:moveTo>
                <a:lnTo>
                  <a:pt x="157" y="5"/>
                </a:lnTo>
                <a:moveTo>
                  <a:pt x="165" y="3"/>
                </a:moveTo>
                <a:lnTo>
                  <a:pt x="168" y="4"/>
                </a:lnTo>
                <a:moveTo>
                  <a:pt x="176" y="9"/>
                </a:moveTo>
                <a:lnTo>
                  <a:pt x="179" y="11"/>
                </a:lnTo>
                <a:moveTo>
                  <a:pt x="188" y="16"/>
                </a:moveTo>
                <a:lnTo>
                  <a:pt x="191" y="17"/>
                </a:lnTo>
                <a:moveTo>
                  <a:pt x="200" y="19"/>
                </a:moveTo>
                <a:lnTo>
                  <a:pt x="203" y="20"/>
                </a:lnTo>
                <a:moveTo>
                  <a:pt x="212" y="22"/>
                </a:moveTo>
                <a:lnTo>
                  <a:pt x="215" y="22"/>
                </a:lnTo>
              </a:path>
            </a:pathLst>
          </a:custGeom>
          <a:noFill/>
          <a:ln w="41275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79" name="Rectangle 79">
            <a:extLst>
              <a:ext uri="{FF2B5EF4-FFF2-40B4-BE49-F238E27FC236}">
                <a16:creationId xmlns:a16="http://schemas.microsoft.com/office/drawing/2014/main" id="{08C48EAA-11A3-4D02-BE14-9D12600B80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7888" y="5008563"/>
            <a:ext cx="42836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0" name="Rectangle 80">
            <a:extLst>
              <a:ext uri="{FF2B5EF4-FFF2-40B4-BE49-F238E27FC236}">
                <a16:creationId xmlns:a16="http://schemas.microsoft.com/office/drawing/2014/main" id="{A2B2BACA-0458-4F2F-A542-E8670A5306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7888" y="5075238"/>
            <a:ext cx="42836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1" name="Rectangle 81">
            <a:extLst>
              <a:ext uri="{FF2B5EF4-FFF2-40B4-BE49-F238E27FC236}">
                <a16:creationId xmlns:a16="http://schemas.microsoft.com/office/drawing/2014/main" id="{94B20A79-CC7F-4CCE-B2BC-888A89BDF5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4708" y="5019676"/>
            <a:ext cx="69197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2" name="Rectangle 82">
            <a:extLst>
              <a:ext uri="{FF2B5EF4-FFF2-40B4-BE49-F238E27FC236}">
                <a16:creationId xmlns:a16="http://schemas.microsoft.com/office/drawing/2014/main" id="{682B0C03-41B1-4E9F-A5B2-71C3070593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4708" y="5064126"/>
            <a:ext cx="69197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3" name="Rectangle 83">
            <a:extLst>
              <a:ext uri="{FF2B5EF4-FFF2-40B4-BE49-F238E27FC236}">
                <a16:creationId xmlns:a16="http://schemas.microsoft.com/office/drawing/2014/main" id="{F28635A5-6884-4F38-878F-D7E80F2E42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30788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4" name="Rectangle 84">
            <a:extLst>
              <a:ext uri="{FF2B5EF4-FFF2-40B4-BE49-F238E27FC236}">
                <a16:creationId xmlns:a16="http://schemas.microsoft.com/office/drawing/2014/main" id="{4F43272D-F977-4DAF-9D61-4B0897F43A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53013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5" name="Rectangle 85">
            <a:extLst>
              <a:ext uri="{FF2B5EF4-FFF2-40B4-BE49-F238E27FC236}">
                <a16:creationId xmlns:a16="http://schemas.microsoft.com/office/drawing/2014/main" id="{9AC93391-1BA0-4E42-94B4-426B05FB8F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41901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6" name="Rectangle 86">
            <a:extLst>
              <a:ext uri="{FF2B5EF4-FFF2-40B4-BE49-F238E27FC236}">
                <a16:creationId xmlns:a16="http://schemas.microsoft.com/office/drawing/2014/main" id="{BCBEF961-B2A7-479C-A993-714682995C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80" y="5041901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7" name="Rectangle 87">
            <a:extLst>
              <a:ext uri="{FF2B5EF4-FFF2-40B4-BE49-F238E27FC236}">
                <a16:creationId xmlns:a16="http://schemas.microsoft.com/office/drawing/2014/main" id="{D02F34C1-C29D-4253-BE01-24BFB99934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08475" y="5075238"/>
            <a:ext cx="42836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8" name="Rectangle 88">
            <a:extLst>
              <a:ext uri="{FF2B5EF4-FFF2-40B4-BE49-F238E27FC236}">
                <a16:creationId xmlns:a16="http://schemas.microsoft.com/office/drawing/2014/main" id="{1FA0A91E-A526-45B6-944E-BF04861F78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08475" y="5141913"/>
            <a:ext cx="42836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89" name="Rectangle 89">
            <a:extLst>
              <a:ext uri="{FF2B5EF4-FFF2-40B4-BE49-F238E27FC236}">
                <a16:creationId xmlns:a16="http://schemas.microsoft.com/office/drawing/2014/main" id="{F2C94BA4-52FD-46C6-86D9-962BAA7198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95295" y="5086351"/>
            <a:ext cx="69197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0" name="Rectangle 90">
            <a:extLst>
              <a:ext uri="{FF2B5EF4-FFF2-40B4-BE49-F238E27FC236}">
                <a16:creationId xmlns:a16="http://schemas.microsoft.com/office/drawing/2014/main" id="{8E4E3B11-7AB7-4020-965B-30ABDC9803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95295" y="5130801"/>
            <a:ext cx="69197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1" name="Rectangle 91">
            <a:extLst>
              <a:ext uri="{FF2B5EF4-FFF2-40B4-BE49-F238E27FC236}">
                <a16:creationId xmlns:a16="http://schemas.microsoft.com/office/drawing/2014/main" id="{BE742DFF-4129-42F9-980F-C50F6EA627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0467" y="5097463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2" name="Rectangle 92">
            <a:extLst>
              <a:ext uri="{FF2B5EF4-FFF2-40B4-BE49-F238E27FC236}">
                <a16:creationId xmlns:a16="http://schemas.microsoft.com/office/drawing/2014/main" id="{D9CA12D6-48EF-4A40-8C8B-5BF6F911BE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0467" y="5119688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3" name="Rectangle 93">
            <a:extLst>
              <a:ext uri="{FF2B5EF4-FFF2-40B4-BE49-F238E27FC236}">
                <a16:creationId xmlns:a16="http://schemas.microsoft.com/office/drawing/2014/main" id="{CE3A8BF8-877E-4344-970C-7E378C5F10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0467" y="5108576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4" name="Rectangle 94">
            <a:extLst>
              <a:ext uri="{FF2B5EF4-FFF2-40B4-BE49-F238E27FC236}">
                <a16:creationId xmlns:a16="http://schemas.microsoft.com/office/drawing/2014/main" id="{D3CC3047-16B1-4F07-AEB7-F6D672FAFD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0467" y="5108576"/>
            <a:ext cx="98853" cy="11113"/>
          </a:xfrm>
          <a:prstGeom prst="rect">
            <a:avLst/>
          </a:prstGeom>
          <a:solidFill>
            <a:srgbClr val="A020F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5" name="Rectangle 95">
            <a:extLst>
              <a:ext uri="{FF2B5EF4-FFF2-40B4-BE49-F238E27FC236}">
                <a16:creationId xmlns:a16="http://schemas.microsoft.com/office/drawing/2014/main" id="{F7A43368-6F6C-4111-8347-AE4EDFCE9B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6987" y="1104901"/>
            <a:ext cx="1611306" cy="8572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6" name="Rectangle 96">
            <a:extLst>
              <a:ext uri="{FF2B5EF4-FFF2-40B4-BE49-F238E27FC236}">
                <a16:creationId xmlns:a16="http://schemas.microsoft.com/office/drawing/2014/main" id="{47101D84-277C-4760-ACF8-0252A25E37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6987" y="1104901"/>
            <a:ext cx="1611306" cy="857250"/>
          </a:xfrm>
          <a:prstGeom prst="rect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7" name="Line 97">
            <a:extLst>
              <a:ext uri="{FF2B5EF4-FFF2-40B4-BE49-F238E27FC236}">
                <a16:creationId xmlns:a16="http://schemas.microsoft.com/office/drawing/2014/main" id="{E315BC4A-2A7D-476B-A4AA-0B5958B939EF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85038" y="1284288"/>
            <a:ext cx="322920" cy="0"/>
          </a:xfrm>
          <a:prstGeom prst="line">
            <a:avLst/>
          </a:prstGeom>
          <a:noFill/>
          <a:ln w="26988" cap="rnd">
            <a:solidFill>
              <a:srgbClr val="0064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8" name="Line 98">
            <a:extLst>
              <a:ext uri="{FF2B5EF4-FFF2-40B4-BE49-F238E27FC236}">
                <a16:creationId xmlns:a16="http://schemas.microsoft.com/office/drawing/2014/main" id="{DE0EEFE1-024F-43D7-8934-5155B2284817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85038" y="1450976"/>
            <a:ext cx="322920" cy="0"/>
          </a:xfrm>
          <a:prstGeom prst="line">
            <a:avLst/>
          </a:prstGeom>
          <a:noFill/>
          <a:ln w="26988" cap="rnd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99" name="Line 99">
            <a:extLst>
              <a:ext uri="{FF2B5EF4-FFF2-40B4-BE49-F238E27FC236}">
                <a16:creationId xmlns:a16="http://schemas.microsoft.com/office/drawing/2014/main" id="{79AAFF1B-4174-4AF6-8796-B78F5DB99FE5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85038" y="1628776"/>
            <a:ext cx="322920" cy="0"/>
          </a:xfrm>
          <a:prstGeom prst="line">
            <a:avLst/>
          </a:prstGeom>
          <a:noFill/>
          <a:ln w="26988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0" name="Line 100">
            <a:extLst>
              <a:ext uri="{FF2B5EF4-FFF2-40B4-BE49-F238E27FC236}">
                <a16:creationId xmlns:a16="http://schemas.microsoft.com/office/drawing/2014/main" id="{BBB4E86C-4C93-412A-9D72-B04A99976D5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285038" y="1795463"/>
            <a:ext cx="322920" cy="0"/>
          </a:xfrm>
          <a:prstGeom prst="line">
            <a:avLst/>
          </a:prstGeom>
          <a:noFill/>
          <a:ln w="26988" cap="rnd">
            <a:solidFill>
              <a:srgbClr val="A020F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1" name="Rectangle 101">
            <a:extLst>
              <a:ext uri="{FF2B5EF4-FFF2-40B4-BE49-F238E27FC236}">
                <a16:creationId xmlns:a16="http://schemas.microsoft.com/office/drawing/2014/main" id="{0C58FAFC-1CE2-4573-B9F2-53775E9289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1180" y="1217613"/>
            <a:ext cx="1008302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6400"/>
                </a:solidFill>
                <a:effectLst/>
                <a:latin typeface="Arial" panose="020B0604020202020204" pitchFamily="34" charset="0"/>
              </a:rPr>
              <a:t>GIRANG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Rectangle 102">
            <a:extLst>
              <a:ext uri="{FF2B5EF4-FFF2-40B4-BE49-F238E27FC236}">
                <a16:creationId xmlns:a16="http://schemas.microsoft.com/office/drawing/2014/main" id="{8F3390A4-FDC9-4C72-AE19-28461B26B9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1180" y="1395413"/>
            <a:ext cx="1036311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Arial" panose="020B0604020202020204" pitchFamily="34" charset="0"/>
              </a:rPr>
              <a:t>LUO IMB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103">
            <a:extLst>
              <a:ext uri="{FF2B5EF4-FFF2-40B4-BE49-F238E27FC236}">
                <a16:creationId xmlns:a16="http://schemas.microsoft.com/office/drawing/2014/main" id="{1CD677E0-27B8-4557-9E07-F728AA1AE3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1180" y="1562101"/>
            <a:ext cx="1036311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anose="020B0604020202020204" pitchFamily="34" charset="0"/>
              </a:rPr>
              <a:t>NYANCH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104">
            <a:extLst>
              <a:ext uri="{FF2B5EF4-FFF2-40B4-BE49-F238E27FC236}">
                <a16:creationId xmlns:a16="http://schemas.microsoft.com/office/drawing/2014/main" id="{FDCE4E36-B618-4047-94D0-CF4BC5E2E0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1180" y="1728788"/>
            <a:ext cx="616185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A020F0"/>
                </a:solidFill>
                <a:effectLst/>
                <a:latin typeface="Arial" panose="020B0604020202020204" pitchFamily="34" charset="0"/>
              </a:rPr>
              <a:t>SUB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5">
            <a:extLst>
              <a:ext uri="{FF2B5EF4-FFF2-40B4-BE49-F238E27FC236}">
                <a16:creationId xmlns:a16="http://schemas.microsoft.com/office/drawing/2014/main" id="{030C16DC-B9A5-4694-8F7B-724D2416AB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0179" y="1104901"/>
            <a:ext cx="3977192" cy="346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6" name="Rectangle 106">
            <a:extLst>
              <a:ext uri="{FF2B5EF4-FFF2-40B4-BE49-F238E27FC236}">
                <a16:creationId xmlns:a16="http://schemas.microsoft.com/office/drawing/2014/main" id="{77E7A2A8-5310-40BC-B6C4-557D4C9F35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0179" y="1104901"/>
            <a:ext cx="3977192" cy="346075"/>
          </a:xfrm>
          <a:prstGeom prst="rect">
            <a:avLst/>
          </a:prstGeom>
          <a:noFill/>
          <a:ln w="142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7" name="Line 107">
            <a:extLst>
              <a:ext uri="{FF2B5EF4-FFF2-40B4-BE49-F238E27FC236}">
                <a16:creationId xmlns:a16="http://schemas.microsoft.com/office/drawing/2014/main" id="{09788E7B-9283-4C05-A7EC-0EFE12395C99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8229" y="1284288"/>
            <a:ext cx="321273" cy="0"/>
          </a:xfrm>
          <a:prstGeom prst="line">
            <a:avLst/>
          </a:pr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8" name="Freeform 108">
            <a:extLst>
              <a:ext uri="{FF2B5EF4-FFF2-40B4-BE49-F238E27FC236}">
                <a16:creationId xmlns:a16="http://schemas.microsoft.com/office/drawing/2014/main" id="{0EEEF98C-3300-47BC-AF8B-073E9AADA61A}"/>
              </a:ext>
            </a:extLst>
          </p:cNvPr>
          <p:cNvSpPr>
            <a:spLocks noEditPoints="1"/>
          </p:cNvSpPr>
          <p:nvPr/>
        </p:nvSpPr>
        <p:spPr bwMode="auto">
          <a:xfrm>
            <a:off x="6811997" y="1284288"/>
            <a:ext cx="294912" cy="0"/>
          </a:xfrm>
          <a:custGeom>
            <a:avLst/>
            <a:gdLst>
              <a:gd name="T0" fmla="*/ 0 w 21"/>
              <a:gd name="T1" fmla="*/ 6 w 21"/>
              <a:gd name="T2" fmla="*/ 8 w 21"/>
              <a:gd name="T3" fmla="*/ 14 w 21"/>
              <a:gd name="T4" fmla="*/ 16 w 2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</a:cxnLst>
            <a:rect l="0" t="0" r="r" b="b"/>
            <a:pathLst>
              <a:path w="21">
                <a:moveTo>
                  <a:pt x="6" y="0"/>
                </a:moveTo>
                <a:lnTo>
                  <a:pt x="8" y="0"/>
                </a:lnTo>
                <a:moveTo>
                  <a:pt x="14" y="0"/>
                </a:moveTo>
                <a:lnTo>
                  <a:pt x="16" y="0"/>
                </a:lnTo>
              </a:path>
            </a:pathLst>
          </a:custGeom>
          <a:noFill/>
          <a:ln w="2698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CA"/>
          </a:p>
        </p:txBody>
      </p:sp>
      <p:sp>
        <p:nvSpPr>
          <p:cNvPr id="109" name="Rectangle 109">
            <a:extLst>
              <a:ext uri="{FF2B5EF4-FFF2-40B4-BE49-F238E27FC236}">
                <a16:creationId xmlns:a16="http://schemas.microsoft.com/office/drawing/2014/main" id="{B819F901-38E4-4F30-99CA-518E319F3E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372" y="1217613"/>
            <a:ext cx="1051139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NTRO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110">
            <a:extLst>
              <a:ext uri="{FF2B5EF4-FFF2-40B4-BE49-F238E27FC236}">
                <a16:creationId xmlns:a16="http://schemas.microsoft.com/office/drawing/2014/main" id="{8056FE22-9A1D-4031-AEC6-8252BE9B3A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0131" y="1217613"/>
            <a:ext cx="1540462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TERVENTION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0508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88</Words>
  <Application>Microsoft Macintosh PowerPoint</Application>
  <PresentationFormat>Widescreen</PresentationFormat>
  <Paragraphs>6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jeeta Mallick</dc:creator>
  <cp:lastModifiedBy>Gail Webber</cp:lastModifiedBy>
  <cp:revision>2</cp:revision>
  <dcterms:created xsi:type="dcterms:W3CDTF">2021-10-20T15:16:24Z</dcterms:created>
  <dcterms:modified xsi:type="dcterms:W3CDTF">2021-10-20T18:40:44Z</dcterms:modified>
</cp:coreProperties>
</file>